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373" r:id="rId2"/>
    <p:sldId id="374" r:id="rId3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CC"/>
    <a:srgbClr val="FFCC00"/>
    <a:srgbClr val="0066FF"/>
    <a:srgbClr val="0099FF"/>
    <a:srgbClr val="99FFCC"/>
    <a:srgbClr val="CCFFFF"/>
    <a:srgbClr val="66FFFF"/>
    <a:srgbClr val="00CCFF"/>
    <a:srgbClr val="00FF00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91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'[Chart in Microsoft PowerPoint]3OAc4OH'!$G$4:$G$593</c:f>
              <c:numCache>
                <c:formatCode>General</c:formatCode>
                <c:ptCount val="590"/>
                <c:pt idx="0">
                  <c:v>51.2</c:v>
                </c:pt>
                <c:pt idx="1">
                  <c:v>51.2</c:v>
                </c:pt>
                <c:pt idx="2">
                  <c:v>51.2</c:v>
                </c:pt>
                <c:pt idx="3">
                  <c:v>51.2</c:v>
                </c:pt>
                <c:pt idx="4">
                  <c:v>51.2</c:v>
                </c:pt>
                <c:pt idx="5">
                  <c:v>51.2</c:v>
                </c:pt>
                <c:pt idx="6">
                  <c:v>51.2</c:v>
                </c:pt>
                <c:pt idx="7">
                  <c:v>51.2</c:v>
                </c:pt>
                <c:pt idx="8">
                  <c:v>51.2</c:v>
                </c:pt>
                <c:pt idx="9">
                  <c:v>53.1</c:v>
                </c:pt>
                <c:pt idx="10">
                  <c:v>53.1</c:v>
                </c:pt>
                <c:pt idx="11">
                  <c:v>53.1</c:v>
                </c:pt>
                <c:pt idx="12">
                  <c:v>53.1</c:v>
                </c:pt>
                <c:pt idx="13">
                  <c:v>53.1</c:v>
                </c:pt>
                <c:pt idx="14">
                  <c:v>53.1</c:v>
                </c:pt>
                <c:pt idx="15">
                  <c:v>53.1</c:v>
                </c:pt>
                <c:pt idx="16">
                  <c:v>53.1</c:v>
                </c:pt>
                <c:pt idx="17">
                  <c:v>53.1</c:v>
                </c:pt>
                <c:pt idx="18">
                  <c:v>54.2</c:v>
                </c:pt>
                <c:pt idx="19">
                  <c:v>54.2</c:v>
                </c:pt>
                <c:pt idx="20">
                  <c:v>54.2</c:v>
                </c:pt>
                <c:pt idx="21">
                  <c:v>54.2</c:v>
                </c:pt>
                <c:pt idx="22">
                  <c:v>54.2</c:v>
                </c:pt>
                <c:pt idx="23">
                  <c:v>54.2</c:v>
                </c:pt>
                <c:pt idx="24">
                  <c:v>54.2</c:v>
                </c:pt>
                <c:pt idx="25">
                  <c:v>54.2</c:v>
                </c:pt>
                <c:pt idx="26">
                  <c:v>54.2</c:v>
                </c:pt>
                <c:pt idx="27">
                  <c:v>55.05</c:v>
                </c:pt>
                <c:pt idx="28">
                  <c:v>55.05</c:v>
                </c:pt>
                <c:pt idx="29">
                  <c:v>55.05</c:v>
                </c:pt>
                <c:pt idx="30">
                  <c:v>55.05</c:v>
                </c:pt>
                <c:pt idx="31">
                  <c:v>55.05</c:v>
                </c:pt>
                <c:pt idx="32">
                  <c:v>55.05</c:v>
                </c:pt>
                <c:pt idx="33">
                  <c:v>55.05</c:v>
                </c:pt>
                <c:pt idx="34">
                  <c:v>55.05</c:v>
                </c:pt>
                <c:pt idx="35">
                  <c:v>55.05</c:v>
                </c:pt>
                <c:pt idx="36">
                  <c:v>57.1</c:v>
                </c:pt>
                <c:pt idx="37">
                  <c:v>57.1</c:v>
                </c:pt>
                <c:pt idx="38">
                  <c:v>57.1</c:v>
                </c:pt>
                <c:pt idx="39">
                  <c:v>57.1</c:v>
                </c:pt>
                <c:pt idx="40">
                  <c:v>57.1</c:v>
                </c:pt>
                <c:pt idx="41">
                  <c:v>57.1</c:v>
                </c:pt>
                <c:pt idx="42">
                  <c:v>57.1</c:v>
                </c:pt>
                <c:pt idx="43">
                  <c:v>57.1</c:v>
                </c:pt>
                <c:pt idx="44">
                  <c:v>57.1</c:v>
                </c:pt>
                <c:pt idx="45">
                  <c:v>59.1</c:v>
                </c:pt>
                <c:pt idx="46">
                  <c:v>59.1</c:v>
                </c:pt>
                <c:pt idx="47">
                  <c:v>59.1</c:v>
                </c:pt>
                <c:pt idx="48">
                  <c:v>59.1</c:v>
                </c:pt>
                <c:pt idx="49">
                  <c:v>59.1</c:v>
                </c:pt>
                <c:pt idx="50">
                  <c:v>59.1</c:v>
                </c:pt>
                <c:pt idx="51">
                  <c:v>59.1</c:v>
                </c:pt>
                <c:pt idx="52">
                  <c:v>59.1</c:v>
                </c:pt>
                <c:pt idx="53">
                  <c:v>59.1</c:v>
                </c:pt>
                <c:pt idx="54">
                  <c:v>60.1</c:v>
                </c:pt>
                <c:pt idx="55">
                  <c:v>60.1</c:v>
                </c:pt>
                <c:pt idx="56">
                  <c:v>60.1</c:v>
                </c:pt>
                <c:pt idx="57">
                  <c:v>60.1</c:v>
                </c:pt>
                <c:pt idx="58">
                  <c:v>60.1</c:v>
                </c:pt>
                <c:pt idx="59">
                  <c:v>60.1</c:v>
                </c:pt>
                <c:pt idx="60">
                  <c:v>60.1</c:v>
                </c:pt>
                <c:pt idx="61">
                  <c:v>60.1</c:v>
                </c:pt>
                <c:pt idx="62">
                  <c:v>60.1</c:v>
                </c:pt>
                <c:pt idx="63">
                  <c:v>65.099999999999994</c:v>
                </c:pt>
                <c:pt idx="64">
                  <c:v>65.099999999999994</c:v>
                </c:pt>
                <c:pt idx="65">
                  <c:v>65.099999999999994</c:v>
                </c:pt>
                <c:pt idx="66">
                  <c:v>65.099999999999994</c:v>
                </c:pt>
                <c:pt idx="67">
                  <c:v>65.099999999999994</c:v>
                </c:pt>
                <c:pt idx="68">
                  <c:v>65.099999999999994</c:v>
                </c:pt>
                <c:pt idx="69">
                  <c:v>65.099999999999994</c:v>
                </c:pt>
                <c:pt idx="70">
                  <c:v>65.099999999999994</c:v>
                </c:pt>
                <c:pt idx="71">
                  <c:v>65.099999999999994</c:v>
                </c:pt>
                <c:pt idx="72">
                  <c:v>66.099999999999994</c:v>
                </c:pt>
                <c:pt idx="73">
                  <c:v>66.099999999999994</c:v>
                </c:pt>
                <c:pt idx="74">
                  <c:v>66.099999999999994</c:v>
                </c:pt>
                <c:pt idx="75">
                  <c:v>66.099999999999994</c:v>
                </c:pt>
                <c:pt idx="76">
                  <c:v>66.099999999999994</c:v>
                </c:pt>
                <c:pt idx="77">
                  <c:v>66.099999999999994</c:v>
                </c:pt>
                <c:pt idx="78">
                  <c:v>66.099999999999994</c:v>
                </c:pt>
                <c:pt idx="79">
                  <c:v>66.099999999999994</c:v>
                </c:pt>
                <c:pt idx="80">
                  <c:v>66.099999999999994</c:v>
                </c:pt>
                <c:pt idx="81">
                  <c:v>67.099999999999994</c:v>
                </c:pt>
                <c:pt idx="82">
                  <c:v>67.099999999999994</c:v>
                </c:pt>
                <c:pt idx="83">
                  <c:v>67.099999999999994</c:v>
                </c:pt>
                <c:pt idx="84">
                  <c:v>67.099999999999994</c:v>
                </c:pt>
                <c:pt idx="85">
                  <c:v>67.099999999999994</c:v>
                </c:pt>
                <c:pt idx="86">
                  <c:v>67.099999999999994</c:v>
                </c:pt>
                <c:pt idx="87">
                  <c:v>67.099999999999994</c:v>
                </c:pt>
                <c:pt idx="88">
                  <c:v>67.099999999999994</c:v>
                </c:pt>
                <c:pt idx="89">
                  <c:v>67.099999999999994</c:v>
                </c:pt>
                <c:pt idx="90">
                  <c:v>68.099999999999994</c:v>
                </c:pt>
                <c:pt idx="91">
                  <c:v>68.099999999999994</c:v>
                </c:pt>
                <c:pt idx="92">
                  <c:v>68.099999999999994</c:v>
                </c:pt>
                <c:pt idx="93">
                  <c:v>68.099999999999994</c:v>
                </c:pt>
                <c:pt idx="94">
                  <c:v>68.099999999999994</c:v>
                </c:pt>
                <c:pt idx="95">
                  <c:v>68.099999999999994</c:v>
                </c:pt>
                <c:pt idx="96">
                  <c:v>68.099999999999994</c:v>
                </c:pt>
                <c:pt idx="97">
                  <c:v>68.099999999999994</c:v>
                </c:pt>
                <c:pt idx="98">
                  <c:v>68.099999999999994</c:v>
                </c:pt>
                <c:pt idx="99">
                  <c:v>69.150000000000006</c:v>
                </c:pt>
                <c:pt idx="100">
                  <c:v>69.150000000000006</c:v>
                </c:pt>
                <c:pt idx="101">
                  <c:v>69.150000000000006</c:v>
                </c:pt>
                <c:pt idx="102">
                  <c:v>69.150000000000006</c:v>
                </c:pt>
                <c:pt idx="103">
                  <c:v>69.150000000000006</c:v>
                </c:pt>
                <c:pt idx="104">
                  <c:v>69.150000000000006</c:v>
                </c:pt>
                <c:pt idx="105">
                  <c:v>69.150000000000006</c:v>
                </c:pt>
                <c:pt idx="106">
                  <c:v>69.150000000000006</c:v>
                </c:pt>
                <c:pt idx="107">
                  <c:v>69.150000000000006</c:v>
                </c:pt>
                <c:pt idx="108">
                  <c:v>70.3</c:v>
                </c:pt>
                <c:pt idx="109">
                  <c:v>70.3</c:v>
                </c:pt>
                <c:pt idx="110">
                  <c:v>70.3</c:v>
                </c:pt>
                <c:pt idx="111">
                  <c:v>70.3</c:v>
                </c:pt>
                <c:pt idx="112">
                  <c:v>70.3</c:v>
                </c:pt>
                <c:pt idx="113">
                  <c:v>70.3</c:v>
                </c:pt>
                <c:pt idx="114">
                  <c:v>70.3</c:v>
                </c:pt>
                <c:pt idx="115">
                  <c:v>70.3</c:v>
                </c:pt>
                <c:pt idx="116">
                  <c:v>70.3</c:v>
                </c:pt>
                <c:pt idx="117">
                  <c:v>71.099999999999994</c:v>
                </c:pt>
                <c:pt idx="118">
                  <c:v>71.099999999999994</c:v>
                </c:pt>
                <c:pt idx="119">
                  <c:v>71.099999999999994</c:v>
                </c:pt>
                <c:pt idx="120">
                  <c:v>71.099999999999994</c:v>
                </c:pt>
                <c:pt idx="121">
                  <c:v>71.099999999999994</c:v>
                </c:pt>
                <c:pt idx="122">
                  <c:v>71.099999999999994</c:v>
                </c:pt>
                <c:pt idx="123">
                  <c:v>71.099999999999994</c:v>
                </c:pt>
                <c:pt idx="124">
                  <c:v>71.099999999999994</c:v>
                </c:pt>
                <c:pt idx="125">
                  <c:v>71.099999999999994</c:v>
                </c:pt>
                <c:pt idx="126">
                  <c:v>77.099999999999994</c:v>
                </c:pt>
                <c:pt idx="127">
                  <c:v>77.099999999999994</c:v>
                </c:pt>
                <c:pt idx="128">
                  <c:v>77.099999999999994</c:v>
                </c:pt>
                <c:pt idx="129">
                  <c:v>77.099999999999994</c:v>
                </c:pt>
                <c:pt idx="130">
                  <c:v>77.099999999999994</c:v>
                </c:pt>
                <c:pt idx="131">
                  <c:v>77.099999999999994</c:v>
                </c:pt>
                <c:pt idx="132">
                  <c:v>77.099999999999994</c:v>
                </c:pt>
                <c:pt idx="133">
                  <c:v>77.099999999999994</c:v>
                </c:pt>
                <c:pt idx="134">
                  <c:v>77.099999999999994</c:v>
                </c:pt>
                <c:pt idx="135">
                  <c:v>78.2</c:v>
                </c:pt>
                <c:pt idx="136">
                  <c:v>78.2</c:v>
                </c:pt>
                <c:pt idx="137">
                  <c:v>78.2</c:v>
                </c:pt>
                <c:pt idx="138">
                  <c:v>78.2</c:v>
                </c:pt>
                <c:pt idx="139">
                  <c:v>78.2</c:v>
                </c:pt>
                <c:pt idx="140">
                  <c:v>78.2</c:v>
                </c:pt>
                <c:pt idx="141">
                  <c:v>78.2</c:v>
                </c:pt>
                <c:pt idx="142">
                  <c:v>78.2</c:v>
                </c:pt>
                <c:pt idx="143">
                  <c:v>78.2</c:v>
                </c:pt>
                <c:pt idx="144">
                  <c:v>79.099999999999994</c:v>
                </c:pt>
                <c:pt idx="145">
                  <c:v>79.099999999999994</c:v>
                </c:pt>
                <c:pt idx="146">
                  <c:v>79.099999999999994</c:v>
                </c:pt>
                <c:pt idx="147">
                  <c:v>79.099999999999994</c:v>
                </c:pt>
                <c:pt idx="148">
                  <c:v>79.099999999999994</c:v>
                </c:pt>
                <c:pt idx="149">
                  <c:v>79.099999999999994</c:v>
                </c:pt>
                <c:pt idx="150">
                  <c:v>79.099999999999994</c:v>
                </c:pt>
                <c:pt idx="151">
                  <c:v>79.099999999999994</c:v>
                </c:pt>
                <c:pt idx="152">
                  <c:v>79.099999999999994</c:v>
                </c:pt>
                <c:pt idx="153">
                  <c:v>80.2</c:v>
                </c:pt>
                <c:pt idx="154">
                  <c:v>80.2</c:v>
                </c:pt>
                <c:pt idx="155">
                  <c:v>80.2</c:v>
                </c:pt>
                <c:pt idx="156">
                  <c:v>80.2</c:v>
                </c:pt>
                <c:pt idx="157">
                  <c:v>80.2</c:v>
                </c:pt>
                <c:pt idx="158">
                  <c:v>80.2</c:v>
                </c:pt>
                <c:pt idx="159">
                  <c:v>80.2</c:v>
                </c:pt>
                <c:pt idx="160">
                  <c:v>80.2</c:v>
                </c:pt>
                <c:pt idx="161">
                  <c:v>80.2</c:v>
                </c:pt>
                <c:pt idx="162">
                  <c:v>81.099999999999994</c:v>
                </c:pt>
                <c:pt idx="163">
                  <c:v>81.099999999999994</c:v>
                </c:pt>
                <c:pt idx="164">
                  <c:v>81.099999999999994</c:v>
                </c:pt>
                <c:pt idx="165">
                  <c:v>81.099999999999994</c:v>
                </c:pt>
                <c:pt idx="166">
                  <c:v>81.099999999999994</c:v>
                </c:pt>
                <c:pt idx="167">
                  <c:v>81.099999999999994</c:v>
                </c:pt>
                <c:pt idx="168">
                  <c:v>81.099999999999994</c:v>
                </c:pt>
                <c:pt idx="169">
                  <c:v>81.099999999999994</c:v>
                </c:pt>
                <c:pt idx="170">
                  <c:v>81.099999999999994</c:v>
                </c:pt>
                <c:pt idx="171">
                  <c:v>82.1</c:v>
                </c:pt>
                <c:pt idx="172">
                  <c:v>82.1</c:v>
                </c:pt>
                <c:pt idx="173">
                  <c:v>82.1</c:v>
                </c:pt>
                <c:pt idx="174">
                  <c:v>82.1</c:v>
                </c:pt>
                <c:pt idx="175">
                  <c:v>82.1</c:v>
                </c:pt>
                <c:pt idx="176">
                  <c:v>82.1</c:v>
                </c:pt>
                <c:pt idx="177">
                  <c:v>82.1</c:v>
                </c:pt>
                <c:pt idx="178">
                  <c:v>82.1</c:v>
                </c:pt>
                <c:pt idx="179">
                  <c:v>82.1</c:v>
                </c:pt>
                <c:pt idx="180">
                  <c:v>83.1</c:v>
                </c:pt>
                <c:pt idx="181">
                  <c:v>83.1</c:v>
                </c:pt>
                <c:pt idx="182">
                  <c:v>83.1</c:v>
                </c:pt>
                <c:pt idx="183">
                  <c:v>83.1</c:v>
                </c:pt>
                <c:pt idx="184">
                  <c:v>83.1</c:v>
                </c:pt>
                <c:pt idx="185">
                  <c:v>83.1</c:v>
                </c:pt>
                <c:pt idx="186">
                  <c:v>83.1</c:v>
                </c:pt>
                <c:pt idx="187">
                  <c:v>83.1</c:v>
                </c:pt>
                <c:pt idx="188">
                  <c:v>83.1</c:v>
                </c:pt>
                <c:pt idx="189">
                  <c:v>84.2</c:v>
                </c:pt>
                <c:pt idx="190">
                  <c:v>84.2</c:v>
                </c:pt>
                <c:pt idx="191">
                  <c:v>84.2</c:v>
                </c:pt>
                <c:pt idx="192">
                  <c:v>84.2</c:v>
                </c:pt>
                <c:pt idx="193">
                  <c:v>84.2</c:v>
                </c:pt>
                <c:pt idx="194">
                  <c:v>84.2</c:v>
                </c:pt>
                <c:pt idx="195">
                  <c:v>84.2</c:v>
                </c:pt>
                <c:pt idx="196">
                  <c:v>84.2</c:v>
                </c:pt>
                <c:pt idx="197">
                  <c:v>84.2</c:v>
                </c:pt>
                <c:pt idx="198">
                  <c:v>85</c:v>
                </c:pt>
                <c:pt idx="199">
                  <c:v>85</c:v>
                </c:pt>
                <c:pt idx="200">
                  <c:v>85</c:v>
                </c:pt>
                <c:pt idx="201">
                  <c:v>85</c:v>
                </c:pt>
                <c:pt idx="202">
                  <c:v>85</c:v>
                </c:pt>
                <c:pt idx="203">
                  <c:v>85</c:v>
                </c:pt>
                <c:pt idx="204">
                  <c:v>85</c:v>
                </c:pt>
                <c:pt idx="205">
                  <c:v>85</c:v>
                </c:pt>
                <c:pt idx="206">
                  <c:v>85</c:v>
                </c:pt>
                <c:pt idx="207">
                  <c:v>91.05</c:v>
                </c:pt>
                <c:pt idx="208">
                  <c:v>91.05</c:v>
                </c:pt>
                <c:pt idx="209">
                  <c:v>91.05</c:v>
                </c:pt>
                <c:pt idx="210">
                  <c:v>91.05</c:v>
                </c:pt>
                <c:pt idx="211">
                  <c:v>91.05</c:v>
                </c:pt>
                <c:pt idx="212">
                  <c:v>91.05</c:v>
                </c:pt>
                <c:pt idx="213">
                  <c:v>91.05</c:v>
                </c:pt>
                <c:pt idx="214">
                  <c:v>91.05</c:v>
                </c:pt>
                <c:pt idx="215">
                  <c:v>91.05</c:v>
                </c:pt>
                <c:pt idx="216">
                  <c:v>92.1</c:v>
                </c:pt>
                <c:pt idx="217">
                  <c:v>92.1</c:v>
                </c:pt>
                <c:pt idx="218">
                  <c:v>92.1</c:v>
                </c:pt>
                <c:pt idx="219">
                  <c:v>92.1</c:v>
                </c:pt>
                <c:pt idx="220">
                  <c:v>92.1</c:v>
                </c:pt>
                <c:pt idx="221">
                  <c:v>92.1</c:v>
                </c:pt>
                <c:pt idx="222">
                  <c:v>92.1</c:v>
                </c:pt>
                <c:pt idx="223">
                  <c:v>92.1</c:v>
                </c:pt>
                <c:pt idx="224">
                  <c:v>92.1</c:v>
                </c:pt>
                <c:pt idx="225">
                  <c:v>93.1</c:v>
                </c:pt>
                <c:pt idx="226">
                  <c:v>93.1</c:v>
                </c:pt>
                <c:pt idx="227">
                  <c:v>93.1</c:v>
                </c:pt>
                <c:pt idx="228">
                  <c:v>93.1</c:v>
                </c:pt>
                <c:pt idx="229">
                  <c:v>93.1</c:v>
                </c:pt>
                <c:pt idx="230">
                  <c:v>93.1</c:v>
                </c:pt>
                <c:pt idx="231">
                  <c:v>93.1</c:v>
                </c:pt>
                <c:pt idx="232">
                  <c:v>93.1</c:v>
                </c:pt>
                <c:pt idx="233">
                  <c:v>93.1</c:v>
                </c:pt>
                <c:pt idx="234">
                  <c:v>94.1</c:v>
                </c:pt>
                <c:pt idx="235">
                  <c:v>94.1</c:v>
                </c:pt>
                <c:pt idx="236">
                  <c:v>94.1</c:v>
                </c:pt>
                <c:pt idx="237">
                  <c:v>94.1</c:v>
                </c:pt>
                <c:pt idx="238">
                  <c:v>94.1</c:v>
                </c:pt>
                <c:pt idx="239">
                  <c:v>94.1</c:v>
                </c:pt>
                <c:pt idx="240">
                  <c:v>94.1</c:v>
                </c:pt>
                <c:pt idx="241">
                  <c:v>94.1</c:v>
                </c:pt>
                <c:pt idx="242">
                  <c:v>94.1</c:v>
                </c:pt>
                <c:pt idx="243">
                  <c:v>95.1</c:v>
                </c:pt>
                <c:pt idx="244">
                  <c:v>95.1</c:v>
                </c:pt>
                <c:pt idx="245">
                  <c:v>95.1</c:v>
                </c:pt>
                <c:pt idx="246">
                  <c:v>95.1</c:v>
                </c:pt>
                <c:pt idx="247">
                  <c:v>95.1</c:v>
                </c:pt>
                <c:pt idx="248">
                  <c:v>95.1</c:v>
                </c:pt>
                <c:pt idx="249">
                  <c:v>95.1</c:v>
                </c:pt>
                <c:pt idx="250">
                  <c:v>95.1</c:v>
                </c:pt>
                <c:pt idx="251">
                  <c:v>95.1</c:v>
                </c:pt>
                <c:pt idx="252">
                  <c:v>96.05</c:v>
                </c:pt>
                <c:pt idx="253">
                  <c:v>96.05</c:v>
                </c:pt>
                <c:pt idx="254">
                  <c:v>96.05</c:v>
                </c:pt>
                <c:pt idx="255">
                  <c:v>96.05</c:v>
                </c:pt>
                <c:pt idx="256">
                  <c:v>96.05</c:v>
                </c:pt>
                <c:pt idx="257">
                  <c:v>96.05</c:v>
                </c:pt>
                <c:pt idx="258">
                  <c:v>96.05</c:v>
                </c:pt>
                <c:pt idx="259">
                  <c:v>96.05</c:v>
                </c:pt>
                <c:pt idx="260">
                  <c:v>96.05</c:v>
                </c:pt>
                <c:pt idx="261">
                  <c:v>97.1</c:v>
                </c:pt>
                <c:pt idx="262">
                  <c:v>97.1</c:v>
                </c:pt>
                <c:pt idx="263">
                  <c:v>97.1</c:v>
                </c:pt>
                <c:pt idx="264">
                  <c:v>97.1</c:v>
                </c:pt>
                <c:pt idx="265">
                  <c:v>97.1</c:v>
                </c:pt>
                <c:pt idx="266">
                  <c:v>97.1</c:v>
                </c:pt>
                <c:pt idx="267">
                  <c:v>97.1</c:v>
                </c:pt>
                <c:pt idx="268">
                  <c:v>97.1</c:v>
                </c:pt>
                <c:pt idx="269">
                  <c:v>97.1</c:v>
                </c:pt>
                <c:pt idx="270">
                  <c:v>98.2</c:v>
                </c:pt>
                <c:pt idx="271">
                  <c:v>98.2</c:v>
                </c:pt>
                <c:pt idx="272">
                  <c:v>98.2</c:v>
                </c:pt>
                <c:pt idx="273">
                  <c:v>98.2</c:v>
                </c:pt>
                <c:pt idx="274">
                  <c:v>98.2</c:v>
                </c:pt>
                <c:pt idx="275">
                  <c:v>98.2</c:v>
                </c:pt>
                <c:pt idx="276">
                  <c:v>98.2</c:v>
                </c:pt>
                <c:pt idx="277">
                  <c:v>98.2</c:v>
                </c:pt>
                <c:pt idx="278">
                  <c:v>98.2</c:v>
                </c:pt>
                <c:pt idx="279">
                  <c:v>99</c:v>
                </c:pt>
                <c:pt idx="280">
                  <c:v>99</c:v>
                </c:pt>
                <c:pt idx="281">
                  <c:v>99</c:v>
                </c:pt>
                <c:pt idx="282">
                  <c:v>99</c:v>
                </c:pt>
                <c:pt idx="283">
                  <c:v>99</c:v>
                </c:pt>
                <c:pt idx="284">
                  <c:v>99</c:v>
                </c:pt>
                <c:pt idx="285">
                  <c:v>99</c:v>
                </c:pt>
                <c:pt idx="286">
                  <c:v>99</c:v>
                </c:pt>
                <c:pt idx="287">
                  <c:v>99</c:v>
                </c:pt>
                <c:pt idx="288">
                  <c:v>103.1</c:v>
                </c:pt>
                <c:pt idx="289">
                  <c:v>103.1</c:v>
                </c:pt>
                <c:pt idx="290">
                  <c:v>103.1</c:v>
                </c:pt>
                <c:pt idx="291">
                  <c:v>103.1</c:v>
                </c:pt>
                <c:pt idx="292">
                  <c:v>103.1</c:v>
                </c:pt>
                <c:pt idx="293">
                  <c:v>103.1</c:v>
                </c:pt>
                <c:pt idx="294">
                  <c:v>103.1</c:v>
                </c:pt>
                <c:pt idx="295">
                  <c:v>103.1</c:v>
                </c:pt>
                <c:pt idx="296">
                  <c:v>103.1</c:v>
                </c:pt>
                <c:pt idx="297">
                  <c:v>105.1</c:v>
                </c:pt>
                <c:pt idx="298">
                  <c:v>105.1</c:v>
                </c:pt>
                <c:pt idx="299">
                  <c:v>105.1</c:v>
                </c:pt>
                <c:pt idx="300">
                  <c:v>105.1</c:v>
                </c:pt>
                <c:pt idx="301">
                  <c:v>105.1</c:v>
                </c:pt>
                <c:pt idx="302">
                  <c:v>105.1</c:v>
                </c:pt>
                <c:pt idx="303">
                  <c:v>105.1</c:v>
                </c:pt>
                <c:pt idx="304">
                  <c:v>105.1</c:v>
                </c:pt>
                <c:pt idx="305">
                  <c:v>105.1</c:v>
                </c:pt>
                <c:pt idx="306">
                  <c:v>106.2</c:v>
                </c:pt>
                <c:pt idx="307">
                  <c:v>106.2</c:v>
                </c:pt>
                <c:pt idx="308">
                  <c:v>106.2</c:v>
                </c:pt>
                <c:pt idx="309">
                  <c:v>106.2</c:v>
                </c:pt>
                <c:pt idx="310">
                  <c:v>106.2</c:v>
                </c:pt>
                <c:pt idx="311">
                  <c:v>106.2</c:v>
                </c:pt>
                <c:pt idx="312">
                  <c:v>106.2</c:v>
                </c:pt>
                <c:pt idx="313">
                  <c:v>106.2</c:v>
                </c:pt>
                <c:pt idx="314">
                  <c:v>106.2</c:v>
                </c:pt>
                <c:pt idx="315">
                  <c:v>107.1</c:v>
                </c:pt>
                <c:pt idx="316">
                  <c:v>107.1</c:v>
                </c:pt>
                <c:pt idx="317">
                  <c:v>107.1</c:v>
                </c:pt>
                <c:pt idx="318">
                  <c:v>107.1</c:v>
                </c:pt>
                <c:pt idx="319">
                  <c:v>107.1</c:v>
                </c:pt>
                <c:pt idx="320">
                  <c:v>107.1</c:v>
                </c:pt>
                <c:pt idx="321">
                  <c:v>107.1</c:v>
                </c:pt>
                <c:pt idx="322">
                  <c:v>107.1</c:v>
                </c:pt>
                <c:pt idx="323">
                  <c:v>107.1</c:v>
                </c:pt>
                <c:pt idx="324">
                  <c:v>108.2</c:v>
                </c:pt>
                <c:pt idx="325">
                  <c:v>108.2</c:v>
                </c:pt>
                <c:pt idx="326">
                  <c:v>108.2</c:v>
                </c:pt>
                <c:pt idx="327">
                  <c:v>108.2</c:v>
                </c:pt>
                <c:pt idx="328">
                  <c:v>108.2</c:v>
                </c:pt>
                <c:pt idx="329">
                  <c:v>108.2</c:v>
                </c:pt>
                <c:pt idx="330">
                  <c:v>108.2</c:v>
                </c:pt>
                <c:pt idx="331">
                  <c:v>108.2</c:v>
                </c:pt>
                <c:pt idx="332">
                  <c:v>108.2</c:v>
                </c:pt>
                <c:pt idx="333">
                  <c:v>109.1</c:v>
                </c:pt>
                <c:pt idx="334">
                  <c:v>109.1</c:v>
                </c:pt>
                <c:pt idx="335">
                  <c:v>109.1</c:v>
                </c:pt>
                <c:pt idx="336">
                  <c:v>109.1</c:v>
                </c:pt>
                <c:pt idx="337">
                  <c:v>109.1</c:v>
                </c:pt>
                <c:pt idx="338">
                  <c:v>109.1</c:v>
                </c:pt>
                <c:pt idx="339">
                  <c:v>109.1</c:v>
                </c:pt>
                <c:pt idx="340">
                  <c:v>109.1</c:v>
                </c:pt>
                <c:pt idx="341">
                  <c:v>109.1</c:v>
                </c:pt>
                <c:pt idx="342">
                  <c:v>110.1</c:v>
                </c:pt>
                <c:pt idx="343">
                  <c:v>110.1</c:v>
                </c:pt>
                <c:pt idx="344">
                  <c:v>110.1</c:v>
                </c:pt>
                <c:pt idx="345">
                  <c:v>110.1</c:v>
                </c:pt>
                <c:pt idx="346">
                  <c:v>110.1</c:v>
                </c:pt>
                <c:pt idx="347">
                  <c:v>110.1</c:v>
                </c:pt>
                <c:pt idx="348">
                  <c:v>110.1</c:v>
                </c:pt>
                <c:pt idx="349">
                  <c:v>110.1</c:v>
                </c:pt>
                <c:pt idx="350">
                  <c:v>110.1</c:v>
                </c:pt>
                <c:pt idx="351">
                  <c:v>111.1</c:v>
                </c:pt>
                <c:pt idx="352">
                  <c:v>111.1</c:v>
                </c:pt>
                <c:pt idx="353">
                  <c:v>111.1</c:v>
                </c:pt>
                <c:pt idx="354">
                  <c:v>111.1</c:v>
                </c:pt>
                <c:pt idx="355">
                  <c:v>111.1</c:v>
                </c:pt>
                <c:pt idx="356">
                  <c:v>112</c:v>
                </c:pt>
                <c:pt idx="357">
                  <c:v>112</c:v>
                </c:pt>
                <c:pt idx="358">
                  <c:v>112</c:v>
                </c:pt>
                <c:pt idx="359">
                  <c:v>115</c:v>
                </c:pt>
                <c:pt idx="360">
                  <c:v>115</c:v>
                </c:pt>
                <c:pt idx="361">
                  <c:v>115</c:v>
                </c:pt>
                <c:pt idx="362">
                  <c:v>117.1</c:v>
                </c:pt>
                <c:pt idx="363">
                  <c:v>117.1</c:v>
                </c:pt>
                <c:pt idx="364">
                  <c:v>117.1</c:v>
                </c:pt>
                <c:pt idx="365">
                  <c:v>119.2</c:v>
                </c:pt>
                <c:pt idx="366">
                  <c:v>119.2</c:v>
                </c:pt>
                <c:pt idx="367">
                  <c:v>119.2</c:v>
                </c:pt>
                <c:pt idx="368">
                  <c:v>120.1</c:v>
                </c:pt>
                <c:pt idx="369">
                  <c:v>120.1</c:v>
                </c:pt>
                <c:pt idx="370">
                  <c:v>120.1</c:v>
                </c:pt>
                <c:pt idx="371">
                  <c:v>121.1</c:v>
                </c:pt>
                <c:pt idx="372">
                  <c:v>121.1</c:v>
                </c:pt>
                <c:pt idx="373">
                  <c:v>121.1</c:v>
                </c:pt>
                <c:pt idx="374">
                  <c:v>122.1</c:v>
                </c:pt>
                <c:pt idx="375">
                  <c:v>122.1</c:v>
                </c:pt>
                <c:pt idx="376">
                  <c:v>122.1</c:v>
                </c:pt>
                <c:pt idx="377">
                  <c:v>123.1</c:v>
                </c:pt>
                <c:pt idx="378">
                  <c:v>123.1</c:v>
                </c:pt>
                <c:pt idx="379">
                  <c:v>123.1</c:v>
                </c:pt>
                <c:pt idx="380">
                  <c:v>124.05</c:v>
                </c:pt>
                <c:pt idx="381">
                  <c:v>124.05</c:v>
                </c:pt>
                <c:pt idx="382">
                  <c:v>124.05</c:v>
                </c:pt>
                <c:pt idx="383">
                  <c:v>125.05</c:v>
                </c:pt>
                <c:pt idx="384">
                  <c:v>125.05</c:v>
                </c:pt>
                <c:pt idx="385">
                  <c:v>125.05</c:v>
                </c:pt>
                <c:pt idx="386">
                  <c:v>126.1</c:v>
                </c:pt>
                <c:pt idx="387">
                  <c:v>126.1</c:v>
                </c:pt>
                <c:pt idx="388">
                  <c:v>126.1</c:v>
                </c:pt>
                <c:pt idx="389">
                  <c:v>127</c:v>
                </c:pt>
                <c:pt idx="390">
                  <c:v>127</c:v>
                </c:pt>
                <c:pt idx="391">
                  <c:v>127</c:v>
                </c:pt>
                <c:pt idx="392">
                  <c:v>128.19999999999999</c:v>
                </c:pt>
                <c:pt idx="393">
                  <c:v>128.19999999999999</c:v>
                </c:pt>
                <c:pt idx="394">
                  <c:v>128.19999999999999</c:v>
                </c:pt>
                <c:pt idx="395">
                  <c:v>129.1</c:v>
                </c:pt>
                <c:pt idx="396">
                  <c:v>129.1</c:v>
                </c:pt>
                <c:pt idx="397">
                  <c:v>129.1</c:v>
                </c:pt>
                <c:pt idx="398">
                  <c:v>130</c:v>
                </c:pt>
                <c:pt idx="399">
                  <c:v>130</c:v>
                </c:pt>
                <c:pt idx="400">
                  <c:v>130</c:v>
                </c:pt>
                <c:pt idx="401">
                  <c:v>131.1</c:v>
                </c:pt>
                <c:pt idx="402">
                  <c:v>131.1</c:v>
                </c:pt>
                <c:pt idx="403">
                  <c:v>131.1</c:v>
                </c:pt>
                <c:pt idx="404">
                  <c:v>133.1</c:v>
                </c:pt>
                <c:pt idx="405">
                  <c:v>133.1</c:v>
                </c:pt>
                <c:pt idx="406">
                  <c:v>133.1</c:v>
                </c:pt>
                <c:pt idx="407">
                  <c:v>134.1</c:v>
                </c:pt>
                <c:pt idx="408">
                  <c:v>134.1</c:v>
                </c:pt>
                <c:pt idx="409">
                  <c:v>134.1</c:v>
                </c:pt>
                <c:pt idx="410">
                  <c:v>135.1</c:v>
                </c:pt>
                <c:pt idx="411">
                  <c:v>135.1</c:v>
                </c:pt>
                <c:pt idx="412">
                  <c:v>135.1</c:v>
                </c:pt>
                <c:pt idx="413">
                  <c:v>136.15</c:v>
                </c:pt>
                <c:pt idx="414">
                  <c:v>136.15</c:v>
                </c:pt>
                <c:pt idx="415">
                  <c:v>136.15</c:v>
                </c:pt>
                <c:pt idx="416">
                  <c:v>137.1</c:v>
                </c:pt>
                <c:pt idx="417">
                  <c:v>137.1</c:v>
                </c:pt>
                <c:pt idx="418">
                  <c:v>137.1</c:v>
                </c:pt>
                <c:pt idx="419">
                  <c:v>138.1</c:v>
                </c:pt>
                <c:pt idx="420">
                  <c:v>138.1</c:v>
                </c:pt>
                <c:pt idx="421">
                  <c:v>138.1</c:v>
                </c:pt>
                <c:pt idx="422">
                  <c:v>139.1</c:v>
                </c:pt>
                <c:pt idx="423">
                  <c:v>139.1</c:v>
                </c:pt>
                <c:pt idx="424">
                  <c:v>139.1</c:v>
                </c:pt>
                <c:pt idx="425">
                  <c:v>140</c:v>
                </c:pt>
                <c:pt idx="426">
                  <c:v>140</c:v>
                </c:pt>
                <c:pt idx="427">
                  <c:v>140</c:v>
                </c:pt>
                <c:pt idx="428">
                  <c:v>141</c:v>
                </c:pt>
                <c:pt idx="429">
                  <c:v>141</c:v>
                </c:pt>
                <c:pt idx="430">
                  <c:v>141</c:v>
                </c:pt>
                <c:pt idx="431">
                  <c:v>142.1</c:v>
                </c:pt>
                <c:pt idx="432">
                  <c:v>142.1</c:v>
                </c:pt>
                <c:pt idx="433">
                  <c:v>142.1</c:v>
                </c:pt>
                <c:pt idx="434">
                  <c:v>143.19999999999999</c:v>
                </c:pt>
                <c:pt idx="435">
                  <c:v>143.19999999999999</c:v>
                </c:pt>
                <c:pt idx="436">
                  <c:v>143.19999999999999</c:v>
                </c:pt>
                <c:pt idx="437">
                  <c:v>144.19999999999999</c:v>
                </c:pt>
                <c:pt idx="438">
                  <c:v>144.19999999999999</c:v>
                </c:pt>
                <c:pt idx="439">
                  <c:v>144.19999999999999</c:v>
                </c:pt>
                <c:pt idx="440">
                  <c:v>145.1</c:v>
                </c:pt>
                <c:pt idx="441">
                  <c:v>145.1</c:v>
                </c:pt>
                <c:pt idx="442">
                  <c:v>145.1</c:v>
                </c:pt>
                <c:pt idx="443">
                  <c:v>146.1</c:v>
                </c:pt>
                <c:pt idx="444">
                  <c:v>146.1</c:v>
                </c:pt>
                <c:pt idx="445">
                  <c:v>146.1</c:v>
                </c:pt>
                <c:pt idx="446">
                  <c:v>147.1</c:v>
                </c:pt>
                <c:pt idx="447">
                  <c:v>147.1</c:v>
                </c:pt>
                <c:pt idx="448">
                  <c:v>147.1</c:v>
                </c:pt>
                <c:pt idx="449">
                  <c:v>148.1</c:v>
                </c:pt>
                <c:pt idx="450">
                  <c:v>148.1</c:v>
                </c:pt>
                <c:pt idx="451">
                  <c:v>148.1</c:v>
                </c:pt>
                <c:pt idx="452">
                  <c:v>149.19999999999999</c:v>
                </c:pt>
                <c:pt idx="453">
                  <c:v>149.19999999999999</c:v>
                </c:pt>
                <c:pt idx="454">
                  <c:v>149.19999999999999</c:v>
                </c:pt>
                <c:pt idx="455">
                  <c:v>151.1</c:v>
                </c:pt>
                <c:pt idx="456">
                  <c:v>151.1</c:v>
                </c:pt>
                <c:pt idx="457">
                  <c:v>151.1</c:v>
                </c:pt>
                <c:pt idx="458">
                  <c:v>152.1</c:v>
                </c:pt>
                <c:pt idx="459">
                  <c:v>152.1</c:v>
                </c:pt>
                <c:pt idx="460">
                  <c:v>152.1</c:v>
                </c:pt>
                <c:pt idx="461">
                  <c:v>155</c:v>
                </c:pt>
                <c:pt idx="462">
                  <c:v>155</c:v>
                </c:pt>
                <c:pt idx="463">
                  <c:v>155</c:v>
                </c:pt>
                <c:pt idx="464">
                  <c:v>156.1</c:v>
                </c:pt>
                <c:pt idx="465">
                  <c:v>156.1</c:v>
                </c:pt>
                <c:pt idx="466">
                  <c:v>156.1</c:v>
                </c:pt>
                <c:pt idx="467">
                  <c:v>157</c:v>
                </c:pt>
                <c:pt idx="468">
                  <c:v>157</c:v>
                </c:pt>
                <c:pt idx="469">
                  <c:v>157</c:v>
                </c:pt>
                <c:pt idx="470">
                  <c:v>157.19999999999999</c:v>
                </c:pt>
                <c:pt idx="471">
                  <c:v>157.19999999999999</c:v>
                </c:pt>
                <c:pt idx="472">
                  <c:v>157.19999999999999</c:v>
                </c:pt>
                <c:pt idx="473">
                  <c:v>159.19999999999999</c:v>
                </c:pt>
                <c:pt idx="474">
                  <c:v>159.19999999999999</c:v>
                </c:pt>
                <c:pt idx="475">
                  <c:v>159.19999999999999</c:v>
                </c:pt>
                <c:pt idx="476">
                  <c:v>160.19999999999999</c:v>
                </c:pt>
                <c:pt idx="477">
                  <c:v>160.19999999999999</c:v>
                </c:pt>
                <c:pt idx="478">
                  <c:v>160.19999999999999</c:v>
                </c:pt>
                <c:pt idx="479">
                  <c:v>161.19999999999999</c:v>
                </c:pt>
                <c:pt idx="480">
                  <c:v>161.19999999999999</c:v>
                </c:pt>
                <c:pt idx="481">
                  <c:v>161.19999999999999</c:v>
                </c:pt>
                <c:pt idx="482">
                  <c:v>162.19999999999999</c:v>
                </c:pt>
                <c:pt idx="483">
                  <c:v>162.19999999999999</c:v>
                </c:pt>
                <c:pt idx="484">
                  <c:v>162.19999999999999</c:v>
                </c:pt>
                <c:pt idx="485">
                  <c:v>163.19999999999999</c:v>
                </c:pt>
                <c:pt idx="486">
                  <c:v>163.19999999999999</c:v>
                </c:pt>
                <c:pt idx="487">
                  <c:v>163.19999999999999</c:v>
                </c:pt>
                <c:pt idx="488">
                  <c:v>165.1</c:v>
                </c:pt>
                <c:pt idx="489">
                  <c:v>165.1</c:v>
                </c:pt>
                <c:pt idx="490">
                  <c:v>165.1</c:v>
                </c:pt>
                <c:pt idx="491">
                  <c:v>166</c:v>
                </c:pt>
                <c:pt idx="492">
                  <c:v>166</c:v>
                </c:pt>
                <c:pt idx="493">
                  <c:v>166</c:v>
                </c:pt>
                <c:pt idx="494">
                  <c:v>171.2</c:v>
                </c:pt>
                <c:pt idx="495">
                  <c:v>171.2</c:v>
                </c:pt>
                <c:pt idx="496">
                  <c:v>171.2</c:v>
                </c:pt>
                <c:pt idx="497">
                  <c:v>173.2</c:v>
                </c:pt>
                <c:pt idx="498">
                  <c:v>173.2</c:v>
                </c:pt>
                <c:pt idx="499">
                  <c:v>173.2</c:v>
                </c:pt>
                <c:pt idx="500">
                  <c:v>174.1</c:v>
                </c:pt>
                <c:pt idx="501">
                  <c:v>174.1</c:v>
                </c:pt>
                <c:pt idx="502">
                  <c:v>174.1</c:v>
                </c:pt>
                <c:pt idx="503">
                  <c:v>175.1</c:v>
                </c:pt>
                <c:pt idx="504">
                  <c:v>175.1</c:v>
                </c:pt>
                <c:pt idx="505">
                  <c:v>175.1</c:v>
                </c:pt>
                <c:pt idx="506">
                  <c:v>176.1</c:v>
                </c:pt>
                <c:pt idx="507">
                  <c:v>176.1</c:v>
                </c:pt>
                <c:pt idx="508">
                  <c:v>176.1</c:v>
                </c:pt>
                <c:pt idx="509">
                  <c:v>177.1</c:v>
                </c:pt>
                <c:pt idx="510">
                  <c:v>177.1</c:v>
                </c:pt>
                <c:pt idx="511">
                  <c:v>177.1</c:v>
                </c:pt>
                <c:pt idx="512">
                  <c:v>178.1</c:v>
                </c:pt>
                <c:pt idx="513">
                  <c:v>178.1</c:v>
                </c:pt>
                <c:pt idx="514">
                  <c:v>178.1</c:v>
                </c:pt>
                <c:pt idx="515">
                  <c:v>179.2</c:v>
                </c:pt>
                <c:pt idx="516">
                  <c:v>179.2</c:v>
                </c:pt>
                <c:pt idx="517">
                  <c:v>179.2</c:v>
                </c:pt>
                <c:pt idx="518">
                  <c:v>183.1</c:v>
                </c:pt>
                <c:pt idx="519">
                  <c:v>183.1</c:v>
                </c:pt>
                <c:pt idx="520">
                  <c:v>183.1</c:v>
                </c:pt>
                <c:pt idx="521">
                  <c:v>185.1</c:v>
                </c:pt>
                <c:pt idx="522">
                  <c:v>185.1</c:v>
                </c:pt>
                <c:pt idx="523">
                  <c:v>185.1</c:v>
                </c:pt>
                <c:pt idx="524">
                  <c:v>187.1</c:v>
                </c:pt>
                <c:pt idx="525">
                  <c:v>187.1</c:v>
                </c:pt>
                <c:pt idx="526">
                  <c:v>187.1</c:v>
                </c:pt>
                <c:pt idx="527">
                  <c:v>188.1</c:v>
                </c:pt>
                <c:pt idx="528">
                  <c:v>188.1</c:v>
                </c:pt>
                <c:pt idx="529">
                  <c:v>188.1</c:v>
                </c:pt>
                <c:pt idx="530">
                  <c:v>189.2</c:v>
                </c:pt>
                <c:pt idx="531">
                  <c:v>189.2</c:v>
                </c:pt>
                <c:pt idx="532">
                  <c:v>189.2</c:v>
                </c:pt>
                <c:pt idx="533">
                  <c:v>190.1</c:v>
                </c:pt>
                <c:pt idx="534">
                  <c:v>190.1</c:v>
                </c:pt>
                <c:pt idx="535">
                  <c:v>190.1</c:v>
                </c:pt>
                <c:pt idx="536">
                  <c:v>191.1</c:v>
                </c:pt>
                <c:pt idx="537">
                  <c:v>191.1</c:v>
                </c:pt>
                <c:pt idx="538">
                  <c:v>191.1</c:v>
                </c:pt>
                <c:pt idx="539">
                  <c:v>192.2</c:v>
                </c:pt>
                <c:pt idx="540">
                  <c:v>192.2</c:v>
                </c:pt>
                <c:pt idx="541">
                  <c:v>192.2</c:v>
                </c:pt>
                <c:pt idx="542">
                  <c:v>197.1</c:v>
                </c:pt>
                <c:pt idx="543">
                  <c:v>197.1</c:v>
                </c:pt>
                <c:pt idx="544">
                  <c:v>197.1</c:v>
                </c:pt>
                <c:pt idx="545">
                  <c:v>201.1</c:v>
                </c:pt>
                <c:pt idx="546">
                  <c:v>201.1</c:v>
                </c:pt>
                <c:pt idx="547">
                  <c:v>201.1</c:v>
                </c:pt>
                <c:pt idx="548">
                  <c:v>202.1</c:v>
                </c:pt>
                <c:pt idx="549">
                  <c:v>202.1</c:v>
                </c:pt>
                <c:pt idx="550">
                  <c:v>202.1</c:v>
                </c:pt>
                <c:pt idx="551">
                  <c:v>203.1</c:v>
                </c:pt>
                <c:pt idx="552">
                  <c:v>203.1</c:v>
                </c:pt>
                <c:pt idx="553">
                  <c:v>203.1</c:v>
                </c:pt>
                <c:pt idx="554">
                  <c:v>205.2</c:v>
                </c:pt>
                <c:pt idx="555">
                  <c:v>205.2</c:v>
                </c:pt>
                <c:pt idx="556">
                  <c:v>205.2</c:v>
                </c:pt>
                <c:pt idx="557">
                  <c:v>207.1</c:v>
                </c:pt>
                <c:pt idx="558">
                  <c:v>207.1</c:v>
                </c:pt>
                <c:pt idx="559">
                  <c:v>207.1</c:v>
                </c:pt>
                <c:pt idx="560">
                  <c:v>208.1</c:v>
                </c:pt>
                <c:pt idx="561">
                  <c:v>208.1</c:v>
                </c:pt>
                <c:pt idx="562">
                  <c:v>208.1</c:v>
                </c:pt>
                <c:pt idx="563">
                  <c:v>208.8</c:v>
                </c:pt>
                <c:pt idx="564">
                  <c:v>208.8</c:v>
                </c:pt>
                <c:pt idx="565">
                  <c:v>208.8</c:v>
                </c:pt>
                <c:pt idx="566">
                  <c:v>215.2</c:v>
                </c:pt>
                <c:pt idx="567">
                  <c:v>215.2</c:v>
                </c:pt>
                <c:pt idx="568">
                  <c:v>215.2</c:v>
                </c:pt>
                <c:pt idx="569">
                  <c:v>217.2</c:v>
                </c:pt>
                <c:pt idx="570">
                  <c:v>217.2</c:v>
                </c:pt>
                <c:pt idx="571">
                  <c:v>217.2</c:v>
                </c:pt>
                <c:pt idx="572">
                  <c:v>218.2</c:v>
                </c:pt>
                <c:pt idx="573">
                  <c:v>218.2</c:v>
                </c:pt>
                <c:pt idx="574">
                  <c:v>218.2</c:v>
                </c:pt>
                <c:pt idx="575">
                  <c:v>230.1</c:v>
                </c:pt>
                <c:pt idx="576">
                  <c:v>230.1</c:v>
                </c:pt>
                <c:pt idx="577">
                  <c:v>230.1</c:v>
                </c:pt>
                <c:pt idx="578">
                  <c:v>231.1</c:v>
                </c:pt>
                <c:pt idx="579">
                  <c:v>231.1</c:v>
                </c:pt>
                <c:pt idx="580">
                  <c:v>231.1</c:v>
                </c:pt>
                <c:pt idx="581">
                  <c:v>233.1</c:v>
                </c:pt>
                <c:pt idx="582">
                  <c:v>233.1</c:v>
                </c:pt>
                <c:pt idx="583">
                  <c:v>233.1</c:v>
                </c:pt>
                <c:pt idx="584">
                  <c:v>292.89999999999998</c:v>
                </c:pt>
                <c:pt idx="585">
                  <c:v>292.89999999999998</c:v>
                </c:pt>
                <c:pt idx="586">
                  <c:v>292.89999999999998</c:v>
                </c:pt>
                <c:pt idx="587">
                  <c:v>308.10000000000002</c:v>
                </c:pt>
                <c:pt idx="588">
                  <c:v>308.10000000000002</c:v>
                </c:pt>
                <c:pt idx="589">
                  <c:v>308.10000000000002</c:v>
                </c:pt>
              </c:numCache>
            </c:numRef>
          </c:xVal>
          <c:yVal>
            <c:numRef>
              <c:f>'[Chart in Microsoft PowerPoint]3OAc4OH'!$H$4:$H$593</c:f>
              <c:numCache>
                <c:formatCode>General</c:formatCode>
                <c:ptCount val="59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2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737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84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1326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65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159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213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598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176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1049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228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814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165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402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1568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373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1029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415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1423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412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482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473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349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2515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499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3521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647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1871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353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873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3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159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272</c:v>
                </c:pt>
                <c:pt idx="293">
                  <c:v>0</c:v>
                </c:pt>
                <c:pt idx="294">
                  <c:v>0</c:v>
                </c:pt>
                <c:pt idx="295">
                  <c:v>0</c:v>
                </c:pt>
                <c:pt idx="296">
                  <c:v>0</c:v>
                </c:pt>
                <c:pt idx="297">
                  <c:v>0</c:v>
                </c:pt>
                <c:pt idx="298">
                  <c:v>0</c:v>
                </c:pt>
                <c:pt idx="299">
                  <c:v>0</c:v>
                </c:pt>
                <c:pt idx="300">
                  <c:v>0</c:v>
                </c:pt>
                <c:pt idx="301">
                  <c:v>1759</c:v>
                </c:pt>
                <c:pt idx="302">
                  <c:v>0</c:v>
                </c:pt>
                <c:pt idx="303">
                  <c:v>0</c:v>
                </c:pt>
                <c:pt idx="304">
                  <c:v>0</c:v>
                </c:pt>
                <c:pt idx="305">
                  <c:v>0</c:v>
                </c:pt>
                <c:pt idx="306">
                  <c:v>0</c:v>
                </c:pt>
                <c:pt idx="307">
                  <c:v>0</c:v>
                </c:pt>
                <c:pt idx="308">
                  <c:v>0</c:v>
                </c:pt>
                <c:pt idx="309">
                  <c:v>0</c:v>
                </c:pt>
                <c:pt idx="310">
                  <c:v>757</c:v>
                </c:pt>
                <c:pt idx="311">
                  <c:v>0</c:v>
                </c:pt>
                <c:pt idx="312">
                  <c:v>0</c:v>
                </c:pt>
                <c:pt idx="313">
                  <c:v>0</c:v>
                </c:pt>
                <c:pt idx="314">
                  <c:v>0</c:v>
                </c:pt>
                <c:pt idx="315">
                  <c:v>0</c:v>
                </c:pt>
                <c:pt idx="316">
                  <c:v>0</c:v>
                </c:pt>
                <c:pt idx="317">
                  <c:v>0</c:v>
                </c:pt>
                <c:pt idx="318">
                  <c:v>0</c:v>
                </c:pt>
                <c:pt idx="319">
                  <c:v>3113</c:v>
                </c:pt>
                <c:pt idx="320">
                  <c:v>0</c:v>
                </c:pt>
                <c:pt idx="321">
                  <c:v>0</c:v>
                </c:pt>
                <c:pt idx="322">
                  <c:v>0</c:v>
                </c:pt>
                <c:pt idx="323">
                  <c:v>0</c:v>
                </c:pt>
                <c:pt idx="324">
                  <c:v>0</c:v>
                </c:pt>
                <c:pt idx="325">
                  <c:v>0</c:v>
                </c:pt>
                <c:pt idx="326">
                  <c:v>0</c:v>
                </c:pt>
                <c:pt idx="327">
                  <c:v>0</c:v>
                </c:pt>
                <c:pt idx="328">
                  <c:v>3113</c:v>
                </c:pt>
                <c:pt idx="329">
                  <c:v>0</c:v>
                </c:pt>
                <c:pt idx="330">
                  <c:v>0</c:v>
                </c:pt>
                <c:pt idx="331">
                  <c:v>0</c:v>
                </c:pt>
                <c:pt idx="332">
                  <c:v>0</c:v>
                </c:pt>
                <c:pt idx="333">
                  <c:v>0</c:v>
                </c:pt>
                <c:pt idx="334">
                  <c:v>0</c:v>
                </c:pt>
                <c:pt idx="335">
                  <c:v>0</c:v>
                </c:pt>
                <c:pt idx="336">
                  <c:v>0</c:v>
                </c:pt>
                <c:pt idx="337">
                  <c:v>1808</c:v>
                </c:pt>
                <c:pt idx="338">
                  <c:v>0</c:v>
                </c:pt>
                <c:pt idx="339">
                  <c:v>0</c:v>
                </c:pt>
                <c:pt idx="340">
                  <c:v>0</c:v>
                </c:pt>
                <c:pt idx="341">
                  <c:v>0</c:v>
                </c:pt>
                <c:pt idx="342">
                  <c:v>0</c:v>
                </c:pt>
                <c:pt idx="343">
                  <c:v>0</c:v>
                </c:pt>
                <c:pt idx="344">
                  <c:v>0</c:v>
                </c:pt>
                <c:pt idx="345">
                  <c:v>0</c:v>
                </c:pt>
                <c:pt idx="346">
                  <c:v>270</c:v>
                </c:pt>
                <c:pt idx="347">
                  <c:v>0</c:v>
                </c:pt>
                <c:pt idx="348">
                  <c:v>0</c:v>
                </c:pt>
                <c:pt idx="349">
                  <c:v>0</c:v>
                </c:pt>
                <c:pt idx="350">
                  <c:v>0</c:v>
                </c:pt>
                <c:pt idx="351">
                  <c:v>0</c:v>
                </c:pt>
                <c:pt idx="352">
                  <c:v>0</c:v>
                </c:pt>
                <c:pt idx="353">
                  <c:v>0</c:v>
                </c:pt>
                <c:pt idx="354">
                  <c:v>573</c:v>
                </c:pt>
                <c:pt idx="355">
                  <c:v>0</c:v>
                </c:pt>
                <c:pt idx="356">
                  <c:v>0</c:v>
                </c:pt>
                <c:pt idx="357">
                  <c:v>203</c:v>
                </c:pt>
                <c:pt idx="358">
                  <c:v>0</c:v>
                </c:pt>
                <c:pt idx="359">
                  <c:v>0</c:v>
                </c:pt>
                <c:pt idx="360">
                  <c:v>5</c:v>
                </c:pt>
                <c:pt idx="361">
                  <c:v>0</c:v>
                </c:pt>
                <c:pt idx="362">
                  <c:v>0</c:v>
                </c:pt>
                <c:pt idx="363">
                  <c:v>380</c:v>
                </c:pt>
                <c:pt idx="364">
                  <c:v>0</c:v>
                </c:pt>
                <c:pt idx="365">
                  <c:v>0</c:v>
                </c:pt>
                <c:pt idx="366">
                  <c:v>1354</c:v>
                </c:pt>
                <c:pt idx="367">
                  <c:v>0</c:v>
                </c:pt>
                <c:pt idx="368">
                  <c:v>0</c:v>
                </c:pt>
                <c:pt idx="369">
                  <c:v>416</c:v>
                </c:pt>
                <c:pt idx="370">
                  <c:v>0</c:v>
                </c:pt>
                <c:pt idx="371">
                  <c:v>0</c:v>
                </c:pt>
                <c:pt idx="372">
                  <c:v>972</c:v>
                </c:pt>
                <c:pt idx="373">
                  <c:v>0</c:v>
                </c:pt>
                <c:pt idx="374">
                  <c:v>0</c:v>
                </c:pt>
                <c:pt idx="375">
                  <c:v>245</c:v>
                </c:pt>
                <c:pt idx="376">
                  <c:v>0</c:v>
                </c:pt>
                <c:pt idx="377">
                  <c:v>0</c:v>
                </c:pt>
                <c:pt idx="378">
                  <c:v>1472</c:v>
                </c:pt>
                <c:pt idx="379">
                  <c:v>0</c:v>
                </c:pt>
                <c:pt idx="380">
                  <c:v>0</c:v>
                </c:pt>
                <c:pt idx="381">
                  <c:v>3679</c:v>
                </c:pt>
                <c:pt idx="382">
                  <c:v>0</c:v>
                </c:pt>
                <c:pt idx="383">
                  <c:v>0</c:v>
                </c:pt>
                <c:pt idx="384">
                  <c:v>1842</c:v>
                </c:pt>
                <c:pt idx="385">
                  <c:v>0</c:v>
                </c:pt>
                <c:pt idx="386">
                  <c:v>0</c:v>
                </c:pt>
                <c:pt idx="387">
                  <c:v>389</c:v>
                </c:pt>
                <c:pt idx="388">
                  <c:v>0</c:v>
                </c:pt>
                <c:pt idx="389">
                  <c:v>0</c:v>
                </c:pt>
                <c:pt idx="390">
                  <c:v>271</c:v>
                </c:pt>
                <c:pt idx="391">
                  <c:v>0</c:v>
                </c:pt>
                <c:pt idx="392">
                  <c:v>0</c:v>
                </c:pt>
                <c:pt idx="393">
                  <c:v>336</c:v>
                </c:pt>
                <c:pt idx="394">
                  <c:v>0</c:v>
                </c:pt>
                <c:pt idx="395">
                  <c:v>0</c:v>
                </c:pt>
                <c:pt idx="396">
                  <c:v>609</c:v>
                </c:pt>
                <c:pt idx="397">
                  <c:v>0</c:v>
                </c:pt>
                <c:pt idx="398">
                  <c:v>0</c:v>
                </c:pt>
                <c:pt idx="399">
                  <c:v>174</c:v>
                </c:pt>
                <c:pt idx="400">
                  <c:v>0</c:v>
                </c:pt>
                <c:pt idx="401">
                  <c:v>0</c:v>
                </c:pt>
                <c:pt idx="402">
                  <c:v>561</c:v>
                </c:pt>
                <c:pt idx="403">
                  <c:v>0</c:v>
                </c:pt>
                <c:pt idx="404">
                  <c:v>0</c:v>
                </c:pt>
                <c:pt idx="405">
                  <c:v>1012</c:v>
                </c:pt>
                <c:pt idx="406">
                  <c:v>0</c:v>
                </c:pt>
                <c:pt idx="407">
                  <c:v>0</c:v>
                </c:pt>
                <c:pt idx="408">
                  <c:v>424</c:v>
                </c:pt>
                <c:pt idx="409">
                  <c:v>0</c:v>
                </c:pt>
                <c:pt idx="410">
                  <c:v>0</c:v>
                </c:pt>
                <c:pt idx="411">
                  <c:v>1212</c:v>
                </c:pt>
                <c:pt idx="412">
                  <c:v>0</c:v>
                </c:pt>
                <c:pt idx="413">
                  <c:v>0</c:v>
                </c:pt>
                <c:pt idx="414">
                  <c:v>191</c:v>
                </c:pt>
                <c:pt idx="415">
                  <c:v>0</c:v>
                </c:pt>
                <c:pt idx="416">
                  <c:v>0</c:v>
                </c:pt>
                <c:pt idx="417">
                  <c:v>384</c:v>
                </c:pt>
                <c:pt idx="418">
                  <c:v>0</c:v>
                </c:pt>
                <c:pt idx="419">
                  <c:v>0</c:v>
                </c:pt>
                <c:pt idx="420">
                  <c:v>173</c:v>
                </c:pt>
                <c:pt idx="421">
                  <c:v>0</c:v>
                </c:pt>
                <c:pt idx="422">
                  <c:v>0</c:v>
                </c:pt>
                <c:pt idx="423">
                  <c:v>313</c:v>
                </c:pt>
                <c:pt idx="424">
                  <c:v>0</c:v>
                </c:pt>
                <c:pt idx="425">
                  <c:v>0</c:v>
                </c:pt>
                <c:pt idx="426">
                  <c:v>251</c:v>
                </c:pt>
                <c:pt idx="427">
                  <c:v>0</c:v>
                </c:pt>
                <c:pt idx="428">
                  <c:v>0</c:v>
                </c:pt>
                <c:pt idx="429">
                  <c:v>373</c:v>
                </c:pt>
                <c:pt idx="430">
                  <c:v>0</c:v>
                </c:pt>
                <c:pt idx="431">
                  <c:v>0</c:v>
                </c:pt>
                <c:pt idx="432">
                  <c:v>269</c:v>
                </c:pt>
                <c:pt idx="433">
                  <c:v>0</c:v>
                </c:pt>
                <c:pt idx="434">
                  <c:v>0</c:v>
                </c:pt>
                <c:pt idx="435">
                  <c:v>588</c:v>
                </c:pt>
                <c:pt idx="436">
                  <c:v>0</c:v>
                </c:pt>
                <c:pt idx="437">
                  <c:v>0</c:v>
                </c:pt>
                <c:pt idx="438">
                  <c:v>208</c:v>
                </c:pt>
                <c:pt idx="439">
                  <c:v>0</c:v>
                </c:pt>
                <c:pt idx="440">
                  <c:v>0</c:v>
                </c:pt>
                <c:pt idx="441">
                  <c:v>781</c:v>
                </c:pt>
                <c:pt idx="442">
                  <c:v>0</c:v>
                </c:pt>
                <c:pt idx="443">
                  <c:v>0</c:v>
                </c:pt>
                <c:pt idx="444">
                  <c:v>292</c:v>
                </c:pt>
                <c:pt idx="445">
                  <c:v>0</c:v>
                </c:pt>
                <c:pt idx="446">
                  <c:v>0</c:v>
                </c:pt>
                <c:pt idx="447">
                  <c:v>1109</c:v>
                </c:pt>
                <c:pt idx="448">
                  <c:v>0</c:v>
                </c:pt>
                <c:pt idx="449">
                  <c:v>0</c:v>
                </c:pt>
                <c:pt idx="450">
                  <c:v>385</c:v>
                </c:pt>
                <c:pt idx="451">
                  <c:v>0</c:v>
                </c:pt>
                <c:pt idx="452">
                  <c:v>0</c:v>
                </c:pt>
                <c:pt idx="453">
                  <c:v>563</c:v>
                </c:pt>
                <c:pt idx="454">
                  <c:v>0</c:v>
                </c:pt>
                <c:pt idx="455">
                  <c:v>0</c:v>
                </c:pt>
                <c:pt idx="456">
                  <c:v>262</c:v>
                </c:pt>
                <c:pt idx="457">
                  <c:v>0</c:v>
                </c:pt>
                <c:pt idx="458">
                  <c:v>0</c:v>
                </c:pt>
                <c:pt idx="459">
                  <c:v>317</c:v>
                </c:pt>
                <c:pt idx="460">
                  <c:v>0</c:v>
                </c:pt>
                <c:pt idx="461">
                  <c:v>0</c:v>
                </c:pt>
                <c:pt idx="462">
                  <c:v>165</c:v>
                </c:pt>
                <c:pt idx="463">
                  <c:v>0</c:v>
                </c:pt>
                <c:pt idx="464">
                  <c:v>0</c:v>
                </c:pt>
                <c:pt idx="465">
                  <c:v>249</c:v>
                </c:pt>
                <c:pt idx="466">
                  <c:v>0</c:v>
                </c:pt>
                <c:pt idx="467">
                  <c:v>0</c:v>
                </c:pt>
                <c:pt idx="468">
                  <c:v>279</c:v>
                </c:pt>
                <c:pt idx="469">
                  <c:v>0</c:v>
                </c:pt>
                <c:pt idx="470">
                  <c:v>0</c:v>
                </c:pt>
                <c:pt idx="471">
                  <c:v>281</c:v>
                </c:pt>
                <c:pt idx="472">
                  <c:v>0</c:v>
                </c:pt>
                <c:pt idx="473">
                  <c:v>0</c:v>
                </c:pt>
                <c:pt idx="474">
                  <c:v>865</c:v>
                </c:pt>
                <c:pt idx="475">
                  <c:v>0</c:v>
                </c:pt>
                <c:pt idx="476">
                  <c:v>0</c:v>
                </c:pt>
                <c:pt idx="477">
                  <c:v>406</c:v>
                </c:pt>
                <c:pt idx="478">
                  <c:v>0</c:v>
                </c:pt>
                <c:pt idx="479">
                  <c:v>0</c:v>
                </c:pt>
                <c:pt idx="480">
                  <c:v>3435</c:v>
                </c:pt>
                <c:pt idx="481">
                  <c:v>0</c:v>
                </c:pt>
                <c:pt idx="482">
                  <c:v>0</c:v>
                </c:pt>
                <c:pt idx="483">
                  <c:v>624</c:v>
                </c:pt>
                <c:pt idx="484">
                  <c:v>0</c:v>
                </c:pt>
                <c:pt idx="485">
                  <c:v>0</c:v>
                </c:pt>
                <c:pt idx="486">
                  <c:v>477</c:v>
                </c:pt>
                <c:pt idx="487">
                  <c:v>0</c:v>
                </c:pt>
                <c:pt idx="488">
                  <c:v>0</c:v>
                </c:pt>
                <c:pt idx="489">
                  <c:v>268</c:v>
                </c:pt>
                <c:pt idx="490">
                  <c:v>0</c:v>
                </c:pt>
                <c:pt idx="491">
                  <c:v>0</c:v>
                </c:pt>
                <c:pt idx="492">
                  <c:v>181</c:v>
                </c:pt>
                <c:pt idx="493">
                  <c:v>0</c:v>
                </c:pt>
                <c:pt idx="494">
                  <c:v>0</c:v>
                </c:pt>
                <c:pt idx="495">
                  <c:v>674</c:v>
                </c:pt>
                <c:pt idx="496">
                  <c:v>0</c:v>
                </c:pt>
                <c:pt idx="497">
                  <c:v>0</c:v>
                </c:pt>
                <c:pt idx="498">
                  <c:v>767</c:v>
                </c:pt>
                <c:pt idx="499">
                  <c:v>0</c:v>
                </c:pt>
                <c:pt idx="500">
                  <c:v>0</c:v>
                </c:pt>
                <c:pt idx="501">
                  <c:v>391</c:v>
                </c:pt>
                <c:pt idx="502">
                  <c:v>0</c:v>
                </c:pt>
                <c:pt idx="503">
                  <c:v>0</c:v>
                </c:pt>
                <c:pt idx="504">
                  <c:v>1025</c:v>
                </c:pt>
                <c:pt idx="505">
                  <c:v>0</c:v>
                </c:pt>
                <c:pt idx="506">
                  <c:v>0</c:v>
                </c:pt>
                <c:pt idx="507">
                  <c:v>196</c:v>
                </c:pt>
                <c:pt idx="508">
                  <c:v>0</c:v>
                </c:pt>
                <c:pt idx="509">
                  <c:v>0</c:v>
                </c:pt>
                <c:pt idx="510">
                  <c:v>518</c:v>
                </c:pt>
                <c:pt idx="511">
                  <c:v>0</c:v>
                </c:pt>
                <c:pt idx="512">
                  <c:v>0</c:v>
                </c:pt>
                <c:pt idx="513">
                  <c:v>158</c:v>
                </c:pt>
                <c:pt idx="514">
                  <c:v>0</c:v>
                </c:pt>
                <c:pt idx="515">
                  <c:v>0</c:v>
                </c:pt>
                <c:pt idx="516">
                  <c:v>409</c:v>
                </c:pt>
                <c:pt idx="517">
                  <c:v>0</c:v>
                </c:pt>
                <c:pt idx="518">
                  <c:v>0</c:v>
                </c:pt>
                <c:pt idx="519">
                  <c:v>256</c:v>
                </c:pt>
                <c:pt idx="520">
                  <c:v>0</c:v>
                </c:pt>
                <c:pt idx="521">
                  <c:v>0</c:v>
                </c:pt>
                <c:pt idx="522">
                  <c:v>167</c:v>
                </c:pt>
                <c:pt idx="523">
                  <c:v>0</c:v>
                </c:pt>
                <c:pt idx="524">
                  <c:v>0</c:v>
                </c:pt>
                <c:pt idx="525">
                  <c:v>383</c:v>
                </c:pt>
                <c:pt idx="526">
                  <c:v>0</c:v>
                </c:pt>
                <c:pt idx="527">
                  <c:v>0</c:v>
                </c:pt>
                <c:pt idx="528">
                  <c:v>181</c:v>
                </c:pt>
                <c:pt idx="529">
                  <c:v>0</c:v>
                </c:pt>
                <c:pt idx="530">
                  <c:v>0</c:v>
                </c:pt>
                <c:pt idx="531">
                  <c:v>1151</c:v>
                </c:pt>
                <c:pt idx="532">
                  <c:v>0</c:v>
                </c:pt>
                <c:pt idx="533">
                  <c:v>0</c:v>
                </c:pt>
                <c:pt idx="534">
                  <c:v>633</c:v>
                </c:pt>
                <c:pt idx="535">
                  <c:v>0</c:v>
                </c:pt>
                <c:pt idx="536">
                  <c:v>0</c:v>
                </c:pt>
                <c:pt idx="537">
                  <c:v>383</c:v>
                </c:pt>
                <c:pt idx="538">
                  <c:v>0</c:v>
                </c:pt>
                <c:pt idx="539">
                  <c:v>0</c:v>
                </c:pt>
                <c:pt idx="540">
                  <c:v>181</c:v>
                </c:pt>
                <c:pt idx="541">
                  <c:v>0</c:v>
                </c:pt>
                <c:pt idx="542">
                  <c:v>0</c:v>
                </c:pt>
                <c:pt idx="543">
                  <c:v>69</c:v>
                </c:pt>
                <c:pt idx="544">
                  <c:v>0</c:v>
                </c:pt>
                <c:pt idx="545">
                  <c:v>0</c:v>
                </c:pt>
                <c:pt idx="546">
                  <c:v>287</c:v>
                </c:pt>
                <c:pt idx="547">
                  <c:v>0</c:v>
                </c:pt>
                <c:pt idx="548">
                  <c:v>0</c:v>
                </c:pt>
                <c:pt idx="549">
                  <c:v>195</c:v>
                </c:pt>
                <c:pt idx="550">
                  <c:v>0</c:v>
                </c:pt>
                <c:pt idx="551">
                  <c:v>0</c:v>
                </c:pt>
                <c:pt idx="552">
                  <c:v>347</c:v>
                </c:pt>
                <c:pt idx="553">
                  <c:v>0</c:v>
                </c:pt>
                <c:pt idx="554">
                  <c:v>0</c:v>
                </c:pt>
                <c:pt idx="555">
                  <c:v>270</c:v>
                </c:pt>
                <c:pt idx="556">
                  <c:v>0</c:v>
                </c:pt>
                <c:pt idx="557">
                  <c:v>0</c:v>
                </c:pt>
                <c:pt idx="558">
                  <c:v>2368</c:v>
                </c:pt>
                <c:pt idx="559">
                  <c:v>0</c:v>
                </c:pt>
                <c:pt idx="560">
                  <c:v>0</c:v>
                </c:pt>
                <c:pt idx="561">
                  <c:v>434</c:v>
                </c:pt>
                <c:pt idx="562">
                  <c:v>0</c:v>
                </c:pt>
                <c:pt idx="563">
                  <c:v>0</c:v>
                </c:pt>
                <c:pt idx="564">
                  <c:v>153</c:v>
                </c:pt>
                <c:pt idx="565">
                  <c:v>0</c:v>
                </c:pt>
                <c:pt idx="566">
                  <c:v>0</c:v>
                </c:pt>
                <c:pt idx="567">
                  <c:v>542</c:v>
                </c:pt>
                <c:pt idx="568">
                  <c:v>0</c:v>
                </c:pt>
                <c:pt idx="569">
                  <c:v>0</c:v>
                </c:pt>
                <c:pt idx="570">
                  <c:v>1951</c:v>
                </c:pt>
                <c:pt idx="571">
                  <c:v>0</c:v>
                </c:pt>
                <c:pt idx="572">
                  <c:v>0</c:v>
                </c:pt>
                <c:pt idx="573">
                  <c:v>345</c:v>
                </c:pt>
                <c:pt idx="574">
                  <c:v>0</c:v>
                </c:pt>
                <c:pt idx="575">
                  <c:v>0</c:v>
                </c:pt>
                <c:pt idx="576">
                  <c:v>157</c:v>
                </c:pt>
                <c:pt idx="577">
                  <c:v>0</c:v>
                </c:pt>
                <c:pt idx="578">
                  <c:v>0</c:v>
                </c:pt>
                <c:pt idx="579">
                  <c:v>262</c:v>
                </c:pt>
                <c:pt idx="580">
                  <c:v>0</c:v>
                </c:pt>
                <c:pt idx="581">
                  <c:v>0</c:v>
                </c:pt>
                <c:pt idx="582">
                  <c:v>198</c:v>
                </c:pt>
                <c:pt idx="583">
                  <c:v>0</c:v>
                </c:pt>
                <c:pt idx="584">
                  <c:v>0</c:v>
                </c:pt>
                <c:pt idx="585">
                  <c:v>252</c:v>
                </c:pt>
                <c:pt idx="586">
                  <c:v>0</c:v>
                </c:pt>
                <c:pt idx="587">
                  <c:v>0</c:v>
                </c:pt>
                <c:pt idx="588">
                  <c:v>191</c:v>
                </c:pt>
                <c:pt idx="589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B52-4F7D-AF5C-4029ABC09A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3623248"/>
        <c:axId val="123623808"/>
      </c:scatterChart>
      <c:valAx>
        <c:axId val="123623248"/>
        <c:scaling>
          <c:orientation val="minMax"/>
          <c:min val="5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3623808"/>
        <c:crosses val="autoZero"/>
        <c:crossBetween val="midCat"/>
      </c:valAx>
      <c:valAx>
        <c:axId val="1236238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36232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'FbBbC4Tri11 + 3OAc #8'!$A$4:$A$1389</c:f>
              <c:numCache>
                <c:formatCode>General</c:formatCode>
                <c:ptCount val="1386"/>
                <c:pt idx="0">
                  <c:v>3.085</c:v>
                </c:pt>
                <c:pt idx="1">
                  <c:v>3.0910000000000002</c:v>
                </c:pt>
                <c:pt idx="2">
                  <c:v>3.097</c:v>
                </c:pt>
                <c:pt idx="3">
                  <c:v>3.1019999999999999</c:v>
                </c:pt>
                <c:pt idx="4">
                  <c:v>3.1080000000000001</c:v>
                </c:pt>
                <c:pt idx="5">
                  <c:v>3.1139999999999999</c:v>
                </c:pt>
                <c:pt idx="6">
                  <c:v>3.1190000000000002</c:v>
                </c:pt>
                <c:pt idx="7">
                  <c:v>3.125</c:v>
                </c:pt>
                <c:pt idx="8">
                  <c:v>3.1309999999999998</c:v>
                </c:pt>
                <c:pt idx="9">
                  <c:v>3.137</c:v>
                </c:pt>
                <c:pt idx="10">
                  <c:v>3.1419999999999999</c:v>
                </c:pt>
                <c:pt idx="11">
                  <c:v>3.1480000000000001</c:v>
                </c:pt>
                <c:pt idx="12">
                  <c:v>3.1539999999999999</c:v>
                </c:pt>
                <c:pt idx="13">
                  <c:v>3.1589999999999998</c:v>
                </c:pt>
                <c:pt idx="14">
                  <c:v>3.165</c:v>
                </c:pt>
                <c:pt idx="15">
                  <c:v>3.1709999999999998</c:v>
                </c:pt>
                <c:pt idx="16">
                  <c:v>3.177</c:v>
                </c:pt>
                <c:pt idx="17">
                  <c:v>3.1819999999999999</c:v>
                </c:pt>
                <c:pt idx="18">
                  <c:v>3.1880000000000002</c:v>
                </c:pt>
                <c:pt idx="19">
                  <c:v>3.194</c:v>
                </c:pt>
                <c:pt idx="20">
                  <c:v>3.1989999999999998</c:v>
                </c:pt>
                <c:pt idx="21">
                  <c:v>3.2050000000000001</c:v>
                </c:pt>
                <c:pt idx="22">
                  <c:v>3.2109999999999999</c:v>
                </c:pt>
                <c:pt idx="23">
                  <c:v>3.2170000000000001</c:v>
                </c:pt>
                <c:pt idx="24">
                  <c:v>3.222</c:v>
                </c:pt>
                <c:pt idx="25">
                  <c:v>3.2280000000000002</c:v>
                </c:pt>
                <c:pt idx="26">
                  <c:v>3.234</c:v>
                </c:pt>
                <c:pt idx="27">
                  <c:v>3.2389999999999999</c:v>
                </c:pt>
                <c:pt idx="28">
                  <c:v>3.2450000000000001</c:v>
                </c:pt>
                <c:pt idx="29">
                  <c:v>3.2509999999999999</c:v>
                </c:pt>
                <c:pt idx="30">
                  <c:v>3.2570000000000001</c:v>
                </c:pt>
                <c:pt idx="31">
                  <c:v>3.262</c:v>
                </c:pt>
                <c:pt idx="32">
                  <c:v>3.2679999999999998</c:v>
                </c:pt>
                <c:pt idx="33">
                  <c:v>3.274</c:v>
                </c:pt>
                <c:pt idx="34">
                  <c:v>3.2789999999999999</c:v>
                </c:pt>
                <c:pt idx="35">
                  <c:v>3.2850000000000001</c:v>
                </c:pt>
                <c:pt idx="36">
                  <c:v>3.2909999999999999</c:v>
                </c:pt>
                <c:pt idx="37">
                  <c:v>3.2970000000000002</c:v>
                </c:pt>
                <c:pt idx="38">
                  <c:v>3.302</c:v>
                </c:pt>
                <c:pt idx="39">
                  <c:v>3.3079999999999998</c:v>
                </c:pt>
                <c:pt idx="40">
                  <c:v>3.3140000000000001</c:v>
                </c:pt>
                <c:pt idx="41">
                  <c:v>3.319</c:v>
                </c:pt>
                <c:pt idx="42">
                  <c:v>3.3250000000000002</c:v>
                </c:pt>
                <c:pt idx="43">
                  <c:v>3.331</c:v>
                </c:pt>
                <c:pt idx="44">
                  <c:v>3.3370000000000002</c:v>
                </c:pt>
                <c:pt idx="45">
                  <c:v>3.3420000000000001</c:v>
                </c:pt>
                <c:pt idx="46">
                  <c:v>3.3479999999999999</c:v>
                </c:pt>
                <c:pt idx="47">
                  <c:v>3.3540000000000001</c:v>
                </c:pt>
                <c:pt idx="48">
                  <c:v>3.359</c:v>
                </c:pt>
                <c:pt idx="49">
                  <c:v>3.3650000000000002</c:v>
                </c:pt>
                <c:pt idx="50">
                  <c:v>3.371</c:v>
                </c:pt>
                <c:pt idx="51">
                  <c:v>3.3769999999999998</c:v>
                </c:pt>
                <c:pt idx="52">
                  <c:v>3.3820000000000001</c:v>
                </c:pt>
                <c:pt idx="53">
                  <c:v>3.3879999999999999</c:v>
                </c:pt>
                <c:pt idx="54">
                  <c:v>3.3940000000000001</c:v>
                </c:pt>
                <c:pt idx="55">
                  <c:v>3.399</c:v>
                </c:pt>
                <c:pt idx="56">
                  <c:v>3.4049999999999998</c:v>
                </c:pt>
                <c:pt idx="57">
                  <c:v>3.411</c:v>
                </c:pt>
                <c:pt idx="58">
                  <c:v>3.4169999999999998</c:v>
                </c:pt>
                <c:pt idx="59">
                  <c:v>3.4220000000000002</c:v>
                </c:pt>
                <c:pt idx="60">
                  <c:v>3.4279999999999999</c:v>
                </c:pt>
                <c:pt idx="61">
                  <c:v>3.4340000000000002</c:v>
                </c:pt>
                <c:pt idx="62">
                  <c:v>3.4390000000000001</c:v>
                </c:pt>
                <c:pt idx="63">
                  <c:v>3.4449999999999998</c:v>
                </c:pt>
                <c:pt idx="64">
                  <c:v>3.4510000000000001</c:v>
                </c:pt>
                <c:pt idx="65">
                  <c:v>3.4569999999999999</c:v>
                </c:pt>
                <c:pt idx="66">
                  <c:v>3.4620000000000002</c:v>
                </c:pt>
                <c:pt idx="67">
                  <c:v>3.468</c:v>
                </c:pt>
                <c:pt idx="68">
                  <c:v>3.4740000000000002</c:v>
                </c:pt>
                <c:pt idx="69">
                  <c:v>3.4790000000000001</c:v>
                </c:pt>
                <c:pt idx="70">
                  <c:v>3.4849999999999999</c:v>
                </c:pt>
                <c:pt idx="71">
                  <c:v>3.4910000000000001</c:v>
                </c:pt>
                <c:pt idx="72">
                  <c:v>3.4969999999999999</c:v>
                </c:pt>
                <c:pt idx="73">
                  <c:v>3.5019999999999998</c:v>
                </c:pt>
                <c:pt idx="74">
                  <c:v>3.508</c:v>
                </c:pt>
                <c:pt idx="75">
                  <c:v>3.5139999999999998</c:v>
                </c:pt>
                <c:pt idx="76">
                  <c:v>3.5190000000000001</c:v>
                </c:pt>
                <c:pt idx="77">
                  <c:v>3.5249999999999999</c:v>
                </c:pt>
                <c:pt idx="78">
                  <c:v>3.5310000000000001</c:v>
                </c:pt>
                <c:pt idx="79">
                  <c:v>3.5369999999999999</c:v>
                </c:pt>
                <c:pt idx="80">
                  <c:v>3.5419999999999998</c:v>
                </c:pt>
                <c:pt idx="81">
                  <c:v>3.548</c:v>
                </c:pt>
                <c:pt idx="82">
                  <c:v>3.5539999999999998</c:v>
                </c:pt>
                <c:pt idx="83">
                  <c:v>3.5590000000000002</c:v>
                </c:pt>
                <c:pt idx="84">
                  <c:v>3.5649999999999999</c:v>
                </c:pt>
                <c:pt idx="85">
                  <c:v>3.5710000000000002</c:v>
                </c:pt>
                <c:pt idx="86">
                  <c:v>3.577</c:v>
                </c:pt>
                <c:pt idx="87">
                  <c:v>3.5819999999999999</c:v>
                </c:pt>
                <c:pt idx="88">
                  <c:v>3.5880000000000001</c:v>
                </c:pt>
                <c:pt idx="89">
                  <c:v>3.5939999999999999</c:v>
                </c:pt>
                <c:pt idx="90">
                  <c:v>3.5990000000000002</c:v>
                </c:pt>
                <c:pt idx="91">
                  <c:v>3.605</c:v>
                </c:pt>
                <c:pt idx="92">
                  <c:v>3.6110000000000002</c:v>
                </c:pt>
                <c:pt idx="93">
                  <c:v>3.617</c:v>
                </c:pt>
                <c:pt idx="94">
                  <c:v>3.6219999999999999</c:v>
                </c:pt>
                <c:pt idx="95">
                  <c:v>3.6280000000000001</c:v>
                </c:pt>
                <c:pt idx="96">
                  <c:v>3.6339999999999999</c:v>
                </c:pt>
                <c:pt idx="97">
                  <c:v>3.6389999999999998</c:v>
                </c:pt>
                <c:pt idx="98">
                  <c:v>3.645</c:v>
                </c:pt>
                <c:pt idx="99">
                  <c:v>3.6509999999999998</c:v>
                </c:pt>
                <c:pt idx="100">
                  <c:v>3.657</c:v>
                </c:pt>
                <c:pt idx="101">
                  <c:v>3.6619999999999999</c:v>
                </c:pt>
                <c:pt idx="102">
                  <c:v>3.6680000000000001</c:v>
                </c:pt>
                <c:pt idx="103">
                  <c:v>3.6739999999999999</c:v>
                </c:pt>
                <c:pt idx="104">
                  <c:v>3.6789999999999998</c:v>
                </c:pt>
                <c:pt idx="105">
                  <c:v>3.6850000000000001</c:v>
                </c:pt>
                <c:pt idx="106">
                  <c:v>3.6909999999999998</c:v>
                </c:pt>
                <c:pt idx="107">
                  <c:v>3.6970000000000001</c:v>
                </c:pt>
                <c:pt idx="108">
                  <c:v>3.702</c:v>
                </c:pt>
                <c:pt idx="109">
                  <c:v>3.7080000000000002</c:v>
                </c:pt>
                <c:pt idx="110">
                  <c:v>3.714</c:v>
                </c:pt>
                <c:pt idx="111">
                  <c:v>3.7189999999999999</c:v>
                </c:pt>
                <c:pt idx="112">
                  <c:v>3.7250000000000001</c:v>
                </c:pt>
                <c:pt idx="113">
                  <c:v>3.7309999999999999</c:v>
                </c:pt>
                <c:pt idx="114">
                  <c:v>3.7370000000000001</c:v>
                </c:pt>
                <c:pt idx="115">
                  <c:v>3.742</c:v>
                </c:pt>
                <c:pt idx="116">
                  <c:v>3.7480000000000002</c:v>
                </c:pt>
                <c:pt idx="117">
                  <c:v>3.754</c:v>
                </c:pt>
                <c:pt idx="118">
                  <c:v>3.7589999999999999</c:v>
                </c:pt>
                <c:pt idx="119">
                  <c:v>3.7650000000000001</c:v>
                </c:pt>
                <c:pt idx="120">
                  <c:v>3.7709999999999999</c:v>
                </c:pt>
                <c:pt idx="121">
                  <c:v>3.7770000000000001</c:v>
                </c:pt>
                <c:pt idx="122">
                  <c:v>3.782</c:v>
                </c:pt>
                <c:pt idx="123">
                  <c:v>3.7879999999999998</c:v>
                </c:pt>
                <c:pt idx="124">
                  <c:v>3.794</c:v>
                </c:pt>
                <c:pt idx="125">
                  <c:v>3.7989999999999999</c:v>
                </c:pt>
                <c:pt idx="126">
                  <c:v>3.8050000000000002</c:v>
                </c:pt>
                <c:pt idx="127">
                  <c:v>3.8109999999999999</c:v>
                </c:pt>
                <c:pt idx="128">
                  <c:v>3.8170000000000002</c:v>
                </c:pt>
                <c:pt idx="129">
                  <c:v>3.8220000000000001</c:v>
                </c:pt>
                <c:pt idx="130">
                  <c:v>3.8279999999999998</c:v>
                </c:pt>
                <c:pt idx="131">
                  <c:v>3.8340000000000001</c:v>
                </c:pt>
                <c:pt idx="132">
                  <c:v>3.84</c:v>
                </c:pt>
                <c:pt idx="133">
                  <c:v>3.8450000000000002</c:v>
                </c:pt>
                <c:pt idx="134">
                  <c:v>3.851</c:v>
                </c:pt>
                <c:pt idx="135">
                  <c:v>3.8570000000000002</c:v>
                </c:pt>
                <c:pt idx="136">
                  <c:v>3.8620000000000001</c:v>
                </c:pt>
                <c:pt idx="137">
                  <c:v>3.8679999999999999</c:v>
                </c:pt>
                <c:pt idx="138">
                  <c:v>3.8740000000000001</c:v>
                </c:pt>
                <c:pt idx="139">
                  <c:v>3.88</c:v>
                </c:pt>
                <c:pt idx="140">
                  <c:v>3.8849999999999998</c:v>
                </c:pt>
                <c:pt idx="141">
                  <c:v>3.891</c:v>
                </c:pt>
                <c:pt idx="142">
                  <c:v>3.8969999999999998</c:v>
                </c:pt>
                <c:pt idx="143">
                  <c:v>3.9020000000000001</c:v>
                </c:pt>
                <c:pt idx="144">
                  <c:v>3.9079999999999999</c:v>
                </c:pt>
                <c:pt idx="145">
                  <c:v>3.9140000000000001</c:v>
                </c:pt>
                <c:pt idx="146">
                  <c:v>3.92</c:v>
                </c:pt>
                <c:pt idx="147">
                  <c:v>3.9249999999999998</c:v>
                </c:pt>
                <c:pt idx="148">
                  <c:v>3.931</c:v>
                </c:pt>
                <c:pt idx="149">
                  <c:v>3.9369999999999998</c:v>
                </c:pt>
                <c:pt idx="150">
                  <c:v>3.9420000000000002</c:v>
                </c:pt>
                <c:pt idx="151">
                  <c:v>3.948</c:v>
                </c:pt>
                <c:pt idx="152">
                  <c:v>3.9540000000000002</c:v>
                </c:pt>
                <c:pt idx="153">
                  <c:v>3.96</c:v>
                </c:pt>
                <c:pt idx="154">
                  <c:v>3.9649999999999999</c:v>
                </c:pt>
                <c:pt idx="155">
                  <c:v>3.9710000000000001</c:v>
                </c:pt>
                <c:pt idx="156">
                  <c:v>3.9769999999999999</c:v>
                </c:pt>
                <c:pt idx="157">
                  <c:v>3.9820000000000002</c:v>
                </c:pt>
                <c:pt idx="158">
                  <c:v>3.988</c:v>
                </c:pt>
                <c:pt idx="159">
                  <c:v>3.9940000000000002</c:v>
                </c:pt>
                <c:pt idx="160">
                  <c:v>4</c:v>
                </c:pt>
                <c:pt idx="161">
                  <c:v>4.0049999999999999</c:v>
                </c:pt>
                <c:pt idx="162">
                  <c:v>4.0110000000000001</c:v>
                </c:pt>
                <c:pt idx="163">
                  <c:v>4.0170000000000003</c:v>
                </c:pt>
                <c:pt idx="164">
                  <c:v>4.0220000000000002</c:v>
                </c:pt>
                <c:pt idx="165">
                  <c:v>4.0279999999999996</c:v>
                </c:pt>
                <c:pt idx="166">
                  <c:v>4.0339999999999998</c:v>
                </c:pt>
                <c:pt idx="167">
                  <c:v>4.04</c:v>
                </c:pt>
                <c:pt idx="168">
                  <c:v>4.0449999999999999</c:v>
                </c:pt>
                <c:pt idx="169">
                  <c:v>4.0510000000000002</c:v>
                </c:pt>
                <c:pt idx="170">
                  <c:v>4.0570000000000004</c:v>
                </c:pt>
                <c:pt idx="171">
                  <c:v>4.0620000000000003</c:v>
                </c:pt>
                <c:pt idx="172">
                  <c:v>4.0679999999999996</c:v>
                </c:pt>
                <c:pt idx="173">
                  <c:v>4.0739999999999998</c:v>
                </c:pt>
                <c:pt idx="174">
                  <c:v>4.08</c:v>
                </c:pt>
                <c:pt idx="175">
                  <c:v>4.085</c:v>
                </c:pt>
                <c:pt idx="176">
                  <c:v>4.0910000000000002</c:v>
                </c:pt>
                <c:pt idx="177">
                  <c:v>4.0970000000000004</c:v>
                </c:pt>
                <c:pt idx="178">
                  <c:v>4.1020000000000003</c:v>
                </c:pt>
                <c:pt idx="179">
                  <c:v>4.1079999999999997</c:v>
                </c:pt>
                <c:pt idx="180">
                  <c:v>4.1139999999999999</c:v>
                </c:pt>
                <c:pt idx="181">
                  <c:v>4.12</c:v>
                </c:pt>
                <c:pt idx="182">
                  <c:v>4.125</c:v>
                </c:pt>
                <c:pt idx="183">
                  <c:v>4.1310000000000002</c:v>
                </c:pt>
                <c:pt idx="184">
                  <c:v>4.1369999999999996</c:v>
                </c:pt>
                <c:pt idx="185">
                  <c:v>4.1420000000000003</c:v>
                </c:pt>
                <c:pt idx="186">
                  <c:v>4.1479999999999997</c:v>
                </c:pt>
                <c:pt idx="187">
                  <c:v>4.1539999999999999</c:v>
                </c:pt>
                <c:pt idx="188">
                  <c:v>4.16</c:v>
                </c:pt>
                <c:pt idx="189">
                  <c:v>4.165</c:v>
                </c:pt>
                <c:pt idx="190">
                  <c:v>4.1710000000000003</c:v>
                </c:pt>
                <c:pt idx="191">
                  <c:v>4.1769999999999996</c:v>
                </c:pt>
                <c:pt idx="192">
                  <c:v>4.1820000000000004</c:v>
                </c:pt>
                <c:pt idx="193">
                  <c:v>4.1879999999999997</c:v>
                </c:pt>
                <c:pt idx="194">
                  <c:v>4.194</c:v>
                </c:pt>
                <c:pt idx="195">
                  <c:v>4.2</c:v>
                </c:pt>
                <c:pt idx="196">
                  <c:v>4.2050000000000001</c:v>
                </c:pt>
                <c:pt idx="197">
                  <c:v>4.2110000000000003</c:v>
                </c:pt>
                <c:pt idx="198">
                  <c:v>4.2169999999999996</c:v>
                </c:pt>
                <c:pt idx="199">
                  <c:v>4.2220000000000004</c:v>
                </c:pt>
                <c:pt idx="200">
                  <c:v>4.2279999999999998</c:v>
                </c:pt>
                <c:pt idx="201">
                  <c:v>4.234</c:v>
                </c:pt>
                <c:pt idx="202">
                  <c:v>4.24</c:v>
                </c:pt>
                <c:pt idx="203">
                  <c:v>4.2450000000000001</c:v>
                </c:pt>
                <c:pt idx="204">
                  <c:v>4.2510000000000003</c:v>
                </c:pt>
                <c:pt idx="205">
                  <c:v>4.2569999999999997</c:v>
                </c:pt>
                <c:pt idx="206">
                  <c:v>4.2619999999999996</c:v>
                </c:pt>
                <c:pt idx="207">
                  <c:v>4.2679999999999998</c:v>
                </c:pt>
                <c:pt idx="208">
                  <c:v>4.274</c:v>
                </c:pt>
                <c:pt idx="209">
                  <c:v>4.28</c:v>
                </c:pt>
                <c:pt idx="210">
                  <c:v>4.2850000000000001</c:v>
                </c:pt>
                <c:pt idx="211">
                  <c:v>4.2910000000000004</c:v>
                </c:pt>
                <c:pt idx="212">
                  <c:v>4.2969999999999997</c:v>
                </c:pt>
                <c:pt idx="213">
                  <c:v>4.3019999999999996</c:v>
                </c:pt>
                <c:pt idx="214">
                  <c:v>4.3079999999999998</c:v>
                </c:pt>
                <c:pt idx="215">
                  <c:v>4.3140000000000001</c:v>
                </c:pt>
                <c:pt idx="216">
                  <c:v>4.32</c:v>
                </c:pt>
                <c:pt idx="217">
                  <c:v>4.3250000000000002</c:v>
                </c:pt>
                <c:pt idx="218">
                  <c:v>4.3310000000000004</c:v>
                </c:pt>
                <c:pt idx="219">
                  <c:v>4.3369999999999997</c:v>
                </c:pt>
                <c:pt idx="220">
                  <c:v>4.3419999999999996</c:v>
                </c:pt>
                <c:pt idx="221">
                  <c:v>4.3479999999999999</c:v>
                </c:pt>
                <c:pt idx="222">
                  <c:v>4.3540000000000001</c:v>
                </c:pt>
                <c:pt idx="223">
                  <c:v>4.3600000000000003</c:v>
                </c:pt>
                <c:pt idx="224">
                  <c:v>4.3650000000000002</c:v>
                </c:pt>
                <c:pt idx="225">
                  <c:v>4.3710000000000004</c:v>
                </c:pt>
                <c:pt idx="226">
                  <c:v>4.3769999999999998</c:v>
                </c:pt>
                <c:pt idx="227">
                  <c:v>4.3819999999999997</c:v>
                </c:pt>
                <c:pt idx="228">
                  <c:v>4.3879999999999999</c:v>
                </c:pt>
                <c:pt idx="229">
                  <c:v>4.3940000000000001</c:v>
                </c:pt>
                <c:pt idx="230">
                  <c:v>4.4000000000000004</c:v>
                </c:pt>
                <c:pt idx="231">
                  <c:v>4.4050000000000002</c:v>
                </c:pt>
                <c:pt idx="232">
                  <c:v>4.4109999999999996</c:v>
                </c:pt>
                <c:pt idx="233">
                  <c:v>4.4169999999999998</c:v>
                </c:pt>
                <c:pt idx="234">
                  <c:v>4.4219999999999997</c:v>
                </c:pt>
                <c:pt idx="235">
                  <c:v>4.4279999999999999</c:v>
                </c:pt>
                <c:pt idx="236">
                  <c:v>4.4340000000000002</c:v>
                </c:pt>
                <c:pt idx="237">
                  <c:v>4.4400000000000004</c:v>
                </c:pt>
                <c:pt idx="238">
                  <c:v>4.4450000000000003</c:v>
                </c:pt>
                <c:pt idx="239">
                  <c:v>4.4509999999999996</c:v>
                </c:pt>
                <c:pt idx="240">
                  <c:v>4.4569999999999999</c:v>
                </c:pt>
                <c:pt idx="241">
                  <c:v>4.4619999999999997</c:v>
                </c:pt>
                <c:pt idx="242">
                  <c:v>4.468</c:v>
                </c:pt>
                <c:pt idx="243">
                  <c:v>4.4740000000000002</c:v>
                </c:pt>
                <c:pt idx="244">
                  <c:v>4.4800000000000004</c:v>
                </c:pt>
                <c:pt idx="245">
                  <c:v>4.4850000000000003</c:v>
                </c:pt>
                <c:pt idx="246">
                  <c:v>4.4909999999999997</c:v>
                </c:pt>
                <c:pt idx="247">
                  <c:v>4.4969999999999999</c:v>
                </c:pt>
                <c:pt idx="248">
                  <c:v>4.5019999999999998</c:v>
                </c:pt>
                <c:pt idx="249">
                  <c:v>4.508</c:v>
                </c:pt>
                <c:pt idx="250">
                  <c:v>4.5140000000000002</c:v>
                </c:pt>
                <c:pt idx="251">
                  <c:v>4.5199999999999996</c:v>
                </c:pt>
                <c:pt idx="252">
                  <c:v>4.5250000000000004</c:v>
                </c:pt>
                <c:pt idx="253">
                  <c:v>4.5309999999999997</c:v>
                </c:pt>
                <c:pt idx="254">
                  <c:v>4.5369999999999999</c:v>
                </c:pt>
                <c:pt idx="255">
                  <c:v>4.5419999999999998</c:v>
                </c:pt>
                <c:pt idx="256">
                  <c:v>4.548</c:v>
                </c:pt>
                <c:pt idx="257">
                  <c:v>4.5540000000000003</c:v>
                </c:pt>
                <c:pt idx="258">
                  <c:v>4.5599999999999996</c:v>
                </c:pt>
                <c:pt idx="259">
                  <c:v>4.5650000000000004</c:v>
                </c:pt>
                <c:pt idx="260">
                  <c:v>4.5709999999999997</c:v>
                </c:pt>
                <c:pt idx="261">
                  <c:v>4.577</c:v>
                </c:pt>
                <c:pt idx="262">
                  <c:v>4.5819999999999999</c:v>
                </c:pt>
                <c:pt idx="263">
                  <c:v>4.5880000000000001</c:v>
                </c:pt>
                <c:pt idx="264">
                  <c:v>4.5940000000000003</c:v>
                </c:pt>
                <c:pt idx="265">
                  <c:v>4.5999999999999996</c:v>
                </c:pt>
                <c:pt idx="266">
                  <c:v>4.6050000000000004</c:v>
                </c:pt>
                <c:pt idx="267">
                  <c:v>4.6109999999999998</c:v>
                </c:pt>
                <c:pt idx="268">
                  <c:v>4.617</c:v>
                </c:pt>
                <c:pt idx="269">
                  <c:v>4.6219999999999999</c:v>
                </c:pt>
                <c:pt idx="270">
                  <c:v>4.6280000000000001</c:v>
                </c:pt>
                <c:pt idx="271">
                  <c:v>4.6340000000000003</c:v>
                </c:pt>
                <c:pt idx="272">
                  <c:v>4.6399999999999997</c:v>
                </c:pt>
                <c:pt idx="273">
                  <c:v>4.6449999999999996</c:v>
                </c:pt>
                <c:pt idx="274">
                  <c:v>4.6509999999999998</c:v>
                </c:pt>
                <c:pt idx="275">
                  <c:v>4.657</c:v>
                </c:pt>
                <c:pt idx="276">
                  <c:v>4.6630000000000003</c:v>
                </c:pt>
                <c:pt idx="277">
                  <c:v>4.6680000000000001</c:v>
                </c:pt>
                <c:pt idx="278">
                  <c:v>4.6740000000000004</c:v>
                </c:pt>
                <c:pt idx="279">
                  <c:v>4.68</c:v>
                </c:pt>
                <c:pt idx="280">
                  <c:v>4.6849999999999996</c:v>
                </c:pt>
                <c:pt idx="281">
                  <c:v>4.6909999999999998</c:v>
                </c:pt>
                <c:pt idx="282">
                  <c:v>4.6970000000000001</c:v>
                </c:pt>
                <c:pt idx="283">
                  <c:v>4.7030000000000003</c:v>
                </c:pt>
                <c:pt idx="284">
                  <c:v>4.7080000000000002</c:v>
                </c:pt>
                <c:pt idx="285">
                  <c:v>4.7140000000000004</c:v>
                </c:pt>
                <c:pt idx="286">
                  <c:v>4.72</c:v>
                </c:pt>
                <c:pt idx="287">
                  <c:v>4.7249999999999996</c:v>
                </c:pt>
                <c:pt idx="288">
                  <c:v>4.7309999999999999</c:v>
                </c:pt>
                <c:pt idx="289">
                  <c:v>4.7370000000000001</c:v>
                </c:pt>
                <c:pt idx="290">
                  <c:v>4.7430000000000003</c:v>
                </c:pt>
                <c:pt idx="291">
                  <c:v>4.7480000000000002</c:v>
                </c:pt>
                <c:pt idx="292">
                  <c:v>4.7539999999999996</c:v>
                </c:pt>
                <c:pt idx="293">
                  <c:v>4.76</c:v>
                </c:pt>
                <c:pt idx="294">
                  <c:v>4.7649999999999997</c:v>
                </c:pt>
                <c:pt idx="295">
                  <c:v>4.7709999999999999</c:v>
                </c:pt>
                <c:pt idx="296">
                  <c:v>4.7770000000000001</c:v>
                </c:pt>
                <c:pt idx="297">
                  <c:v>4.7830000000000004</c:v>
                </c:pt>
                <c:pt idx="298">
                  <c:v>4.7880000000000003</c:v>
                </c:pt>
                <c:pt idx="299">
                  <c:v>4.7939999999999996</c:v>
                </c:pt>
                <c:pt idx="300">
                  <c:v>4.8</c:v>
                </c:pt>
                <c:pt idx="301">
                  <c:v>4.8049999999999997</c:v>
                </c:pt>
                <c:pt idx="302">
                  <c:v>4.8109999999999999</c:v>
                </c:pt>
                <c:pt idx="303">
                  <c:v>4.8170000000000002</c:v>
                </c:pt>
                <c:pt idx="304">
                  <c:v>4.8230000000000004</c:v>
                </c:pt>
                <c:pt idx="305">
                  <c:v>4.8280000000000003</c:v>
                </c:pt>
                <c:pt idx="306">
                  <c:v>4.8339999999999996</c:v>
                </c:pt>
                <c:pt idx="307">
                  <c:v>4.84</c:v>
                </c:pt>
                <c:pt idx="308">
                  <c:v>4.8449999999999998</c:v>
                </c:pt>
                <c:pt idx="309">
                  <c:v>4.851</c:v>
                </c:pt>
                <c:pt idx="310">
                  <c:v>4.8570000000000002</c:v>
                </c:pt>
                <c:pt idx="311">
                  <c:v>4.8630000000000004</c:v>
                </c:pt>
                <c:pt idx="312">
                  <c:v>4.8680000000000003</c:v>
                </c:pt>
                <c:pt idx="313">
                  <c:v>4.8739999999999997</c:v>
                </c:pt>
                <c:pt idx="314">
                  <c:v>4.88</c:v>
                </c:pt>
                <c:pt idx="315">
                  <c:v>4.8849999999999998</c:v>
                </c:pt>
                <c:pt idx="316">
                  <c:v>4.891</c:v>
                </c:pt>
                <c:pt idx="317">
                  <c:v>4.8970000000000002</c:v>
                </c:pt>
                <c:pt idx="318">
                  <c:v>4.9029999999999996</c:v>
                </c:pt>
                <c:pt idx="319">
                  <c:v>4.9080000000000004</c:v>
                </c:pt>
                <c:pt idx="320">
                  <c:v>4.9139999999999997</c:v>
                </c:pt>
                <c:pt idx="321">
                  <c:v>4.92</c:v>
                </c:pt>
                <c:pt idx="322">
                  <c:v>4.9249999999999998</c:v>
                </c:pt>
                <c:pt idx="323">
                  <c:v>4.931</c:v>
                </c:pt>
                <c:pt idx="324">
                  <c:v>4.9370000000000003</c:v>
                </c:pt>
                <c:pt idx="325">
                  <c:v>4.9429999999999996</c:v>
                </c:pt>
                <c:pt idx="326">
                  <c:v>4.9480000000000004</c:v>
                </c:pt>
                <c:pt idx="327">
                  <c:v>4.9539999999999997</c:v>
                </c:pt>
                <c:pt idx="328">
                  <c:v>4.96</c:v>
                </c:pt>
                <c:pt idx="329">
                  <c:v>4.9649999999999999</c:v>
                </c:pt>
                <c:pt idx="330">
                  <c:v>4.9710000000000001</c:v>
                </c:pt>
                <c:pt idx="331">
                  <c:v>4.9770000000000003</c:v>
                </c:pt>
                <c:pt idx="332">
                  <c:v>4.9829999999999997</c:v>
                </c:pt>
                <c:pt idx="333">
                  <c:v>4.9880000000000004</c:v>
                </c:pt>
                <c:pt idx="334">
                  <c:v>4.9939999999999998</c:v>
                </c:pt>
                <c:pt idx="335">
                  <c:v>5</c:v>
                </c:pt>
                <c:pt idx="336">
                  <c:v>5.0049999999999999</c:v>
                </c:pt>
                <c:pt idx="337">
                  <c:v>5.0110000000000001</c:v>
                </c:pt>
                <c:pt idx="338">
                  <c:v>5.0170000000000003</c:v>
                </c:pt>
                <c:pt idx="339">
                  <c:v>5.0229999999999997</c:v>
                </c:pt>
                <c:pt idx="340">
                  <c:v>5.0279999999999996</c:v>
                </c:pt>
                <c:pt idx="341">
                  <c:v>5.0339999999999998</c:v>
                </c:pt>
                <c:pt idx="342">
                  <c:v>5.04</c:v>
                </c:pt>
                <c:pt idx="343">
                  <c:v>5.0449999999999999</c:v>
                </c:pt>
                <c:pt idx="344">
                  <c:v>5.0510000000000002</c:v>
                </c:pt>
                <c:pt idx="345">
                  <c:v>5.0570000000000004</c:v>
                </c:pt>
                <c:pt idx="346">
                  <c:v>5.0629999999999997</c:v>
                </c:pt>
                <c:pt idx="347">
                  <c:v>5.0679999999999996</c:v>
                </c:pt>
                <c:pt idx="348">
                  <c:v>5.0739999999999998</c:v>
                </c:pt>
                <c:pt idx="349">
                  <c:v>5.08</c:v>
                </c:pt>
                <c:pt idx="350">
                  <c:v>5.085</c:v>
                </c:pt>
                <c:pt idx="351">
                  <c:v>5.0910000000000002</c:v>
                </c:pt>
                <c:pt idx="352">
                  <c:v>5.0970000000000004</c:v>
                </c:pt>
                <c:pt idx="353">
                  <c:v>5.1029999999999998</c:v>
                </c:pt>
                <c:pt idx="354">
                  <c:v>5.1079999999999997</c:v>
                </c:pt>
                <c:pt idx="355">
                  <c:v>5.1139999999999999</c:v>
                </c:pt>
                <c:pt idx="356">
                  <c:v>5.12</c:v>
                </c:pt>
                <c:pt idx="357">
                  <c:v>5.125</c:v>
                </c:pt>
                <c:pt idx="358">
                  <c:v>5.1310000000000002</c:v>
                </c:pt>
                <c:pt idx="359">
                  <c:v>5.1369999999999996</c:v>
                </c:pt>
                <c:pt idx="360">
                  <c:v>5.1429999999999998</c:v>
                </c:pt>
                <c:pt idx="361">
                  <c:v>5.1479999999999997</c:v>
                </c:pt>
                <c:pt idx="362">
                  <c:v>5.1539999999999999</c:v>
                </c:pt>
                <c:pt idx="363">
                  <c:v>5.16</c:v>
                </c:pt>
                <c:pt idx="364">
                  <c:v>5.165</c:v>
                </c:pt>
                <c:pt idx="365">
                  <c:v>5.1710000000000003</c:v>
                </c:pt>
                <c:pt idx="366">
                  <c:v>5.1769999999999996</c:v>
                </c:pt>
                <c:pt idx="367">
                  <c:v>5.1829999999999998</c:v>
                </c:pt>
                <c:pt idx="368">
                  <c:v>5.1879999999999997</c:v>
                </c:pt>
                <c:pt idx="369">
                  <c:v>5.194</c:v>
                </c:pt>
                <c:pt idx="370">
                  <c:v>5.2</c:v>
                </c:pt>
                <c:pt idx="371">
                  <c:v>5.2050000000000001</c:v>
                </c:pt>
                <c:pt idx="372">
                  <c:v>5.2110000000000003</c:v>
                </c:pt>
                <c:pt idx="373">
                  <c:v>5.2169999999999996</c:v>
                </c:pt>
                <c:pt idx="374">
                  <c:v>5.2229999999999999</c:v>
                </c:pt>
                <c:pt idx="375">
                  <c:v>5.2279999999999998</c:v>
                </c:pt>
                <c:pt idx="376">
                  <c:v>5.234</c:v>
                </c:pt>
                <c:pt idx="377">
                  <c:v>5.24</c:v>
                </c:pt>
                <c:pt idx="378">
                  <c:v>5.2450000000000001</c:v>
                </c:pt>
                <c:pt idx="379">
                  <c:v>5.2510000000000003</c:v>
                </c:pt>
                <c:pt idx="380">
                  <c:v>5.2569999999999997</c:v>
                </c:pt>
                <c:pt idx="381">
                  <c:v>5.2629999999999999</c:v>
                </c:pt>
                <c:pt idx="382">
                  <c:v>5.2679999999999998</c:v>
                </c:pt>
                <c:pt idx="383">
                  <c:v>5.274</c:v>
                </c:pt>
                <c:pt idx="384">
                  <c:v>5.28</c:v>
                </c:pt>
                <c:pt idx="385">
                  <c:v>5.2850000000000001</c:v>
                </c:pt>
                <c:pt idx="386">
                  <c:v>5.2910000000000004</c:v>
                </c:pt>
                <c:pt idx="387">
                  <c:v>5.2969999999999997</c:v>
                </c:pt>
                <c:pt idx="388">
                  <c:v>5.3029999999999999</c:v>
                </c:pt>
                <c:pt idx="389">
                  <c:v>5.3079999999999998</c:v>
                </c:pt>
                <c:pt idx="390">
                  <c:v>5.3140000000000001</c:v>
                </c:pt>
                <c:pt idx="391">
                  <c:v>5.32</c:v>
                </c:pt>
                <c:pt idx="392">
                  <c:v>5.3250000000000002</c:v>
                </c:pt>
                <c:pt idx="393">
                  <c:v>5.3310000000000004</c:v>
                </c:pt>
                <c:pt idx="394">
                  <c:v>5.3369999999999997</c:v>
                </c:pt>
                <c:pt idx="395">
                  <c:v>5.343</c:v>
                </c:pt>
                <c:pt idx="396">
                  <c:v>5.3479999999999999</c:v>
                </c:pt>
                <c:pt idx="397">
                  <c:v>5.3540000000000001</c:v>
                </c:pt>
                <c:pt idx="398">
                  <c:v>5.36</c:v>
                </c:pt>
                <c:pt idx="399">
                  <c:v>5.3650000000000002</c:v>
                </c:pt>
                <c:pt idx="400">
                  <c:v>5.3710000000000004</c:v>
                </c:pt>
                <c:pt idx="401">
                  <c:v>5.3769999999999998</c:v>
                </c:pt>
                <c:pt idx="402">
                  <c:v>5.383</c:v>
                </c:pt>
                <c:pt idx="403">
                  <c:v>5.3879999999999999</c:v>
                </c:pt>
                <c:pt idx="404">
                  <c:v>5.3940000000000001</c:v>
                </c:pt>
                <c:pt idx="405">
                  <c:v>5.4</c:v>
                </c:pt>
                <c:pt idx="406">
                  <c:v>5.4050000000000002</c:v>
                </c:pt>
                <c:pt idx="407">
                  <c:v>5.4109999999999996</c:v>
                </c:pt>
                <c:pt idx="408">
                  <c:v>5.4169999999999998</c:v>
                </c:pt>
                <c:pt idx="409">
                  <c:v>5.423</c:v>
                </c:pt>
                <c:pt idx="410">
                  <c:v>5.4279999999999999</c:v>
                </c:pt>
                <c:pt idx="411">
                  <c:v>5.4340000000000002</c:v>
                </c:pt>
                <c:pt idx="412">
                  <c:v>5.44</c:v>
                </c:pt>
                <c:pt idx="413">
                  <c:v>5.4459999999999997</c:v>
                </c:pt>
                <c:pt idx="414">
                  <c:v>5.4509999999999996</c:v>
                </c:pt>
                <c:pt idx="415">
                  <c:v>5.4569999999999999</c:v>
                </c:pt>
                <c:pt idx="416">
                  <c:v>5.4630000000000001</c:v>
                </c:pt>
                <c:pt idx="417">
                  <c:v>5.468</c:v>
                </c:pt>
                <c:pt idx="418">
                  <c:v>5.4740000000000002</c:v>
                </c:pt>
                <c:pt idx="419">
                  <c:v>5.48</c:v>
                </c:pt>
                <c:pt idx="420">
                  <c:v>5.4859999999999998</c:v>
                </c:pt>
                <c:pt idx="421">
                  <c:v>5.4909999999999997</c:v>
                </c:pt>
                <c:pt idx="422">
                  <c:v>5.4969999999999999</c:v>
                </c:pt>
                <c:pt idx="423">
                  <c:v>5.5030000000000001</c:v>
                </c:pt>
                <c:pt idx="424">
                  <c:v>5.508</c:v>
                </c:pt>
                <c:pt idx="425">
                  <c:v>5.5140000000000002</c:v>
                </c:pt>
                <c:pt idx="426">
                  <c:v>5.52</c:v>
                </c:pt>
                <c:pt idx="427">
                  <c:v>5.5259999999999998</c:v>
                </c:pt>
                <c:pt idx="428">
                  <c:v>5.5309999999999997</c:v>
                </c:pt>
                <c:pt idx="429">
                  <c:v>5.5369999999999999</c:v>
                </c:pt>
                <c:pt idx="430">
                  <c:v>5.5430000000000001</c:v>
                </c:pt>
                <c:pt idx="431">
                  <c:v>5.548</c:v>
                </c:pt>
                <c:pt idx="432">
                  <c:v>5.5540000000000003</c:v>
                </c:pt>
                <c:pt idx="433">
                  <c:v>5.56</c:v>
                </c:pt>
                <c:pt idx="434">
                  <c:v>5.5659999999999998</c:v>
                </c:pt>
                <c:pt idx="435">
                  <c:v>5.5709999999999997</c:v>
                </c:pt>
                <c:pt idx="436">
                  <c:v>5.577</c:v>
                </c:pt>
                <c:pt idx="437">
                  <c:v>5.5830000000000002</c:v>
                </c:pt>
                <c:pt idx="438">
                  <c:v>5.5880000000000001</c:v>
                </c:pt>
                <c:pt idx="439">
                  <c:v>5.5940000000000003</c:v>
                </c:pt>
                <c:pt idx="440">
                  <c:v>5.6</c:v>
                </c:pt>
                <c:pt idx="441">
                  <c:v>5.6059999999999999</c:v>
                </c:pt>
                <c:pt idx="442">
                  <c:v>5.6109999999999998</c:v>
                </c:pt>
                <c:pt idx="443">
                  <c:v>5.617</c:v>
                </c:pt>
                <c:pt idx="444">
                  <c:v>5.6230000000000002</c:v>
                </c:pt>
                <c:pt idx="445">
                  <c:v>5.6280000000000001</c:v>
                </c:pt>
                <c:pt idx="446">
                  <c:v>5.6340000000000003</c:v>
                </c:pt>
                <c:pt idx="447">
                  <c:v>5.64</c:v>
                </c:pt>
                <c:pt idx="448">
                  <c:v>5.6459999999999999</c:v>
                </c:pt>
                <c:pt idx="449">
                  <c:v>5.6509999999999998</c:v>
                </c:pt>
                <c:pt idx="450">
                  <c:v>5.657</c:v>
                </c:pt>
                <c:pt idx="451">
                  <c:v>5.6630000000000003</c:v>
                </c:pt>
                <c:pt idx="452">
                  <c:v>5.6680000000000001</c:v>
                </c:pt>
                <c:pt idx="453">
                  <c:v>5.6740000000000004</c:v>
                </c:pt>
                <c:pt idx="454">
                  <c:v>5.68</c:v>
                </c:pt>
                <c:pt idx="455">
                  <c:v>5.6859999999999999</c:v>
                </c:pt>
                <c:pt idx="456">
                  <c:v>5.6909999999999998</c:v>
                </c:pt>
                <c:pt idx="457">
                  <c:v>5.6970000000000001</c:v>
                </c:pt>
                <c:pt idx="458">
                  <c:v>5.7030000000000003</c:v>
                </c:pt>
                <c:pt idx="459">
                  <c:v>5.7080000000000002</c:v>
                </c:pt>
                <c:pt idx="460">
                  <c:v>5.7140000000000004</c:v>
                </c:pt>
                <c:pt idx="461">
                  <c:v>5.72</c:v>
                </c:pt>
                <c:pt idx="462">
                  <c:v>5.726</c:v>
                </c:pt>
                <c:pt idx="463">
                  <c:v>5.7309999999999999</c:v>
                </c:pt>
                <c:pt idx="464">
                  <c:v>5.7370000000000001</c:v>
                </c:pt>
                <c:pt idx="465">
                  <c:v>5.7430000000000003</c:v>
                </c:pt>
                <c:pt idx="466">
                  <c:v>5.7480000000000002</c:v>
                </c:pt>
                <c:pt idx="467">
                  <c:v>5.7539999999999996</c:v>
                </c:pt>
                <c:pt idx="468">
                  <c:v>5.76</c:v>
                </c:pt>
                <c:pt idx="469">
                  <c:v>5.766</c:v>
                </c:pt>
                <c:pt idx="470">
                  <c:v>5.7709999999999999</c:v>
                </c:pt>
                <c:pt idx="471">
                  <c:v>5.7770000000000001</c:v>
                </c:pt>
                <c:pt idx="472">
                  <c:v>5.7830000000000004</c:v>
                </c:pt>
                <c:pt idx="473">
                  <c:v>5.7880000000000003</c:v>
                </c:pt>
                <c:pt idx="474">
                  <c:v>5.7939999999999996</c:v>
                </c:pt>
                <c:pt idx="475">
                  <c:v>5.8</c:v>
                </c:pt>
                <c:pt idx="476">
                  <c:v>5.806</c:v>
                </c:pt>
                <c:pt idx="477">
                  <c:v>5.8109999999999999</c:v>
                </c:pt>
                <c:pt idx="478">
                  <c:v>5.8170000000000002</c:v>
                </c:pt>
                <c:pt idx="479">
                  <c:v>5.8230000000000004</c:v>
                </c:pt>
                <c:pt idx="480">
                  <c:v>5.8280000000000003</c:v>
                </c:pt>
                <c:pt idx="481">
                  <c:v>5.8339999999999996</c:v>
                </c:pt>
                <c:pt idx="482">
                  <c:v>5.84</c:v>
                </c:pt>
                <c:pt idx="483">
                  <c:v>5.8460000000000001</c:v>
                </c:pt>
                <c:pt idx="484">
                  <c:v>5.851</c:v>
                </c:pt>
                <c:pt idx="485">
                  <c:v>5.8570000000000002</c:v>
                </c:pt>
                <c:pt idx="486">
                  <c:v>5.8630000000000004</c:v>
                </c:pt>
                <c:pt idx="487">
                  <c:v>5.8680000000000003</c:v>
                </c:pt>
                <c:pt idx="488">
                  <c:v>5.8739999999999997</c:v>
                </c:pt>
                <c:pt idx="489">
                  <c:v>5.88</c:v>
                </c:pt>
                <c:pt idx="490">
                  <c:v>5.8860000000000001</c:v>
                </c:pt>
                <c:pt idx="491">
                  <c:v>5.891</c:v>
                </c:pt>
                <c:pt idx="492">
                  <c:v>5.8970000000000002</c:v>
                </c:pt>
                <c:pt idx="493">
                  <c:v>5.9029999999999996</c:v>
                </c:pt>
                <c:pt idx="494">
                  <c:v>5.9080000000000004</c:v>
                </c:pt>
                <c:pt idx="495">
                  <c:v>5.9139999999999997</c:v>
                </c:pt>
                <c:pt idx="496">
                  <c:v>5.92</c:v>
                </c:pt>
                <c:pt idx="497">
                  <c:v>5.9260000000000002</c:v>
                </c:pt>
                <c:pt idx="498">
                  <c:v>5.931</c:v>
                </c:pt>
                <c:pt idx="499">
                  <c:v>5.9370000000000003</c:v>
                </c:pt>
                <c:pt idx="500">
                  <c:v>5.9429999999999996</c:v>
                </c:pt>
                <c:pt idx="501">
                  <c:v>5.9480000000000004</c:v>
                </c:pt>
                <c:pt idx="502">
                  <c:v>5.9539999999999997</c:v>
                </c:pt>
                <c:pt idx="503">
                  <c:v>5.96</c:v>
                </c:pt>
                <c:pt idx="504">
                  <c:v>5.9660000000000002</c:v>
                </c:pt>
                <c:pt idx="505">
                  <c:v>5.9710000000000001</c:v>
                </c:pt>
                <c:pt idx="506">
                  <c:v>5.9770000000000003</c:v>
                </c:pt>
                <c:pt idx="507">
                  <c:v>5.9829999999999997</c:v>
                </c:pt>
                <c:pt idx="508">
                  <c:v>5.9880000000000004</c:v>
                </c:pt>
                <c:pt idx="509">
                  <c:v>5.9939999999999998</c:v>
                </c:pt>
                <c:pt idx="510">
                  <c:v>6</c:v>
                </c:pt>
                <c:pt idx="511">
                  <c:v>6.0060000000000002</c:v>
                </c:pt>
                <c:pt idx="512">
                  <c:v>6.0110000000000001</c:v>
                </c:pt>
                <c:pt idx="513">
                  <c:v>6.0170000000000003</c:v>
                </c:pt>
                <c:pt idx="514">
                  <c:v>6.0229999999999997</c:v>
                </c:pt>
                <c:pt idx="515">
                  <c:v>6.0279999999999996</c:v>
                </c:pt>
                <c:pt idx="516">
                  <c:v>6.0339999999999998</c:v>
                </c:pt>
                <c:pt idx="517">
                  <c:v>6.04</c:v>
                </c:pt>
                <c:pt idx="518">
                  <c:v>6.0460000000000003</c:v>
                </c:pt>
                <c:pt idx="519">
                  <c:v>6.0510000000000002</c:v>
                </c:pt>
                <c:pt idx="520">
                  <c:v>6.0570000000000004</c:v>
                </c:pt>
                <c:pt idx="521">
                  <c:v>6.0629999999999997</c:v>
                </c:pt>
                <c:pt idx="522">
                  <c:v>6.0679999999999996</c:v>
                </c:pt>
                <c:pt idx="523">
                  <c:v>6.0739999999999998</c:v>
                </c:pt>
                <c:pt idx="524">
                  <c:v>6.08</c:v>
                </c:pt>
                <c:pt idx="525">
                  <c:v>6.0860000000000003</c:v>
                </c:pt>
                <c:pt idx="526">
                  <c:v>6.0910000000000002</c:v>
                </c:pt>
                <c:pt idx="527">
                  <c:v>6.0970000000000004</c:v>
                </c:pt>
                <c:pt idx="528">
                  <c:v>6.1029999999999998</c:v>
                </c:pt>
                <c:pt idx="529">
                  <c:v>6.1079999999999997</c:v>
                </c:pt>
                <c:pt idx="530">
                  <c:v>6.1139999999999999</c:v>
                </c:pt>
                <c:pt idx="531">
                  <c:v>6.12</c:v>
                </c:pt>
                <c:pt idx="532">
                  <c:v>6.1260000000000003</c:v>
                </c:pt>
                <c:pt idx="533">
                  <c:v>6.1310000000000002</c:v>
                </c:pt>
                <c:pt idx="534">
                  <c:v>6.1369999999999996</c:v>
                </c:pt>
                <c:pt idx="535">
                  <c:v>6.1429999999999998</c:v>
                </c:pt>
                <c:pt idx="536">
                  <c:v>6.1479999999999997</c:v>
                </c:pt>
                <c:pt idx="537">
                  <c:v>6.1539999999999999</c:v>
                </c:pt>
                <c:pt idx="538">
                  <c:v>6.16</c:v>
                </c:pt>
                <c:pt idx="539">
                  <c:v>6.1660000000000004</c:v>
                </c:pt>
                <c:pt idx="540">
                  <c:v>6.1710000000000003</c:v>
                </c:pt>
                <c:pt idx="541">
                  <c:v>6.1769999999999996</c:v>
                </c:pt>
                <c:pt idx="542">
                  <c:v>6.1829999999999998</c:v>
                </c:pt>
                <c:pt idx="543">
                  <c:v>6.1879999999999997</c:v>
                </c:pt>
                <c:pt idx="544">
                  <c:v>6.194</c:v>
                </c:pt>
                <c:pt idx="545">
                  <c:v>6.2</c:v>
                </c:pt>
                <c:pt idx="546">
                  <c:v>6.2060000000000004</c:v>
                </c:pt>
                <c:pt idx="547">
                  <c:v>6.2110000000000003</c:v>
                </c:pt>
                <c:pt idx="548">
                  <c:v>6.2169999999999996</c:v>
                </c:pt>
                <c:pt idx="549">
                  <c:v>6.2229999999999999</c:v>
                </c:pt>
                <c:pt idx="550">
                  <c:v>6.2290000000000001</c:v>
                </c:pt>
                <c:pt idx="551">
                  <c:v>6.234</c:v>
                </c:pt>
                <c:pt idx="552">
                  <c:v>6.24</c:v>
                </c:pt>
                <c:pt idx="553">
                  <c:v>6.2460000000000004</c:v>
                </c:pt>
                <c:pt idx="554">
                  <c:v>6.2510000000000003</c:v>
                </c:pt>
                <c:pt idx="555">
                  <c:v>6.2569999999999997</c:v>
                </c:pt>
                <c:pt idx="556">
                  <c:v>6.2629999999999999</c:v>
                </c:pt>
                <c:pt idx="557">
                  <c:v>6.2690000000000001</c:v>
                </c:pt>
                <c:pt idx="558">
                  <c:v>6.274</c:v>
                </c:pt>
                <c:pt idx="559">
                  <c:v>6.28</c:v>
                </c:pt>
                <c:pt idx="560">
                  <c:v>6.2859999999999996</c:v>
                </c:pt>
                <c:pt idx="561">
                  <c:v>6.2910000000000004</c:v>
                </c:pt>
                <c:pt idx="562">
                  <c:v>6.2969999999999997</c:v>
                </c:pt>
                <c:pt idx="563">
                  <c:v>6.3029999999999999</c:v>
                </c:pt>
                <c:pt idx="564">
                  <c:v>6.3090000000000002</c:v>
                </c:pt>
                <c:pt idx="565">
                  <c:v>6.3140000000000001</c:v>
                </c:pt>
                <c:pt idx="566">
                  <c:v>6.32</c:v>
                </c:pt>
                <c:pt idx="567">
                  <c:v>6.3259999999999996</c:v>
                </c:pt>
                <c:pt idx="568">
                  <c:v>6.3310000000000004</c:v>
                </c:pt>
                <c:pt idx="569">
                  <c:v>6.3369999999999997</c:v>
                </c:pt>
                <c:pt idx="570">
                  <c:v>6.343</c:v>
                </c:pt>
                <c:pt idx="571">
                  <c:v>6.3490000000000002</c:v>
                </c:pt>
                <c:pt idx="572">
                  <c:v>6.3540000000000001</c:v>
                </c:pt>
                <c:pt idx="573">
                  <c:v>6.36</c:v>
                </c:pt>
                <c:pt idx="574">
                  <c:v>6.3659999999999997</c:v>
                </c:pt>
                <c:pt idx="575">
                  <c:v>6.3710000000000004</c:v>
                </c:pt>
                <c:pt idx="576">
                  <c:v>6.3769999999999998</c:v>
                </c:pt>
                <c:pt idx="577">
                  <c:v>6.383</c:v>
                </c:pt>
                <c:pt idx="578">
                  <c:v>6.3890000000000002</c:v>
                </c:pt>
                <c:pt idx="579">
                  <c:v>6.3940000000000001</c:v>
                </c:pt>
                <c:pt idx="580">
                  <c:v>6.4</c:v>
                </c:pt>
                <c:pt idx="581">
                  <c:v>6.4059999999999997</c:v>
                </c:pt>
                <c:pt idx="582">
                  <c:v>6.4109999999999996</c:v>
                </c:pt>
                <c:pt idx="583">
                  <c:v>6.4169999999999998</c:v>
                </c:pt>
                <c:pt idx="584">
                  <c:v>6.423</c:v>
                </c:pt>
                <c:pt idx="585">
                  <c:v>6.4290000000000003</c:v>
                </c:pt>
                <c:pt idx="586">
                  <c:v>6.4340000000000002</c:v>
                </c:pt>
                <c:pt idx="587">
                  <c:v>6.44</c:v>
                </c:pt>
                <c:pt idx="588">
                  <c:v>6.4459999999999997</c:v>
                </c:pt>
                <c:pt idx="589">
                  <c:v>6.4509999999999996</c:v>
                </c:pt>
                <c:pt idx="590">
                  <c:v>6.4569999999999999</c:v>
                </c:pt>
                <c:pt idx="591">
                  <c:v>6.4630000000000001</c:v>
                </c:pt>
                <c:pt idx="592">
                  <c:v>6.4690000000000003</c:v>
                </c:pt>
                <c:pt idx="593">
                  <c:v>6.4740000000000002</c:v>
                </c:pt>
                <c:pt idx="594">
                  <c:v>6.48</c:v>
                </c:pt>
                <c:pt idx="595">
                  <c:v>6.4859999999999998</c:v>
                </c:pt>
                <c:pt idx="596">
                  <c:v>6.4909999999999997</c:v>
                </c:pt>
                <c:pt idx="597">
                  <c:v>6.4969999999999999</c:v>
                </c:pt>
                <c:pt idx="598">
                  <c:v>6.5030000000000001</c:v>
                </c:pt>
                <c:pt idx="599">
                  <c:v>6.5090000000000003</c:v>
                </c:pt>
                <c:pt idx="600">
                  <c:v>6.5140000000000002</c:v>
                </c:pt>
                <c:pt idx="601">
                  <c:v>6.52</c:v>
                </c:pt>
                <c:pt idx="602">
                  <c:v>6.5259999999999998</c:v>
                </c:pt>
                <c:pt idx="603">
                  <c:v>6.5309999999999997</c:v>
                </c:pt>
                <c:pt idx="604">
                  <c:v>6.5369999999999999</c:v>
                </c:pt>
                <c:pt idx="605">
                  <c:v>6.5430000000000001</c:v>
                </c:pt>
                <c:pt idx="606">
                  <c:v>6.5490000000000004</c:v>
                </c:pt>
                <c:pt idx="607">
                  <c:v>6.5540000000000003</c:v>
                </c:pt>
                <c:pt idx="608">
                  <c:v>6.56</c:v>
                </c:pt>
                <c:pt idx="609">
                  <c:v>6.5659999999999998</c:v>
                </c:pt>
                <c:pt idx="610">
                  <c:v>6.5709999999999997</c:v>
                </c:pt>
                <c:pt idx="611">
                  <c:v>6.577</c:v>
                </c:pt>
                <c:pt idx="612">
                  <c:v>6.5830000000000002</c:v>
                </c:pt>
                <c:pt idx="613">
                  <c:v>6.5890000000000004</c:v>
                </c:pt>
                <c:pt idx="614">
                  <c:v>6.5940000000000003</c:v>
                </c:pt>
                <c:pt idx="615">
                  <c:v>6.6</c:v>
                </c:pt>
                <c:pt idx="616">
                  <c:v>6.6059999999999999</c:v>
                </c:pt>
                <c:pt idx="617">
                  <c:v>6.6109999999999998</c:v>
                </c:pt>
                <c:pt idx="618">
                  <c:v>6.617</c:v>
                </c:pt>
                <c:pt idx="619">
                  <c:v>6.6230000000000002</c:v>
                </c:pt>
                <c:pt idx="620">
                  <c:v>6.6289999999999996</c:v>
                </c:pt>
                <c:pt idx="621">
                  <c:v>6.6340000000000003</c:v>
                </c:pt>
                <c:pt idx="622">
                  <c:v>6.64</c:v>
                </c:pt>
                <c:pt idx="623">
                  <c:v>6.6459999999999999</c:v>
                </c:pt>
                <c:pt idx="624">
                  <c:v>6.6509999999999998</c:v>
                </c:pt>
                <c:pt idx="625">
                  <c:v>6.657</c:v>
                </c:pt>
                <c:pt idx="626">
                  <c:v>6.6630000000000003</c:v>
                </c:pt>
                <c:pt idx="627">
                  <c:v>6.6689999999999996</c:v>
                </c:pt>
                <c:pt idx="628">
                  <c:v>6.6740000000000004</c:v>
                </c:pt>
                <c:pt idx="629">
                  <c:v>6.68</c:v>
                </c:pt>
                <c:pt idx="630">
                  <c:v>6.6859999999999999</c:v>
                </c:pt>
                <c:pt idx="631">
                  <c:v>6.6909999999999998</c:v>
                </c:pt>
                <c:pt idx="632">
                  <c:v>6.6970000000000001</c:v>
                </c:pt>
                <c:pt idx="633">
                  <c:v>6.7030000000000003</c:v>
                </c:pt>
                <c:pt idx="634">
                  <c:v>6.7089999999999996</c:v>
                </c:pt>
                <c:pt idx="635">
                  <c:v>6.7140000000000004</c:v>
                </c:pt>
                <c:pt idx="636">
                  <c:v>6.72</c:v>
                </c:pt>
                <c:pt idx="637">
                  <c:v>6.726</c:v>
                </c:pt>
                <c:pt idx="638">
                  <c:v>6.7309999999999999</c:v>
                </c:pt>
                <c:pt idx="639">
                  <c:v>6.7370000000000001</c:v>
                </c:pt>
                <c:pt idx="640">
                  <c:v>6.7430000000000003</c:v>
                </c:pt>
                <c:pt idx="641">
                  <c:v>6.7489999999999997</c:v>
                </c:pt>
                <c:pt idx="642">
                  <c:v>6.7539999999999996</c:v>
                </c:pt>
                <c:pt idx="643">
                  <c:v>6.76</c:v>
                </c:pt>
                <c:pt idx="644">
                  <c:v>6.766</c:v>
                </c:pt>
                <c:pt idx="645">
                  <c:v>6.7709999999999999</c:v>
                </c:pt>
                <c:pt idx="646">
                  <c:v>6.7770000000000001</c:v>
                </c:pt>
                <c:pt idx="647">
                  <c:v>6.7830000000000004</c:v>
                </c:pt>
                <c:pt idx="648">
                  <c:v>6.7889999999999997</c:v>
                </c:pt>
                <c:pt idx="649">
                  <c:v>6.7939999999999996</c:v>
                </c:pt>
                <c:pt idx="650">
                  <c:v>6.8</c:v>
                </c:pt>
                <c:pt idx="651">
                  <c:v>6.806</c:v>
                </c:pt>
                <c:pt idx="652">
                  <c:v>6.8109999999999999</c:v>
                </c:pt>
                <c:pt idx="653">
                  <c:v>6.8170000000000002</c:v>
                </c:pt>
                <c:pt idx="654">
                  <c:v>6.8230000000000004</c:v>
                </c:pt>
                <c:pt idx="655">
                  <c:v>6.8289999999999997</c:v>
                </c:pt>
                <c:pt idx="656">
                  <c:v>6.8339999999999996</c:v>
                </c:pt>
                <c:pt idx="657">
                  <c:v>6.84</c:v>
                </c:pt>
                <c:pt idx="658">
                  <c:v>6.8460000000000001</c:v>
                </c:pt>
                <c:pt idx="659">
                  <c:v>6.851</c:v>
                </c:pt>
                <c:pt idx="660">
                  <c:v>6.8570000000000002</c:v>
                </c:pt>
                <c:pt idx="661">
                  <c:v>6.8630000000000004</c:v>
                </c:pt>
                <c:pt idx="662">
                  <c:v>6.8689999999999998</c:v>
                </c:pt>
                <c:pt idx="663">
                  <c:v>6.8739999999999997</c:v>
                </c:pt>
                <c:pt idx="664">
                  <c:v>6.88</c:v>
                </c:pt>
                <c:pt idx="665">
                  <c:v>6.8860000000000001</c:v>
                </c:pt>
                <c:pt idx="666">
                  <c:v>6.891</c:v>
                </c:pt>
                <c:pt idx="667">
                  <c:v>6.8970000000000002</c:v>
                </c:pt>
                <c:pt idx="668">
                  <c:v>6.9029999999999996</c:v>
                </c:pt>
                <c:pt idx="669">
                  <c:v>6.9089999999999998</c:v>
                </c:pt>
                <c:pt idx="670">
                  <c:v>6.9139999999999997</c:v>
                </c:pt>
                <c:pt idx="671">
                  <c:v>6.92</c:v>
                </c:pt>
                <c:pt idx="672">
                  <c:v>6.9260000000000002</c:v>
                </c:pt>
                <c:pt idx="673">
                  <c:v>6.931</c:v>
                </c:pt>
                <c:pt idx="674">
                  <c:v>6.9370000000000003</c:v>
                </c:pt>
                <c:pt idx="675">
                  <c:v>6.9429999999999996</c:v>
                </c:pt>
                <c:pt idx="676">
                  <c:v>6.9489999999999998</c:v>
                </c:pt>
                <c:pt idx="677">
                  <c:v>6.9539999999999997</c:v>
                </c:pt>
                <c:pt idx="678">
                  <c:v>6.96</c:v>
                </c:pt>
                <c:pt idx="679">
                  <c:v>6.9660000000000002</c:v>
                </c:pt>
                <c:pt idx="680">
                  <c:v>6.9710000000000001</c:v>
                </c:pt>
                <c:pt idx="681">
                  <c:v>6.9770000000000003</c:v>
                </c:pt>
                <c:pt idx="682">
                  <c:v>6.9829999999999997</c:v>
                </c:pt>
                <c:pt idx="683">
                  <c:v>6.9889999999999999</c:v>
                </c:pt>
                <c:pt idx="684">
                  <c:v>6.9939999999999998</c:v>
                </c:pt>
                <c:pt idx="685">
                  <c:v>7</c:v>
                </c:pt>
                <c:pt idx="686">
                  <c:v>7.0060000000000002</c:v>
                </c:pt>
                <c:pt idx="687">
                  <c:v>7.0110000000000001</c:v>
                </c:pt>
                <c:pt idx="688">
                  <c:v>7.0170000000000003</c:v>
                </c:pt>
                <c:pt idx="689">
                  <c:v>7.0229999999999997</c:v>
                </c:pt>
                <c:pt idx="690">
                  <c:v>7.0289999999999999</c:v>
                </c:pt>
                <c:pt idx="691">
                  <c:v>7.0339999999999998</c:v>
                </c:pt>
                <c:pt idx="692">
                  <c:v>7.04</c:v>
                </c:pt>
                <c:pt idx="693">
                  <c:v>7.0460000000000003</c:v>
                </c:pt>
                <c:pt idx="694">
                  <c:v>7.0519999999999996</c:v>
                </c:pt>
                <c:pt idx="695">
                  <c:v>7.0570000000000004</c:v>
                </c:pt>
                <c:pt idx="696">
                  <c:v>7.0629999999999997</c:v>
                </c:pt>
                <c:pt idx="697">
                  <c:v>7.069</c:v>
                </c:pt>
                <c:pt idx="698">
                  <c:v>7.0739999999999998</c:v>
                </c:pt>
                <c:pt idx="699">
                  <c:v>7.08</c:v>
                </c:pt>
                <c:pt idx="700">
                  <c:v>7.0860000000000003</c:v>
                </c:pt>
                <c:pt idx="701">
                  <c:v>7.0910000000000002</c:v>
                </c:pt>
                <c:pt idx="702">
                  <c:v>7.0970000000000004</c:v>
                </c:pt>
                <c:pt idx="703">
                  <c:v>7.1029999999999998</c:v>
                </c:pt>
                <c:pt idx="704">
                  <c:v>7.109</c:v>
                </c:pt>
                <c:pt idx="705">
                  <c:v>7.1139999999999999</c:v>
                </c:pt>
                <c:pt idx="706">
                  <c:v>7.12</c:v>
                </c:pt>
                <c:pt idx="707">
                  <c:v>7.1260000000000003</c:v>
                </c:pt>
                <c:pt idx="708">
                  <c:v>7.1319999999999997</c:v>
                </c:pt>
                <c:pt idx="709">
                  <c:v>7.1369999999999996</c:v>
                </c:pt>
                <c:pt idx="710">
                  <c:v>7.1429999999999998</c:v>
                </c:pt>
                <c:pt idx="711">
                  <c:v>7.149</c:v>
                </c:pt>
                <c:pt idx="712">
                  <c:v>7.1539999999999999</c:v>
                </c:pt>
                <c:pt idx="713">
                  <c:v>7.16</c:v>
                </c:pt>
                <c:pt idx="714">
                  <c:v>7.1660000000000004</c:v>
                </c:pt>
                <c:pt idx="715">
                  <c:v>7.1719999999999997</c:v>
                </c:pt>
                <c:pt idx="716">
                  <c:v>7.1769999999999996</c:v>
                </c:pt>
                <c:pt idx="717">
                  <c:v>7.1829999999999998</c:v>
                </c:pt>
                <c:pt idx="718">
                  <c:v>7.1890000000000001</c:v>
                </c:pt>
                <c:pt idx="719">
                  <c:v>7.194</c:v>
                </c:pt>
                <c:pt idx="720">
                  <c:v>7.2</c:v>
                </c:pt>
                <c:pt idx="721">
                  <c:v>7.2060000000000004</c:v>
                </c:pt>
                <c:pt idx="722">
                  <c:v>7.2119999999999997</c:v>
                </c:pt>
                <c:pt idx="723">
                  <c:v>7.2169999999999996</c:v>
                </c:pt>
                <c:pt idx="724">
                  <c:v>7.2229999999999999</c:v>
                </c:pt>
                <c:pt idx="725">
                  <c:v>7.2290000000000001</c:v>
                </c:pt>
                <c:pt idx="726">
                  <c:v>7.234</c:v>
                </c:pt>
                <c:pt idx="727">
                  <c:v>7.24</c:v>
                </c:pt>
                <c:pt idx="728">
                  <c:v>7.2460000000000004</c:v>
                </c:pt>
                <c:pt idx="729">
                  <c:v>7.2519999999999998</c:v>
                </c:pt>
                <c:pt idx="730">
                  <c:v>7.2569999999999997</c:v>
                </c:pt>
                <c:pt idx="731">
                  <c:v>7.2629999999999999</c:v>
                </c:pt>
                <c:pt idx="732">
                  <c:v>7.2690000000000001</c:v>
                </c:pt>
                <c:pt idx="733">
                  <c:v>7.274</c:v>
                </c:pt>
                <c:pt idx="734">
                  <c:v>7.28</c:v>
                </c:pt>
                <c:pt idx="735">
                  <c:v>7.2859999999999996</c:v>
                </c:pt>
                <c:pt idx="736">
                  <c:v>7.2919999999999998</c:v>
                </c:pt>
                <c:pt idx="737">
                  <c:v>7.2969999999999997</c:v>
                </c:pt>
                <c:pt idx="738">
                  <c:v>7.3029999999999999</c:v>
                </c:pt>
                <c:pt idx="739">
                  <c:v>7.3090000000000002</c:v>
                </c:pt>
                <c:pt idx="740">
                  <c:v>7.3140000000000001</c:v>
                </c:pt>
                <c:pt idx="741">
                  <c:v>7.32</c:v>
                </c:pt>
                <c:pt idx="742">
                  <c:v>7.3259999999999996</c:v>
                </c:pt>
                <c:pt idx="743">
                  <c:v>7.3319999999999999</c:v>
                </c:pt>
                <c:pt idx="744">
                  <c:v>7.3369999999999997</c:v>
                </c:pt>
                <c:pt idx="745">
                  <c:v>7.343</c:v>
                </c:pt>
                <c:pt idx="746">
                  <c:v>7.3490000000000002</c:v>
                </c:pt>
                <c:pt idx="747">
                  <c:v>7.3540000000000001</c:v>
                </c:pt>
                <c:pt idx="748">
                  <c:v>7.36</c:v>
                </c:pt>
                <c:pt idx="749">
                  <c:v>7.3659999999999997</c:v>
                </c:pt>
                <c:pt idx="750">
                  <c:v>7.3719999999999999</c:v>
                </c:pt>
                <c:pt idx="751">
                  <c:v>7.3769999999999998</c:v>
                </c:pt>
                <c:pt idx="752">
                  <c:v>7.383</c:v>
                </c:pt>
                <c:pt idx="753">
                  <c:v>7.3890000000000002</c:v>
                </c:pt>
                <c:pt idx="754">
                  <c:v>7.3940000000000001</c:v>
                </c:pt>
                <c:pt idx="755">
                  <c:v>7.4</c:v>
                </c:pt>
                <c:pt idx="756">
                  <c:v>7.4059999999999997</c:v>
                </c:pt>
                <c:pt idx="757">
                  <c:v>7.4119999999999999</c:v>
                </c:pt>
                <c:pt idx="758">
                  <c:v>7.4169999999999998</c:v>
                </c:pt>
                <c:pt idx="759">
                  <c:v>7.423</c:v>
                </c:pt>
                <c:pt idx="760">
                  <c:v>7.4290000000000003</c:v>
                </c:pt>
                <c:pt idx="761">
                  <c:v>7.4340000000000002</c:v>
                </c:pt>
                <c:pt idx="762">
                  <c:v>7.44</c:v>
                </c:pt>
                <c:pt idx="763">
                  <c:v>7.4459999999999997</c:v>
                </c:pt>
                <c:pt idx="764">
                  <c:v>7.452</c:v>
                </c:pt>
                <c:pt idx="765">
                  <c:v>7.4569999999999999</c:v>
                </c:pt>
                <c:pt idx="766">
                  <c:v>7.4630000000000001</c:v>
                </c:pt>
                <c:pt idx="767">
                  <c:v>7.4690000000000003</c:v>
                </c:pt>
                <c:pt idx="768">
                  <c:v>7.4740000000000002</c:v>
                </c:pt>
                <c:pt idx="769">
                  <c:v>7.48</c:v>
                </c:pt>
                <c:pt idx="770">
                  <c:v>7.4859999999999998</c:v>
                </c:pt>
                <c:pt idx="771">
                  <c:v>7.492</c:v>
                </c:pt>
                <c:pt idx="772">
                  <c:v>7.4969999999999999</c:v>
                </c:pt>
                <c:pt idx="773">
                  <c:v>7.5030000000000001</c:v>
                </c:pt>
                <c:pt idx="774">
                  <c:v>7.5090000000000003</c:v>
                </c:pt>
                <c:pt idx="775">
                  <c:v>7.5140000000000002</c:v>
                </c:pt>
                <c:pt idx="776">
                  <c:v>7.52</c:v>
                </c:pt>
                <c:pt idx="777">
                  <c:v>7.5259999999999998</c:v>
                </c:pt>
                <c:pt idx="778">
                  <c:v>7.532</c:v>
                </c:pt>
                <c:pt idx="779">
                  <c:v>7.5369999999999999</c:v>
                </c:pt>
                <c:pt idx="780">
                  <c:v>7.5430000000000001</c:v>
                </c:pt>
                <c:pt idx="781">
                  <c:v>7.5490000000000004</c:v>
                </c:pt>
                <c:pt idx="782">
                  <c:v>7.5540000000000003</c:v>
                </c:pt>
                <c:pt idx="783">
                  <c:v>7.56</c:v>
                </c:pt>
                <c:pt idx="784">
                  <c:v>7.5659999999999998</c:v>
                </c:pt>
                <c:pt idx="785">
                  <c:v>7.5720000000000001</c:v>
                </c:pt>
                <c:pt idx="786">
                  <c:v>7.577</c:v>
                </c:pt>
                <c:pt idx="787">
                  <c:v>7.5830000000000002</c:v>
                </c:pt>
                <c:pt idx="788">
                  <c:v>7.5890000000000004</c:v>
                </c:pt>
                <c:pt idx="789">
                  <c:v>7.5940000000000003</c:v>
                </c:pt>
                <c:pt idx="790">
                  <c:v>7.6</c:v>
                </c:pt>
                <c:pt idx="791">
                  <c:v>7.6059999999999999</c:v>
                </c:pt>
                <c:pt idx="792">
                  <c:v>7.6120000000000001</c:v>
                </c:pt>
                <c:pt idx="793">
                  <c:v>7.617</c:v>
                </c:pt>
                <c:pt idx="794">
                  <c:v>7.6230000000000002</c:v>
                </c:pt>
                <c:pt idx="795">
                  <c:v>7.6289999999999996</c:v>
                </c:pt>
                <c:pt idx="796">
                  <c:v>7.6340000000000003</c:v>
                </c:pt>
                <c:pt idx="797">
                  <c:v>7.64</c:v>
                </c:pt>
                <c:pt idx="798">
                  <c:v>7.6459999999999999</c:v>
                </c:pt>
                <c:pt idx="799">
                  <c:v>7.6520000000000001</c:v>
                </c:pt>
                <c:pt idx="800">
                  <c:v>7.657</c:v>
                </c:pt>
                <c:pt idx="801">
                  <c:v>7.6630000000000003</c:v>
                </c:pt>
                <c:pt idx="802">
                  <c:v>7.6689999999999996</c:v>
                </c:pt>
                <c:pt idx="803">
                  <c:v>7.6740000000000004</c:v>
                </c:pt>
                <c:pt idx="804">
                  <c:v>7.68</c:v>
                </c:pt>
                <c:pt idx="805">
                  <c:v>7.6859999999999999</c:v>
                </c:pt>
                <c:pt idx="806">
                  <c:v>7.6920000000000002</c:v>
                </c:pt>
                <c:pt idx="807">
                  <c:v>7.6970000000000001</c:v>
                </c:pt>
                <c:pt idx="808">
                  <c:v>7.7030000000000003</c:v>
                </c:pt>
                <c:pt idx="809">
                  <c:v>7.7089999999999996</c:v>
                </c:pt>
                <c:pt idx="810">
                  <c:v>7.7140000000000004</c:v>
                </c:pt>
                <c:pt idx="811">
                  <c:v>7.72</c:v>
                </c:pt>
                <c:pt idx="812">
                  <c:v>7.726</c:v>
                </c:pt>
                <c:pt idx="813">
                  <c:v>7.7320000000000002</c:v>
                </c:pt>
                <c:pt idx="814">
                  <c:v>7.7370000000000001</c:v>
                </c:pt>
                <c:pt idx="815">
                  <c:v>7.7430000000000003</c:v>
                </c:pt>
                <c:pt idx="816">
                  <c:v>7.7489999999999997</c:v>
                </c:pt>
                <c:pt idx="817">
                  <c:v>7.7539999999999996</c:v>
                </c:pt>
                <c:pt idx="818">
                  <c:v>7.76</c:v>
                </c:pt>
                <c:pt idx="819">
                  <c:v>7.766</c:v>
                </c:pt>
                <c:pt idx="820">
                  <c:v>7.7720000000000002</c:v>
                </c:pt>
                <c:pt idx="821">
                  <c:v>7.7770000000000001</c:v>
                </c:pt>
                <c:pt idx="822">
                  <c:v>7.7830000000000004</c:v>
                </c:pt>
                <c:pt idx="823">
                  <c:v>7.7889999999999997</c:v>
                </c:pt>
                <c:pt idx="824">
                  <c:v>7.7939999999999996</c:v>
                </c:pt>
                <c:pt idx="825">
                  <c:v>7.8</c:v>
                </c:pt>
                <c:pt idx="826">
                  <c:v>7.806</c:v>
                </c:pt>
                <c:pt idx="827">
                  <c:v>7.8120000000000003</c:v>
                </c:pt>
                <c:pt idx="828">
                  <c:v>7.8170000000000002</c:v>
                </c:pt>
                <c:pt idx="829">
                  <c:v>7.8230000000000004</c:v>
                </c:pt>
                <c:pt idx="830">
                  <c:v>7.8289999999999997</c:v>
                </c:pt>
                <c:pt idx="831">
                  <c:v>7.835</c:v>
                </c:pt>
                <c:pt idx="832">
                  <c:v>7.84</c:v>
                </c:pt>
                <c:pt idx="833">
                  <c:v>7.8460000000000001</c:v>
                </c:pt>
                <c:pt idx="834">
                  <c:v>7.8520000000000003</c:v>
                </c:pt>
                <c:pt idx="835">
                  <c:v>7.8570000000000002</c:v>
                </c:pt>
                <c:pt idx="836">
                  <c:v>7.8630000000000004</c:v>
                </c:pt>
                <c:pt idx="837">
                  <c:v>7.8689999999999998</c:v>
                </c:pt>
                <c:pt idx="838">
                  <c:v>7.875</c:v>
                </c:pt>
                <c:pt idx="839">
                  <c:v>7.88</c:v>
                </c:pt>
                <c:pt idx="840">
                  <c:v>7.8860000000000001</c:v>
                </c:pt>
                <c:pt idx="841">
                  <c:v>7.8920000000000003</c:v>
                </c:pt>
                <c:pt idx="842">
                  <c:v>7.8970000000000002</c:v>
                </c:pt>
                <c:pt idx="843">
                  <c:v>7.9029999999999996</c:v>
                </c:pt>
                <c:pt idx="844">
                  <c:v>7.9089999999999998</c:v>
                </c:pt>
                <c:pt idx="845">
                  <c:v>7.915</c:v>
                </c:pt>
                <c:pt idx="846">
                  <c:v>7.92</c:v>
                </c:pt>
                <c:pt idx="847">
                  <c:v>7.9260000000000002</c:v>
                </c:pt>
                <c:pt idx="848">
                  <c:v>7.9320000000000004</c:v>
                </c:pt>
                <c:pt idx="849">
                  <c:v>7.9370000000000003</c:v>
                </c:pt>
                <c:pt idx="850">
                  <c:v>7.9429999999999996</c:v>
                </c:pt>
                <c:pt idx="851">
                  <c:v>7.9489999999999998</c:v>
                </c:pt>
                <c:pt idx="852">
                  <c:v>7.9550000000000001</c:v>
                </c:pt>
                <c:pt idx="853">
                  <c:v>7.96</c:v>
                </c:pt>
                <c:pt idx="854">
                  <c:v>7.9660000000000002</c:v>
                </c:pt>
                <c:pt idx="855">
                  <c:v>7.9720000000000004</c:v>
                </c:pt>
                <c:pt idx="856">
                  <c:v>7.9770000000000003</c:v>
                </c:pt>
                <c:pt idx="857">
                  <c:v>7.9829999999999997</c:v>
                </c:pt>
                <c:pt idx="858">
                  <c:v>7.9889999999999999</c:v>
                </c:pt>
                <c:pt idx="859">
                  <c:v>7.9950000000000001</c:v>
                </c:pt>
                <c:pt idx="860">
                  <c:v>8</c:v>
                </c:pt>
                <c:pt idx="861">
                  <c:v>8.0060000000000002</c:v>
                </c:pt>
                <c:pt idx="862">
                  <c:v>8.0120000000000005</c:v>
                </c:pt>
                <c:pt idx="863">
                  <c:v>8.0169999999999995</c:v>
                </c:pt>
                <c:pt idx="864">
                  <c:v>8.0229999999999997</c:v>
                </c:pt>
                <c:pt idx="865">
                  <c:v>8.0289999999999999</c:v>
                </c:pt>
                <c:pt idx="866">
                  <c:v>8.0350000000000001</c:v>
                </c:pt>
                <c:pt idx="867">
                  <c:v>8.0399999999999991</c:v>
                </c:pt>
                <c:pt idx="868">
                  <c:v>8.0459999999999994</c:v>
                </c:pt>
                <c:pt idx="869">
                  <c:v>8.0519999999999996</c:v>
                </c:pt>
                <c:pt idx="870">
                  <c:v>8.0570000000000004</c:v>
                </c:pt>
                <c:pt idx="871">
                  <c:v>8.0630000000000006</c:v>
                </c:pt>
                <c:pt idx="872">
                  <c:v>8.0690000000000008</c:v>
                </c:pt>
                <c:pt idx="873">
                  <c:v>8.0749999999999993</c:v>
                </c:pt>
                <c:pt idx="874">
                  <c:v>8.08</c:v>
                </c:pt>
                <c:pt idx="875">
                  <c:v>8.0860000000000003</c:v>
                </c:pt>
                <c:pt idx="876">
                  <c:v>8.0920000000000005</c:v>
                </c:pt>
                <c:pt idx="877">
                  <c:v>8.0969999999999995</c:v>
                </c:pt>
                <c:pt idx="878">
                  <c:v>8.1029999999999998</c:v>
                </c:pt>
                <c:pt idx="879">
                  <c:v>8.109</c:v>
                </c:pt>
                <c:pt idx="880">
                  <c:v>8.1150000000000002</c:v>
                </c:pt>
                <c:pt idx="881">
                  <c:v>8.1199999999999992</c:v>
                </c:pt>
                <c:pt idx="882">
                  <c:v>8.1259999999999994</c:v>
                </c:pt>
                <c:pt idx="883">
                  <c:v>8.1319999999999997</c:v>
                </c:pt>
                <c:pt idx="884">
                  <c:v>8.1370000000000005</c:v>
                </c:pt>
                <c:pt idx="885">
                  <c:v>8.1430000000000007</c:v>
                </c:pt>
                <c:pt idx="886">
                  <c:v>8.1489999999999991</c:v>
                </c:pt>
                <c:pt idx="887">
                  <c:v>8.1549999999999994</c:v>
                </c:pt>
                <c:pt idx="888">
                  <c:v>8.16</c:v>
                </c:pt>
                <c:pt idx="889">
                  <c:v>8.1660000000000004</c:v>
                </c:pt>
                <c:pt idx="890">
                  <c:v>8.1720000000000006</c:v>
                </c:pt>
                <c:pt idx="891">
                  <c:v>8.1769999999999996</c:v>
                </c:pt>
                <c:pt idx="892">
                  <c:v>8.1829999999999998</c:v>
                </c:pt>
                <c:pt idx="893">
                  <c:v>8.1890000000000001</c:v>
                </c:pt>
                <c:pt idx="894">
                  <c:v>8.1950000000000003</c:v>
                </c:pt>
                <c:pt idx="895">
                  <c:v>8.1999999999999993</c:v>
                </c:pt>
                <c:pt idx="896">
                  <c:v>8.2059999999999995</c:v>
                </c:pt>
                <c:pt idx="897">
                  <c:v>8.2119999999999997</c:v>
                </c:pt>
                <c:pt idx="898">
                  <c:v>8.2170000000000005</c:v>
                </c:pt>
                <c:pt idx="899">
                  <c:v>8.2230000000000008</c:v>
                </c:pt>
                <c:pt idx="900">
                  <c:v>8.2289999999999992</c:v>
                </c:pt>
                <c:pt idx="901">
                  <c:v>8.2349999999999994</c:v>
                </c:pt>
                <c:pt idx="902">
                  <c:v>8.24</c:v>
                </c:pt>
                <c:pt idx="903">
                  <c:v>8.2460000000000004</c:v>
                </c:pt>
                <c:pt idx="904">
                  <c:v>8.2520000000000007</c:v>
                </c:pt>
                <c:pt idx="905">
                  <c:v>8.2569999999999997</c:v>
                </c:pt>
                <c:pt idx="906">
                  <c:v>8.2629999999999999</c:v>
                </c:pt>
                <c:pt idx="907">
                  <c:v>8.2690000000000001</c:v>
                </c:pt>
                <c:pt idx="908">
                  <c:v>8.2750000000000004</c:v>
                </c:pt>
                <c:pt idx="909">
                  <c:v>8.2799999999999994</c:v>
                </c:pt>
                <c:pt idx="910">
                  <c:v>8.2859999999999996</c:v>
                </c:pt>
                <c:pt idx="911">
                  <c:v>8.2919999999999998</c:v>
                </c:pt>
                <c:pt idx="912">
                  <c:v>8.2970000000000006</c:v>
                </c:pt>
                <c:pt idx="913">
                  <c:v>8.3030000000000008</c:v>
                </c:pt>
                <c:pt idx="914">
                  <c:v>8.3089999999999993</c:v>
                </c:pt>
                <c:pt idx="915">
                  <c:v>8.3149999999999995</c:v>
                </c:pt>
                <c:pt idx="916">
                  <c:v>8.32</c:v>
                </c:pt>
                <c:pt idx="917">
                  <c:v>8.3260000000000005</c:v>
                </c:pt>
                <c:pt idx="918">
                  <c:v>8.3320000000000007</c:v>
                </c:pt>
                <c:pt idx="919">
                  <c:v>8.3369999999999997</c:v>
                </c:pt>
                <c:pt idx="920">
                  <c:v>8.343</c:v>
                </c:pt>
                <c:pt idx="921">
                  <c:v>8.3490000000000002</c:v>
                </c:pt>
                <c:pt idx="922">
                  <c:v>8.3550000000000004</c:v>
                </c:pt>
                <c:pt idx="923">
                  <c:v>8.36</c:v>
                </c:pt>
                <c:pt idx="924">
                  <c:v>8.3659999999999997</c:v>
                </c:pt>
                <c:pt idx="925">
                  <c:v>8.3719999999999999</c:v>
                </c:pt>
                <c:pt idx="926">
                  <c:v>8.3770000000000007</c:v>
                </c:pt>
                <c:pt idx="927">
                  <c:v>8.3829999999999991</c:v>
                </c:pt>
                <c:pt idx="928">
                  <c:v>8.3889999999999993</c:v>
                </c:pt>
                <c:pt idx="929">
                  <c:v>8.3949999999999996</c:v>
                </c:pt>
                <c:pt idx="930">
                  <c:v>8.4</c:v>
                </c:pt>
                <c:pt idx="931">
                  <c:v>8.4060000000000006</c:v>
                </c:pt>
                <c:pt idx="932">
                  <c:v>8.4120000000000008</c:v>
                </c:pt>
                <c:pt idx="933">
                  <c:v>8.4169999999999998</c:v>
                </c:pt>
                <c:pt idx="934">
                  <c:v>8.423</c:v>
                </c:pt>
                <c:pt idx="935">
                  <c:v>8.4290000000000003</c:v>
                </c:pt>
                <c:pt idx="936">
                  <c:v>8.4350000000000005</c:v>
                </c:pt>
                <c:pt idx="937">
                  <c:v>8.44</c:v>
                </c:pt>
                <c:pt idx="938">
                  <c:v>8.4459999999999997</c:v>
                </c:pt>
                <c:pt idx="939">
                  <c:v>8.452</c:v>
                </c:pt>
                <c:pt idx="940">
                  <c:v>8.4570000000000007</c:v>
                </c:pt>
                <c:pt idx="941">
                  <c:v>8.4629999999999992</c:v>
                </c:pt>
                <c:pt idx="942">
                  <c:v>8.4689999999999994</c:v>
                </c:pt>
                <c:pt idx="943">
                  <c:v>8.4749999999999996</c:v>
                </c:pt>
                <c:pt idx="944">
                  <c:v>8.48</c:v>
                </c:pt>
                <c:pt idx="945">
                  <c:v>8.4860000000000007</c:v>
                </c:pt>
                <c:pt idx="946">
                  <c:v>8.4920000000000009</c:v>
                </c:pt>
                <c:pt idx="947">
                  <c:v>8.4969999999999999</c:v>
                </c:pt>
                <c:pt idx="948">
                  <c:v>8.5030000000000001</c:v>
                </c:pt>
                <c:pt idx="949">
                  <c:v>8.5090000000000003</c:v>
                </c:pt>
                <c:pt idx="950">
                  <c:v>8.5150000000000006</c:v>
                </c:pt>
                <c:pt idx="951">
                  <c:v>8.52</c:v>
                </c:pt>
                <c:pt idx="952">
                  <c:v>8.5259999999999998</c:v>
                </c:pt>
                <c:pt idx="953">
                  <c:v>8.532</c:v>
                </c:pt>
                <c:pt idx="954">
                  <c:v>8.5370000000000008</c:v>
                </c:pt>
                <c:pt idx="955">
                  <c:v>8.5429999999999993</c:v>
                </c:pt>
                <c:pt idx="956">
                  <c:v>8.5489999999999995</c:v>
                </c:pt>
                <c:pt idx="957">
                  <c:v>8.5549999999999997</c:v>
                </c:pt>
                <c:pt idx="958">
                  <c:v>8.56</c:v>
                </c:pt>
                <c:pt idx="959">
                  <c:v>8.5660000000000007</c:v>
                </c:pt>
                <c:pt idx="960">
                  <c:v>8.5719999999999992</c:v>
                </c:pt>
                <c:pt idx="961">
                  <c:v>8.577</c:v>
                </c:pt>
                <c:pt idx="962">
                  <c:v>8.5830000000000002</c:v>
                </c:pt>
                <c:pt idx="963">
                  <c:v>8.5890000000000004</c:v>
                </c:pt>
                <c:pt idx="964">
                  <c:v>8.5950000000000006</c:v>
                </c:pt>
                <c:pt idx="965">
                  <c:v>8.6</c:v>
                </c:pt>
                <c:pt idx="966">
                  <c:v>8.6059999999999999</c:v>
                </c:pt>
                <c:pt idx="967">
                  <c:v>8.6120000000000001</c:v>
                </c:pt>
                <c:pt idx="968">
                  <c:v>8.6170000000000009</c:v>
                </c:pt>
                <c:pt idx="969">
                  <c:v>8.6229999999999993</c:v>
                </c:pt>
                <c:pt idx="970">
                  <c:v>8.6289999999999996</c:v>
                </c:pt>
                <c:pt idx="971">
                  <c:v>8.6349999999999998</c:v>
                </c:pt>
                <c:pt idx="972">
                  <c:v>8.64</c:v>
                </c:pt>
                <c:pt idx="973">
                  <c:v>8.6460000000000008</c:v>
                </c:pt>
                <c:pt idx="974">
                  <c:v>8.6519999999999992</c:v>
                </c:pt>
                <c:pt idx="975">
                  <c:v>8.6579999999999995</c:v>
                </c:pt>
                <c:pt idx="976">
                  <c:v>8.6630000000000003</c:v>
                </c:pt>
                <c:pt idx="977">
                  <c:v>8.6690000000000005</c:v>
                </c:pt>
                <c:pt idx="978">
                  <c:v>8.6750000000000007</c:v>
                </c:pt>
                <c:pt idx="979">
                  <c:v>8.68</c:v>
                </c:pt>
                <c:pt idx="980">
                  <c:v>8.6859999999999999</c:v>
                </c:pt>
                <c:pt idx="981">
                  <c:v>8.6920000000000002</c:v>
                </c:pt>
                <c:pt idx="982">
                  <c:v>8.6969999999999992</c:v>
                </c:pt>
                <c:pt idx="983">
                  <c:v>8.7029999999999994</c:v>
                </c:pt>
                <c:pt idx="984">
                  <c:v>8.7089999999999996</c:v>
                </c:pt>
                <c:pt idx="985">
                  <c:v>8.7149999999999999</c:v>
                </c:pt>
                <c:pt idx="986">
                  <c:v>8.7200000000000006</c:v>
                </c:pt>
                <c:pt idx="987">
                  <c:v>8.7260000000000009</c:v>
                </c:pt>
                <c:pt idx="988">
                  <c:v>8.7319999999999993</c:v>
                </c:pt>
                <c:pt idx="989">
                  <c:v>8.7379999999999995</c:v>
                </c:pt>
                <c:pt idx="990">
                  <c:v>8.7430000000000003</c:v>
                </c:pt>
                <c:pt idx="991">
                  <c:v>8.7490000000000006</c:v>
                </c:pt>
                <c:pt idx="992">
                  <c:v>8.7550000000000008</c:v>
                </c:pt>
                <c:pt idx="993">
                  <c:v>8.76</c:v>
                </c:pt>
                <c:pt idx="994">
                  <c:v>8.766</c:v>
                </c:pt>
                <c:pt idx="995">
                  <c:v>8.7720000000000002</c:v>
                </c:pt>
                <c:pt idx="996">
                  <c:v>8.7780000000000005</c:v>
                </c:pt>
                <c:pt idx="997">
                  <c:v>8.7829999999999995</c:v>
                </c:pt>
                <c:pt idx="998">
                  <c:v>8.7889999999999997</c:v>
                </c:pt>
                <c:pt idx="999">
                  <c:v>8.7949999999999999</c:v>
                </c:pt>
                <c:pt idx="1000">
                  <c:v>8.8000000000000007</c:v>
                </c:pt>
                <c:pt idx="1001">
                  <c:v>8.8059999999999992</c:v>
                </c:pt>
                <c:pt idx="1002">
                  <c:v>8.8119999999999994</c:v>
                </c:pt>
                <c:pt idx="1003">
                  <c:v>8.8179999999999996</c:v>
                </c:pt>
                <c:pt idx="1004">
                  <c:v>8.8230000000000004</c:v>
                </c:pt>
                <c:pt idx="1005">
                  <c:v>8.8290000000000006</c:v>
                </c:pt>
                <c:pt idx="1006">
                  <c:v>8.8350000000000009</c:v>
                </c:pt>
                <c:pt idx="1007">
                  <c:v>8.84</c:v>
                </c:pt>
                <c:pt idx="1008">
                  <c:v>8.8460000000000001</c:v>
                </c:pt>
                <c:pt idx="1009">
                  <c:v>8.8520000000000003</c:v>
                </c:pt>
                <c:pt idx="1010">
                  <c:v>8.8580000000000005</c:v>
                </c:pt>
                <c:pt idx="1011">
                  <c:v>8.8629999999999995</c:v>
                </c:pt>
                <c:pt idx="1012">
                  <c:v>8.8689999999999998</c:v>
                </c:pt>
                <c:pt idx="1013">
                  <c:v>8.875</c:v>
                </c:pt>
                <c:pt idx="1014">
                  <c:v>8.8800000000000008</c:v>
                </c:pt>
                <c:pt idx="1015">
                  <c:v>8.8859999999999992</c:v>
                </c:pt>
                <c:pt idx="1016">
                  <c:v>8.8919999999999995</c:v>
                </c:pt>
                <c:pt idx="1017">
                  <c:v>8.8979999999999997</c:v>
                </c:pt>
                <c:pt idx="1018">
                  <c:v>8.9030000000000005</c:v>
                </c:pt>
                <c:pt idx="1019">
                  <c:v>8.9090000000000007</c:v>
                </c:pt>
                <c:pt idx="1020">
                  <c:v>8.9149999999999991</c:v>
                </c:pt>
                <c:pt idx="1021">
                  <c:v>8.92</c:v>
                </c:pt>
                <c:pt idx="1022">
                  <c:v>8.9260000000000002</c:v>
                </c:pt>
                <c:pt idx="1023">
                  <c:v>8.9320000000000004</c:v>
                </c:pt>
                <c:pt idx="1024">
                  <c:v>8.9380000000000006</c:v>
                </c:pt>
                <c:pt idx="1025">
                  <c:v>8.9429999999999996</c:v>
                </c:pt>
                <c:pt idx="1026">
                  <c:v>8.9489999999999998</c:v>
                </c:pt>
                <c:pt idx="1027">
                  <c:v>8.9550000000000001</c:v>
                </c:pt>
                <c:pt idx="1028">
                  <c:v>8.9600000000000009</c:v>
                </c:pt>
                <c:pt idx="1029">
                  <c:v>8.9659999999999993</c:v>
                </c:pt>
                <c:pt idx="1030">
                  <c:v>8.9719999999999995</c:v>
                </c:pt>
                <c:pt idx="1031">
                  <c:v>8.9779999999999998</c:v>
                </c:pt>
                <c:pt idx="1032">
                  <c:v>8.9830000000000005</c:v>
                </c:pt>
                <c:pt idx="1033">
                  <c:v>8.9890000000000008</c:v>
                </c:pt>
                <c:pt idx="1034">
                  <c:v>8.9949999999999992</c:v>
                </c:pt>
                <c:pt idx="1035">
                  <c:v>9</c:v>
                </c:pt>
                <c:pt idx="1036">
                  <c:v>9.0060000000000002</c:v>
                </c:pt>
                <c:pt idx="1037">
                  <c:v>9.0120000000000005</c:v>
                </c:pt>
                <c:pt idx="1038">
                  <c:v>9.0180000000000007</c:v>
                </c:pt>
                <c:pt idx="1039">
                  <c:v>9.0229999999999997</c:v>
                </c:pt>
                <c:pt idx="1040">
                  <c:v>9.0289999999999999</c:v>
                </c:pt>
                <c:pt idx="1041">
                  <c:v>9.0350000000000001</c:v>
                </c:pt>
                <c:pt idx="1042">
                  <c:v>9.0399999999999991</c:v>
                </c:pt>
                <c:pt idx="1043">
                  <c:v>9.0459999999999994</c:v>
                </c:pt>
                <c:pt idx="1044">
                  <c:v>9.0519999999999996</c:v>
                </c:pt>
                <c:pt idx="1045">
                  <c:v>9.0579999999999998</c:v>
                </c:pt>
                <c:pt idx="1046">
                  <c:v>9.0630000000000006</c:v>
                </c:pt>
                <c:pt idx="1047">
                  <c:v>9.0690000000000008</c:v>
                </c:pt>
                <c:pt idx="1048">
                  <c:v>9.0749999999999993</c:v>
                </c:pt>
                <c:pt idx="1049">
                  <c:v>9.08</c:v>
                </c:pt>
                <c:pt idx="1050">
                  <c:v>9.0860000000000003</c:v>
                </c:pt>
                <c:pt idx="1051">
                  <c:v>9.0920000000000005</c:v>
                </c:pt>
                <c:pt idx="1052">
                  <c:v>9.0980000000000008</c:v>
                </c:pt>
                <c:pt idx="1053">
                  <c:v>9.1029999999999998</c:v>
                </c:pt>
                <c:pt idx="1054">
                  <c:v>9.109</c:v>
                </c:pt>
                <c:pt idx="1055">
                  <c:v>9.1150000000000002</c:v>
                </c:pt>
                <c:pt idx="1056">
                  <c:v>9.1199999999999992</c:v>
                </c:pt>
                <c:pt idx="1057">
                  <c:v>9.1259999999999994</c:v>
                </c:pt>
                <c:pt idx="1058">
                  <c:v>9.1319999999999997</c:v>
                </c:pt>
                <c:pt idx="1059">
                  <c:v>9.1379999999999999</c:v>
                </c:pt>
                <c:pt idx="1060">
                  <c:v>9.1430000000000007</c:v>
                </c:pt>
                <c:pt idx="1061">
                  <c:v>9.1489999999999991</c:v>
                </c:pt>
                <c:pt idx="1062">
                  <c:v>9.1549999999999994</c:v>
                </c:pt>
                <c:pt idx="1063">
                  <c:v>9.16</c:v>
                </c:pt>
                <c:pt idx="1064">
                  <c:v>9.1660000000000004</c:v>
                </c:pt>
                <c:pt idx="1065">
                  <c:v>9.1720000000000006</c:v>
                </c:pt>
                <c:pt idx="1066">
                  <c:v>9.1780000000000008</c:v>
                </c:pt>
                <c:pt idx="1067">
                  <c:v>9.1829999999999998</c:v>
                </c:pt>
                <c:pt idx="1068">
                  <c:v>9.1890000000000001</c:v>
                </c:pt>
                <c:pt idx="1069">
                  <c:v>9.1950000000000003</c:v>
                </c:pt>
                <c:pt idx="1070">
                  <c:v>9.1999999999999993</c:v>
                </c:pt>
                <c:pt idx="1071">
                  <c:v>9.2059999999999995</c:v>
                </c:pt>
                <c:pt idx="1072">
                  <c:v>9.2119999999999997</c:v>
                </c:pt>
                <c:pt idx="1073">
                  <c:v>9.218</c:v>
                </c:pt>
                <c:pt idx="1074">
                  <c:v>9.2230000000000008</c:v>
                </c:pt>
                <c:pt idx="1075">
                  <c:v>9.2289999999999992</c:v>
                </c:pt>
                <c:pt idx="1076">
                  <c:v>9.2349999999999994</c:v>
                </c:pt>
                <c:pt idx="1077">
                  <c:v>9.24</c:v>
                </c:pt>
                <c:pt idx="1078">
                  <c:v>9.2460000000000004</c:v>
                </c:pt>
                <c:pt idx="1079">
                  <c:v>9.2520000000000007</c:v>
                </c:pt>
                <c:pt idx="1080">
                  <c:v>9.2579999999999991</c:v>
                </c:pt>
                <c:pt idx="1081">
                  <c:v>9.2629999999999999</c:v>
                </c:pt>
                <c:pt idx="1082">
                  <c:v>9.2690000000000001</c:v>
                </c:pt>
                <c:pt idx="1083">
                  <c:v>9.2750000000000004</c:v>
                </c:pt>
                <c:pt idx="1084">
                  <c:v>9.2799999999999994</c:v>
                </c:pt>
                <c:pt idx="1085">
                  <c:v>9.2859999999999996</c:v>
                </c:pt>
                <c:pt idx="1086">
                  <c:v>9.2919999999999998</c:v>
                </c:pt>
                <c:pt idx="1087">
                  <c:v>9.298</c:v>
                </c:pt>
                <c:pt idx="1088">
                  <c:v>9.3030000000000008</c:v>
                </c:pt>
                <c:pt idx="1089">
                  <c:v>9.3089999999999993</c:v>
                </c:pt>
                <c:pt idx="1090">
                  <c:v>9.3149999999999995</c:v>
                </c:pt>
                <c:pt idx="1091">
                  <c:v>9.32</c:v>
                </c:pt>
                <c:pt idx="1092">
                  <c:v>9.3260000000000005</c:v>
                </c:pt>
                <c:pt idx="1093">
                  <c:v>9.3320000000000007</c:v>
                </c:pt>
                <c:pt idx="1094">
                  <c:v>9.3379999999999992</c:v>
                </c:pt>
                <c:pt idx="1095">
                  <c:v>9.343</c:v>
                </c:pt>
                <c:pt idx="1096">
                  <c:v>9.3490000000000002</c:v>
                </c:pt>
                <c:pt idx="1097">
                  <c:v>9.3550000000000004</c:v>
                </c:pt>
                <c:pt idx="1098">
                  <c:v>9.36</c:v>
                </c:pt>
                <c:pt idx="1099">
                  <c:v>9.3659999999999997</c:v>
                </c:pt>
                <c:pt idx="1100">
                  <c:v>9.3719999999999999</c:v>
                </c:pt>
                <c:pt idx="1101">
                  <c:v>9.3780000000000001</c:v>
                </c:pt>
                <c:pt idx="1102">
                  <c:v>9.3829999999999991</c:v>
                </c:pt>
                <c:pt idx="1103">
                  <c:v>9.3889999999999993</c:v>
                </c:pt>
                <c:pt idx="1104">
                  <c:v>9.3949999999999996</c:v>
                </c:pt>
                <c:pt idx="1105">
                  <c:v>9.4</c:v>
                </c:pt>
                <c:pt idx="1106">
                  <c:v>9.4060000000000006</c:v>
                </c:pt>
                <c:pt idx="1107">
                  <c:v>9.4120000000000008</c:v>
                </c:pt>
                <c:pt idx="1108">
                  <c:v>9.4179999999999993</c:v>
                </c:pt>
                <c:pt idx="1109">
                  <c:v>9.423</c:v>
                </c:pt>
                <c:pt idx="1110">
                  <c:v>9.4290000000000003</c:v>
                </c:pt>
                <c:pt idx="1111">
                  <c:v>9.4350000000000005</c:v>
                </c:pt>
                <c:pt idx="1112">
                  <c:v>9.4410000000000007</c:v>
                </c:pt>
                <c:pt idx="1113">
                  <c:v>9.4459999999999997</c:v>
                </c:pt>
                <c:pt idx="1114">
                  <c:v>9.452</c:v>
                </c:pt>
                <c:pt idx="1115">
                  <c:v>9.4580000000000002</c:v>
                </c:pt>
                <c:pt idx="1116">
                  <c:v>9.4629999999999992</c:v>
                </c:pt>
                <c:pt idx="1117">
                  <c:v>9.4689999999999994</c:v>
                </c:pt>
                <c:pt idx="1118">
                  <c:v>9.4749999999999996</c:v>
                </c:pt>
                <c:pt idx="1119">
                  <c:v>9.4809999999999999</c:v>
                </c:pt>
                <c:pt idx="1120">
                  <c:v>9.4860000000000007</c:v>
                </c:pt>
                <c:pt idx="1121">
                  <c:v>9.4920000000000009</c:v>
                </c:pt>
                <c:pt idx="1122">
                  <c:v>9.4979999999999993</c:v>
                </c:pt>
                <c:pt idx="1123">
                  <c:v>9.5030000000000001</c:v>
                </c:pt>
                <c:pt idx="1124">
                  <c:v>9.5090000000000003</c:v>
                </c:pt>
                <c:pt idx="1125">
                  <c:v>9.5150000000000006</c:v>
                </c:pt>
                <c:pt idx="1126">
                  <c:v>9.5210000000000008</c:v>
                </c:pt>
                <c:pt idx="1127">
                  <c:v>9.5259999999999998</c:v>
                </c:pt>
                <c:pt idx="1128">
                  <c:v>9.532</c:v>
                </c:pt>
                <c:pt idx="1129">
                  <c:v>9.5380000000000003</c:v>
                </c:pt>
                <c:pt idx="1130">
                  <c:v>9.5429999999999993</c:v>
                </c:pt>
                <c:pt idx="1131">
                  <c:v>9.5489999999999995</c:v>
                </c:pt>
                <c:pt idx="1132">
                  <c:v>9.5549999999999997</c:v>
                </c:pt>
                <c:pt idx="1133">
                  <c:v>9.5609999999999999</c:v>
                </c:pt>
                <c:pt idx="1134">
                  <c:v>9.5660000000000007</c:v>
                </c:pt>
                <c:pt idx="1135">
                  <c:v>9.5719999999999992</c:v>
                </c:pt>
                <c:pt idx="1136">
                  <c:v>9.5779999999999994</c:v>
                </c:pt>
                <c:pt idx="1137">
                  <c:v>9.5830000000000002</c:v>
                </c:pt>
                <c:pt idx="1138">
                  <c:v>9.5890000000000004</c:v>
                </c:pt>
                <c:pt idx="1139">
                  <c:v>9.5950000000000006</c:v>
                </c:pt>
                <c:pt idx="1140">
                  <c:v>9.6010000000000009</c:v>
                </c:pt>
                <c:pt idx="1141">
                  <c:v>9.6059999999999999</c:v>
                </c:pt>
                <c:pt idx="1142">
                  <c:v>9.6120000000000001</c:v>
                </c:pt>
                <c:pt idx="1143">
                  <c:v>9.6180000000000003</c:v>
                </c:pt>
                <c:pt idx="1144">
                  <c:v>9.6229999999999993</c:v>
                </c:pt>
                <c:pt idx="1145">
                  <c:v>9.6289999999999996</c:v>
                </c:pt>
                <c:pt idx="1146">
                  <c:v>9.6349999999999998</c:v>
                </c:pt>
                <c:pt idx="1147">
                  <c:v>9.641</c:v>
                </c:pt>
                <c:pt idx="1148">
                  <c:v>9.6460000000000008</c:v>
                </c:pt>
                <c:pt idx="1149">
                  <c:v>9.6519999999999992</c:v>
                </c:pt>
                <c:pt idx="1150">
                  <c:v>9.6579999999999995</c:v>
                </c:pt>
                <c:pt idx="1151">
                  <c:v>9.6630000000000003</c:v>
                </c:pt>
                <c:pt idx="1152">
                  <c:v>9.6690000000000005</c:v>
                </c:pt>
                <c:pt idx="1153">
                  <c:v>9.6750000000000007</c:v>
                </c:pt>
                <c:pt idx="1154">
                  <c:v>9.6809999999999992</c:v>
                </c:pt>
                <c:pt idx="1155">
                  <c:v>9.6859999999999999</c:v>
                </c:pt>
                <c:pt idx="1156">
                  <c:v>9.6920000000000002</c:v>
                </c:pt>
                <c:pt idx="1157">
                  <c:v>9.6980000000000004</c:v>
                </c:pt>
                <c:pt idx="1158">
                  <c:v>9.7029999999999994</c:v>
                </c:pt>
                <c:pt idx="1159">
                  <c:v>9.7089999999999996</c:v>
                </c:pt>
                <c:pt idx="1160">
                  <c:v>9.7149999999999999</c:v>
                </c:pt>
                <c:pt idx="1161">
                  <c:v>9.7210000000000001</c:v>
                </c:pt>
                <c:pt idx="1162">
                  <c:v>9.7260000000000009</c:v>
                </c:pt>
                <c:pt idx="1163">
                  <c:v>9.7319999999999993</c:v>
                </c:pt>
                <c:pt idx="1164">
                  <c:v>9.7379999999999995</c:v>
                </c:pt>
                <c:pt idx="1165">
                  <c:v>9.7430000000000003</c:v>
                </c:pt>
                <c:pt idx="1166">
                  <c:v>9.7490000000000006</c:v>
                </c:pt>
                <c:pt idx="1167">
                  <c:v>9.7550000000000008</c:v>
                </c:pt>
                <c:pt idx="1168">
                  <c:v>9.7609999999999992</c:v>
                </c:pt>
                <c:pt idx="1169">
                  <c:v>9.766</c:v>
                </c:pt>
                <c:pt idx="1170">
                  <c:v>9.7720000000000002</c:v>
                </c:pt>
                <c:pt idx="1171">
                  <c:v>9.7780000000000005</c:v>
                </c:pt>
                <c:pt idx="1172">
                  <c:v>9.7829999999999995</c:v>
                </c:pt>
                <c:pt idx="1173">
                  <c:v>9.7889999999999997</c:v>
                </c:pt>
                <c:pt idx="1174">
                  <c:v>9.7949999999999999</c:v>
                </c:pt>
                <c:pt idx="1175">
                  <c:v>9.8010000000000002</c:v>
                </c:pt>
                <c:pt idx="1176">
                  <c:v>9.8059999999999992</c:v>
                </c:pt>
                <c:pt idx="1177">
                  <c:v>9.8119999999999994</c:v>
                </c:pt>
                <c:pt idx="1178">
                  <c:v>9.8179999999999996</c:v>
                </c:pt>
                <c:pt idx="1179">
                  <c:v>9.8230000000000004</c:v>
                </c:pt>
                <c:pt idx="1180">
                  <c:v>9.8290000000000006</c:v>
                </c:pt>
                <c:pt idx="1181">
                  <c:v>9.8350000000000009</c:v>
                </c:pt>
                <c:pt idx="1182">
                  <c:v>9.8409999999999993</c:v>
                </c:pt>
                <c:pt idx="1183">
                  <c:v>9.8460000000000001</c:v>
                </c:pt>
                <c:pt idx="1184">
                  <c:v>9.8520000000000003</c:v>
                </c:pt>
                <c:pt idx="1185">
                  <c:v>9.8580000000000005</c:v>
                </c:pt>
                <c:pt idx="1186">
                  <c:v>9.8629999999999995</c:v>
                </c:pt>
                <c:pt idx="1187">
                  <c:v>9.8689999999999998</c:v>
                </c:pt>
                <c:pt idx="1188">
                  <c:v>9.875</c:v>
                </c:pt>
                <c:pt idx="1189">
                  <c:v>9.8810000000000002</c:v>
                </c:pt>
                <c:pt idx="1190">
                  <c:v>9.8859999999999992</c:v>
                </c:pt>
                <c:pt idx="1191">
                  <c:v>9.8919999999999995</c:v>
                </c:pt>
                <c:pt idx="1192">
                  <c:v>9.8979999999999997</c:v>
                </c:pt>
                <c:pt idx="1193">
                  <c:v>9.9030000000000005</c:v>
                </c:pt>
                <c:pt idx="1194">
                  <c:v>9.9090000000000007</c:v>
                </c:pt>
                <c:pt idx="1195">
                  <c:v>9.9149999999999991</c:v>
                </c:pt>
                <c:pt idx="1196">
                  <c:v>9.9209999999999994</c:v>
                </c:pt>
                <c:pt idx="1197">
                  <c:v>9.9260000000000002</c:v>
                </c:pt>
                <c:pt idx="1198">
                  <c:v>9.9320000000000004</c:v>
                </c:pt>
                <c:pt idx="1199">
                  <c:v>9.9380000000000006</c:v>
                </c:pt>
                <c:pt idx="1200">
                  <c:v>9.9429999999999996</c:v>
                </c:pt>
                <c:pt idx="1201">
                  <c:v>9.9489999999999998</c:v>
                </c:pt>
                <c:pt idx="1202">
                  <c:v>9.9550000000000001</c:v>
                </c:pt>
                <c:pt idx="1203">
                  <c:v>9.9610000000000003</c:v>
                </c:pt>
                <c:pt idx="1204">
                  <c:v>9.9659999999999993</c:v>
                </c:pt>
                <c:pt idx="1205">
                  <c:v>9.9719999999999995</c:v>
                </c:pt>
                <c:pt idx="1206">
                  <c:v>9.9779999999999998</c:v>
                </c:pt>
                <c:pt idx="1207">
                  <c:v>9.9830000000000005</c:v>
                </c:pt>
                <c:pt idx="1208">
                  <c:v>9.9890000000000008</c:v>
                </c:pt>
                <c:pt idx="1209">
                  <c:v>9.9949999999999992</c:v>
                </c:pt>
                <c:pt idx="1210">
                  <c:v>10.000999999999999</c:v>
                </c:pt>
                <c:pt idx="1211">
                  <c:v>10.006</c:v>
                </c:pt>
                <c:pt idx="1212">
                  <c:v>10.012</c:v>
                </c:pt>
                <c:pt idx="1213">
                  <c:v>10.018000000000001</c:v>
                </c:pt>
                <c:pt idx="1214">
                  <c:v>10.023</c:v>
                </c:pt>
                <c:pt idx="1215">
                  <c:v>10.029</c:v>
                </c:pt>
                <c:pt idx="1216">
                  <c:v>10.035</c:v>
                </c:pt>
                <c:pt idx="1217">
                  <c:v>10.041</c:v>
                </c:pt>
                <c:pt idx="1218">
                  <c:v>10.045999999999999</c:v>
                </c:pt>
                <c:pt idx="1219">
                  <c:v>10.052</c:v>
                </c:pt>
                <c:pt idx="1220">
                  <c:v>10.058</c:v>
                </c:pt>
                <c:pt idx="1221">
                  <c:v>10.063000000000001</c:v>
                </c:pt>
                <c:pt idx="1222">
                  <c:v>10.069000000000001</c:v>
                </c:pt>
                <c:pt idx="1223">
                  <c:v>10.074999999999999</c:v>
                </c:pt>
                <c:pt idx="1224">
                  <c:v>10.081</c:v>
                </c:pt>
                <c:pt idx="1225">
                  <c:v>10.086</c:v>
                </c:pt>
                <c:pt idx="1226">
                  <c:v>10.092000000000001</c:v>
                </c:pt>
                <c:pt idx="1227">
                  <c:v>10.098000000000001</c:v>
                </c:pt>
                <c:pt idx="1228">
                  <c:v>10.103</c:v>
                </c:pt>
                <c:pt idx="1229">
                  <c:v>10.109</c:v>
                </c:pt>
                <c:pt idx="1230">
                  <c:v>10.115</c:v>
                </c:pt>
                <c:pt idx="1231">
                  <c:v>10.121</c:v>
                </c:pt>
                <c:pt idx="1232">
                  <c:v>10.125999999999999</c:v>
                </c:pt>
                <c:pt idx="1233">
                  <c:v>10.132</c:v>
                </c:pt>
                <c:pt idx="1234">
                  <c:v>10.138</c:v>
                </c:pt>
                <c:pt idx="1235">
                  <c:v>10.143000000000001</c:v>
                </c:pt>
                <c:pt idx="1236">
                  <c:v>10.148999999999999</c:v>
                </c:pt>
                <c:pt idx="1237">
                  <c:v>10.154999999999999</c:v>
                </c:pt>
                <c:pt idx="1238">
                  <c:v>10.161</c:v>
                </c:pt>
                <c:pt idx="1239">
                  <c:v>10.166</c:v>
                </c:pt>
                <c:pt idx="1240">
                  <c:v>10.172000000000001</c:v>
                </c:pt>
                <c:pt idx="1241">
                  <c:v>10.178000000000001</c:v>
                </c:pt>
                <c:pt idx="1242">
                  <c:v>10.183</c:v>
                </c:pt>
                <c:pt idx="1243">
                  <c:v>10.189</c:v>
                </c:pt>
                <c:pt idx="1244">
                  <c:v>10.195</c:v>
                </c:pt>
                <c:pt idx="1245">
                  <c:v>10.201000000000001</c:v>
                </c:pt>
                <c:pt idx="1246">
                  <c:v>10.206</c:v>
                </c:pt>
                <c:pt idx="1247">
                  <c:v>10.212</c:v>
                </c:pt>
                <c:pt idx="1248">
                  <c:v>10.218</c:v>
                </c:pt>
                <c:pt idx="1249">
                  <c:v>10.224</c:v>
                </c:pt>
                <c:pt idx="1250">
                  <c:v>10.228999999999999</c:v>
                </c:pt>
                <c:pt idx="1251">
                  <c:v>10.234999999999999</c:v>
                </c:pt>
                <c:pt idx="1252">
                  <c:v>10.241</c:v>
                </c:pt>
                <c:pt idx="1253">
                  <c:v>10.246</c:v>
                </c:pt>
                <c:pt idx="1254">
                  <c:v>10.252000000000001</c:v>
                </c:pt>
                <c:pt idx="1255">
                  <c:v>10.257999999999999</c:v>
                </c:pt>
                <c:pt idx="1256">
                  <c:v>10.263999999999999</c:v>
                </c:pt>
                <c:pt idx="1257">
                  <c:v>10.269</c:v>
                </c:pt>
                <c:pt idx="1258">
                  <c:v>10.275</c:v>
                </c:pt>
                <c:pt idx="1259">
                  <c:v>10.281000000000001</c:v>
                </c:pt>
                <c:pt idx="1260">
                  <c:v>10.286</c:v>
                </c:pt>
                <c:pt idx="1261">
                  <c:v>10.292</c:v>
                </c:pt>
                <c:pt idx="1262">
                  <c:v>10.298</c:v>
                </c:pt>
                <c:pt idx="1263">
                  <c:v>10.304</c:v>
                </c:pt>
                <c:pt idx="1264">
                  <c:v>10.308999999999999</c:v>
                </c:pt>
                <c:pt idx="1265">
                  <c:v>10.315</c:v>
                </c:pt>
                <c:pt idx="1266">
                  <c:v>10.321</c:v>
                </c:pt>
                <c:pt idx="1267">
                  <c:v>10.326000000000001</c:v>
                </c:pt>
                <c:pt idx="1268">
                  <c:v>10.332000000000001</c:v>
                </c:pt>
                <c:pt idx="1269">
                  <c:v>10.337999999999999</c:v>
                </c:pt>
                <c:pt idx="1270">
                  <c:v>10.343999999999999</c:v>
                </c:pt>
                <c:pt idx="1271">
                  <c:v>10.349</c:v>
                </c:pt>
                <c:pt idx="1272">
                  <c:v>10.355</c:v>
                </c:pt>
                <c:pt idx="1273">
                  <c:v>10.361000000000001</c:v>
                </c:pt>
                <c:pt idx="1274">
                  <c:v>10.366</c:v>
                </c:pt>
                <c:pt idx="1275">
                  <c:v>10.372</c:v>
                </c:pt>
                <c:pt idx="1276">
                  <c:v>10.378</c:v>
                </c:pt>
                <c:pt idx="1277">
                  <c:v>10.384</c:v>
                </c:pt>
                <c:pt idx="1278">
                  <c:v>10.388999999999999</c:v>
                </c:pt>
                <c:pt idx="1279">
                  <c:v>10.395</c:v>
                </c:pt>
                <c:pt idx="1280">
                  <c:v>10.401</c:v>
                </c:pt>
                <c:pt idx="1281">
                  <c:v>10.406000000000001</c:v>
                </c:pt>
                <c:pt idx="1282">
                  <c:v>10.412000000000001</c:v>
                </c:pt>
                <c:pt idx="1283">
                  <c:v>10.417999999999999</c:v>
                </c:pt>
                <c:pt idx="1284">
                  <c:v>10.423999999999999</c:v>
                </c:pt>
                <c:pt idx="1285">
                  <c:v>10.429</c:v>
                </c:pt>
                <c:pt idx="1286">
                  <c:v>10.435</c:v>
                </c:pt>
                <c:pt idx="1287">
                  <c:v>10.441000000000001</c:v>
                </c:pt>
                <c:pt idx="1288">
                  <c:v>10.446</c:v>
                </c:pt>
                <c:pt idx="1289">
                  <c:v>10.452</c:v>
                </c:pt>
                <c:pt idx="1290">
                  <c:v>10.458</c:v>
                </c:pt>
                <c:pt idx="1291">
                  <c:v>10.464</c:v>
                </c:pt>
                <c:pt idx="1292">
                  <c:v>10.468999999999999</c:v>
                </c:pt>
                <c:pt idx="1293">
                  <c:v>10.475</c:v>
                </c:pt>
                <c:pt idx="1294">
                  <c:v>10.481</c:v>
                </c:pt>
                <c:pt idx="1295">
                  <c:v>10.486000000000001</c:v>
                </c:pt>
                <c:pt idx="1296">
                  <c:v>10.492000000000001</c:v>
                </c:pt>
                <c:pt idx="1297">
                  <c:v>10.497999999999999</c:v>
                </c:pt>
                <c:pt idx="1298">
                  <c:v>10.504</c:v>
                </c:pt>
                <c:pt idx="1299">
                  <c:v>10.509</c:v>
                </c:pt>
                <c:pt idx="1300">
                  <c:v>10.515000000000001</c:v>
                </c:pt>
                <c:pt idx="1301">
                  <c:v>10.521000000000001</c:v>
                </c:pt>
                <c:pt idx="1302">
                  <c:v>10.526</c:v>
                </c:pt>
                <c:pt idx="1303">
                  <c:v>10.532</c:v>
                </c:pt>
                <c:pt idx="1304">
                  <c:v>10.538</c:v>
                </c:pt>
                <c:pt idx="1305">
                  <c:v>10.544</c:v>
                </c:pt>
                <c:pt idx="1306">
                  <c:v>10.548999999999999</c:v>
                </c:pt>
                <c:pt idx="1307">
                  <c:v>10.555</c:v>
                </c:pt>
                <c:pt idx="1308">
                  <c:v>10.561</c:v>
                </c:pt>
                <c:pt idx="1309">
                  <c:v>10.566000000000001</c:v>
                </c:pt>
                <c:pt idx="1310">
                  <c:v>10.571999999999999</c:v>
                </c:pt>
                <c:pt idx="1311">
                  <c:v>10.577999999999999</c:v>
                </c:pt>
                <c:pt idx="1312">
                  <c:v>10.584</c:v>
                </c:pt>
                <c:pt idx="1313">
                  <c:v>10.589</c:v>
                </c:pt>
                <c:pt idx="1314">
                  <c:v>10.595000000000001</c:v>
                </c:pt>
                <c:pt idx="1315">
                  <c:v>10.601000000000001</c:v>
                </c:pt>
                <c:pt idx="1316">
                  <c:v>10.606</c:v>
                </c:pt>
                <c:pt idx="1317">
                  <c:v>10.612</c:v>
                </c:pt>
                <c:pt idx="1318">
                  <c:v>10.618</c:v>
                </c:pt>
                <c:pt idx="1319">
                  <c:v>10.624000000000001</c:v>
                </c:pt>
                <c:pt idx="1320">
                  <c:v>10.629</c:v>
                </c:pt>
                <c:pt idx="1321">
                  <c:v>10.635</c:v>
                </c:pt>
                <c:pt idx="1322">
                  <c:v>10.641</c:v>
                </c:pt>
                <c:pt idx="1323">
                  <c:v>10.646000000000001</c:v>
                </c:pt>
                <c:pt idx="1324">
                  <c:v>10.651999999999999</c:v>
                </c:pt>
                <c:pt idx="1325">
                  <c:v>10.657999999999999</c:v>
                </c:pt>
                <c:pt idx="1326">
                  <c:v>10.664</c:v>
                </c:pt>
                <c:pt idx="1327">
                  <c:v>10.669</c:v>
                </c:pt>
                <c:pt idx="1328">
                  <c:v>10.675000000000001</c:v>
                </c:pt>
                <c:pt idx="1329">
                  <c:v>10.680999999999999</c:v>
                </c:pt>
                <c:pt idx="1330">
                  <c:v>10.686</c:v>
                </c:pt>
                <c:pt idx="1331">
                  <c:v>10.692</c:v>
                </c:pt>
                <c:pt idx="1332">
                  <c:v>10.698</c:v>
                </c:pt>
                <c:pt idx="1333">
                  <c:v>10.704000000000001</c:v>
                </c:pt>
                <c:pt idx="1334">
                  <c:v>10.709</c:v>
                </c:pt>
                <c:pt idx="1335">
                  <c:v>10.715</c:v>
                </c:pt>
                <c:pt idx="1336">
                  <c:v>10.721</c:v>
                </c:pt>
                <c:pt idx="1337">
                  <c:v>10.726000000000001</c:v>
                </c:pt>
                <c:pt idx="1338">
                  <c:v>10.731999999999999</c:v>
                </c:pt>
                <c:pt idx="1339">
                  <c:v>10.738</c:v>
                </c:pt>
                <c:pt idx="1340">
                  <c:v>10.744</c:v>
                </c:pt>
                <c:pt idx="1341">
                  <c:v>10.749000000000001</c:v>
                </c:pt>
                <c:pt idx="1342">
                  <c:v>10.755000000000001</c:v>
                </c:pt>
                <c:pt idx="1343">
                  <c:v>10.760999999999999</c:v>
                </c:pt>
                <c:pt idx="1344">
                  <c:v>10.766</c:v>
                </c:pt>
                <c:pt idx="1345">
                  <c:v>10.772</c:v>
                </c:pt>
                <c:pt idx="1346">
                  <c:v>10.778</c:v>
                </c:pt>
                <c:pt idx="1347">
                  <c:v>10.784000000000001</c:v>
                </c:pt>
                <c:pt idx="1348">
                  <c:v>10.789</c:v>
                </c:pt>
                <c:pt idx="1349">
                  <c:v>10.795</c:v>
                </c:pt>
                <c:pt idx="1350">
                  <c:v>10.801</c:v>
                </c:pt>
                <c:pt idx="1351">
                  <c:v>10.805999999999999</c:v>
                </c:pt>
                <c:pt idx="1352">
                  <c:v>10.811999999999999</c:v>
                </c:pt>
                <c:pt idx="1353">
                  <c:v>10.818</c:v>
                </c:pt>
                <c:pt idx="1354">
                  <c:v>10.824</c:v>
                </c:pt>
                <c:pt idx="1355">
                  <c:v>10.829000000000001</c:v>
                </c:pt>
                <c:pt idx="1356">
                  <c:v>10.835000000000001</c:v>
                </c:pt>
                <c:pt idx="1357">
                  <c:v>10.840999999999999</c:v>
                </c:pt>
                <c:pt idx="1358">
                  <c:v>10.846</c:v>
                </c:pt>
                <c:pt idx="1359">
                  <c:v>10.852</c:v>
                </c:pt>
                <c:pt idx="1360">
                  <c:v>10.858000000000001</c:v>
                </c:pt>
                <c:pt idx="1361">
                  <c:v>10.864000000000001</c:v>
                </c:pt>
                <c:pt idx="1362">
                  <c:v>10.869</c:v>
                </c:pt>
                <c:pt idx="1363">
                  <c:v>10.875</c:v>
                </c:pt>
                <c:pt idx="1364">
                  <c:v>10.881</c:v>
                </c:pt>
                <c:pt idx="1365">
                  <c:v>10.885999999999999</c:v>
                </c:pt>
                <c:pt idx="1366">
                  <c:v>10.891999999999999</c:v>
                </c:pt>
                <c:pt idx="1367">
                  <c:v>10.898</c:v>
                </c:pt>
                <c:pt idx="1368">
                  <c:v>10.904</c:v>
                </c:pt>
                <c:pt idx="1369">
                  <c:v>10.909000000000001</c:v>
                </c:pt>
                <c:pt idx="1370">
                  <c:v>10.914999999999999</c:v>
                </c:pt>
                <c:pt idx="1371">
                  <c:v>10.920999999999999</c:v>
                </c:pt>
                <c:pt idx="1372">
                  <c:v>10.926</c:v>
                </c:pt>
                <c:pt idx="1373">
                  <c:v>10.932</c:v>
                </c:pt>
                <c:pt idx="1374">
                  <c:v>10.938000000000001</c:v>
                </c:pt>
                <c:pt idx="1375">
                  <c:v>10.944000000000001</c:v>
                </c:pt>
                <c:pt idx="1376">
                  <c:v>10.949</c:v>
                </c:pt>
                <c:pt idx="1377">
                  <c:v>10.955</c:v>
                </c:pt>
                <c:pt idx="1378">
                  <c:v>10.961</c:v>
                </c:pt>
                <c:pt idx="1379">
                  <c:v>10.965999999999999</c:v>
                </c:pt>
                <c:pt idx="1380">
                  <c:v>10.972</c:v>
                </c:pt>
                <c:pt idx="1381">
                  <c:v>10.978</c:v>
                </c:pt>
                <c:pt idx="1382">
                  <c:v>10.984</c:v>
                </c:pt>
                <c:pt idx="1383">
                  <c:v>10.989000000000001</c:v>
                </c:pt>
                <c:pt idx="1384">
                  <c:v>10.994999999999999</c:v>
                </c:pt>
                <c:pt idx="1385">
                  <c:v>11.000999999999999</c:v>
                </c:pt>
              </c:numCache>
            </c:numRef>
          </c:xVal>
          <c:yVal>
            <c:numRef>
              <c:f>'FbBbC4Tri11 + 3OAc #8'!$B$4:$B$1389</c:f>
              <c:numCache>
                <c:formatCode>General</c:formatCode>
                <c:ptCount val="1386"/>
                <c:pt idx="0">
                  <c:v>2946</c:v>
                </c:pt>
                <c:pt idx="1">
                  <c:v>2566</c:v>
                </c:pt>
                <c:pt idx="2">
                  <c:v>1648</c:v>
                </c:pt>
                <c:pt idx="3">
                  <c:v>1513</c:v>
                </c:pt>
                <c:pt idx="4">
                  <c:v>1811</c:v>
                </c:pt>
                <c:pt idx="5">
                  <c:v>1696</c:v>
                </c:pt>
                <c:pt idx="6">
                  <c:v>1454</c:v>
                </c:pt>
                <c:pt idx="7">
                  <c:v>1610</c:v>
                </c:pt>
                <c:pt idx="8">
                  <c:v>1695</c:v>
                </c:pt>
                <c:pt idx="9">
                  <c:v>1677</c:v>
                </c:pt>
                <c:pt idx="10">
                  <c:v>1218</c:v>
                </c:pt>
                <c:pt idx="11">
                  <c:v>856</c:v>
                </c:pt>
                <c:pt idx="12">
                  <c:v>1221</c:v>
                </c:pt>
                <c:pt idx="13">
                  <c:v>832</c:v>
                </c:pt>
                <c:pt idx="14">
                  <c:v>1095</c:v>
                </c:pt>
                <c:pt idx="15">
                  <c:v>1360</c:v>
                </c:pt>
                <c:pt idx="16">
                  <c:v>1592</c:v>
                </c:pt>
                <c:pt idx="17">
                  <c:v>1097</c:v>
                </c:pt>
                <c:pt idx="18">
                  <c:v>1109</c:v>
                </c:pt>
                <c:pt idx="19">
                  <c:v>1010</c:v>
                </c:pt>
                <c:pt idx="20">
                  <c:v>773</c:v>
                </c:pt>
                <c:pt idx="21">
                  <c:v>705</c:v>
                </c:pt>
                <c:pt idx="22">
                  <c:v>572</c:v>
                </c:pt>
                <c:pt idx="23">
                  <c:v>485</c:v>
                </c:pt>
                <c:pt idx="24">
                  <c:v>488</c:v>
                </c:pt>
                <c:pt idx="25">
                  <c:v>475</c:v>
                </c:pt>
                <c:pt idx="26">
                  <c:v>464</c:v>
                </c:pt>
                <c:pt idx="27">
                  <c:v>372</c:v>
                </c:pt>
                <c:pt idx="28">
                  <c:v>739</c:v>
                </c:pt>
                <c:pt idx="29">
                  <c:v>161</c:v>
                </c:pt>
                <c:pt idx="30">
                  <c:v>592</c:v>
                </c:pt>
                <c:pt idx="31">
                  <c:v>556</c:v>
                </c:pt>
                <c:pt idx="32">
                  <c:v>385</c:v>
                </c:pt>
                <c:pt idx="33">
                  <c:v>230</c:v>
                </c:pt>
                <c:pt idx="34">
                  <c:v>199</c:v>
                </c:pt>
                <c:pt idx="35">
                  <c:v>419</c:v>
                </c:pt>
                <c:pt idx="36">
                  <c:v>231</c:v>
                </c:pt>
                <c:pt idx="37">
                  <c:v>0</c:v>
                </c:pt>
                <c:pt idx="38">
                  <c:v>334</c:v>
                </c:pt>
                <c:pt idx="39">
                  <c:v>191</c:v>
                </c:pt>
                <c:pt idx="40">
                  <c:v>208</c:v>
                </c:pt>
                <c:pt idx="41">
                  <c:v>0</c:v>
                </c:pt>
                <c:pt idx="42">
                  <c:v>233</c:v>
                </c:pt>
                <c:pt idx="43">
                  <c:v>354</c:v>
                </c:pt>
                <c:pt idx="44">
                  <c:v>392</c:v>
                </c:pt>
                <c:pt idx="45">
                  <c:v>0</c:v>
                </c:pt>
                <c:pt idx="46">
                  <c:v>175</c:v>
                </c:pt>
                <c:pt idx="47">
                  <c:v>204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165</c:v>
                </c:pt>
                <c:pt idx="53">
                  <c:v>155</c:v>
                </c:pt>
                <c:pt idx="54">
                  <c:v>156</c:v>
                </c:pt>
                <c:pt idx="55">
                  <c:v>175</c:v>
                </c:pt>
                <c:pt idx="56">
                  <c:v>0</c:v>
                </c:pt>
                <c:pt idx="57">
                  <c:v>152</c:v>
                </c:pt>
                <c:pt idx="58">
                  <c:v>0</c:v>
                </c:pt>
                <c:pt idx="59">
                  <c:v>159</c:v>
                </c:pt>
                <c:pt idx="60">
                  <c:v>0</c:v>
                </c:pt>
                <c:pt idx="61">
                  <c:v>0</c:v>
                </c:pt>
                <c:pt idx="62">
                  <c:v>156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156</c:v>
                </c:pt>
                <c:pt idx="67">
                  <c:v>151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18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153</c:v>
                </c:pt>
                <c:pt idx="79">
                  <c:v>0</c:v>
                </c:pt>
                <c:pt idx="80">
                  <c:v>0</c:v>
                </c:pt>
                <c:pt idx="81">
                  <c:v>178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183</c:v>
                </c:pt>
                <c:pt idx="86">
                  <c:v>0</c:v>
                </c:pt>
                <c:pt idx="87">
                  <c:v>419</c:v>
                </c:pt>
                <c:pt idx="88">
                  <c:v>1088</c:v>
                </c:pt>
                <c:pt idx="89">
                  <c:v>1704</c:v>
                </c:pt>
                <c:pt idx="90">
                  <c:v>768</c:v>
                </c:pt>
                <c:pt idx="91">
                  <c:v>172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152</c:v>
                </c:pt>
                <c:pt idx="96">
                  <c:v>0</c:v>
                </c:pt>
                <c:pt idx="97">
                  <c:v>164</c:v>
                </c:pt>
                <c:pt idx="98">
                  <c:v>0</c:v>
                </c:pt>
                <c:pt idx="99">
                  <c:v>158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196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7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174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37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69</c:v>
                </c:pt>
                <c:pt idx="124">
                  <c:v>150</c:v>
                </c:pt>
                <c:pt idx="125">
                  <c:v>0</c:v>
                </c:pt>
                <c:pt idx="126">
                  <c:v>197</c:v>
                </c:pt>
                <c:pt idx="127">
                  <c:v>156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169</c:v>
                </c:pt>
                <c:pt idx="148">
                  <c:v>0</c:v>
                </c:pt>
                <c:pt idx="149">
                  <c:v>0</c:v>
                </c:pt>
                <c:pt idx="150">
                  <c:v>445</c:v>
                </c:pt>
                <c:pt idx="151">
                  <c:v>2032</c:v>
                </c:pt>
                <c:pt idx="152">
                  <c:v>2631</c:v>
                </c:pt>
                <c:pt idx="153">
                  <c:v>1500</c:v>
                </c:pt>
                <c:pt idx="154">
                  <c:v>17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167</c:v>
                </c:pt>
                <c:pt idx="159">
                  <c:v>0</c:v>
                </c:pt>
                <c:pt idx="160">
                  <c:v>0</c:v>
                </c:pt>
                <c:pt idx="161">
                  <c:v>153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173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305</c:v>
                </c:pt>
                <c:pt idx="173">
                  <c:v>0</c:v>
                </c:pt>
                <c:pt idx="174">
                  <c:v>188</c:v>
                </c:pt>
                <c:pt idx="175">
                  <c:v>0</c:v>
                </c:pt>
                <c:pt idx="176">
                  <c:v>169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169</c:v>
                </c:pt>
                <c:pt idx="183">
                  <c:v>0</c:v>
                </c:pt>
                <c:pt idx="184">
                  <c:v>0</c:v>
                </c:pt>
                <c:pt idx="185">
                  <c:v>163</c:v>
                </c:pt>
                <c:pt idx="186">
                  <c:v>0</c:v>
                </c:pt>
                <c:pt idx="187">
                  <c:v>0</c:v>
                </c:pt>
                <c:pt idx="188">
                  <c:v>412</c:v>
                </c:pt>
                <c:pt idx="189">
                  <c:v>0</c:v>
                </c:pt>
                <c:pt idx="190">
                  <c:v>0</c:v>
                </c:pt>
                <c:pt idx="191">
                  <c:v>193</c:v>
                </c:pt>
                <c:pt idx="192">
                  <c:v>307</c:v>
                </c:pt>
                <c:pt idx="193">
                  <c:v>0</c:v>
                </c:pt>
                <c:pt idx="194">
                  <c:v>0</c:v>
                </c:pt>
                <c:pt idx="195">
                  <c:v>177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487</c:v>
                </c:pt>
                <c:pt idx="200">
                  <c:v>211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196</c:v>
                </c:pt>
                <c:pt idx="205">
                  <c:v>0</c:v>
                </c:pt>
                <c:pt idx="206">
                  <c:v>740</c:v>
                </c:pt>
                <c:pt idx="207">
                  <c:v>299</c:v>
                </c:pt>
                <c:pt idx="208">
                  <c:v>649</c:v>
                </c:pt>
                <c:pt idx="209">
                  <c:v>167</c:v>
                </c:pt>
                <c:pt idx="210">
                  <c:v>199</c:v>
                </c:pt>
                <c:pt idx="211">
                  <c:v>0</c:v>
                </c:pt>
                <c:pt idx="212">
                  <c:v>0</c:v>
                </c:pt>
                <c:pt idx="213">
                  <c:v>388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371</c:v>
                </c:pt>
                <c:pt idx="218">
                  <c:v>851</c:v>
                </c:pt>
                <c:pt idx="219">
                  <c:v>1119</c:v>
                </c:pt>
                <c:pt idx="220">
                  <c:v>732</c:v>
                </c:pt>
                <c:pt idx="221">
                  <c:v>520</c:v>
                </c:pt>
                <c:pt idx="222">
                  <c:v>0</c:v>
                </c:pt>
                <c:pt idx="223">
                  <c:v>152</c:v>
                </c:pt>
                <c:pt idx="224">
                  <c:v>0</c:v>
                </c:pt>
                <c:pt idx="225">
                  <c:v>150</c:v>
                </c:pt>
                <c:pt idx="226">
                  <c:v>199</c:v>
                </c:pt>
                <c:pt idx="227">
                  <c:v>0</c:v>
                </c:pt>
                <c:pt idx="228">
                  <c:v>158</c:v>
                </c:pt>
                <c:pt idx="229">
                  <c:v>151</c:v>
                </c:pt>
                <c:pt idx="230">
                  <c:v>0</c:v>
                </c:pt>
                <c:pt idx="231">
                  <c:v>191</c:v>
                </c:pt>
                <c:pt idx="232">
                  <c:v>316</c:v>
                </c:pt>
                <c:pt idx="233">
                  <c:v>346</c:v>
                </c:pt>
                <c:pt idx="234">
                  <c:v>330</c:v>
                </c:pt>
                <c:pt idx="235">
                  <c:v>0</c:v>
                </c:pt>
                <c:pt idx="236">
                  <c:v>0</c:v>
                </c:pt>
                <c:pt idx="237">
                  <c:v>322</c:v>
                </c:pt>
                <c:pt idx="238">
                  <c:v>0</c:v>
                </c:pt>
                <c:pt idx="239">
                  <c:v>167</c:v>
                </c:pt>
                <c:pt idx="240">
                  <c:v>336</c:v>
                </c:pt>
                <c:pt idx="241">
                  <c:v>209</c:v>
                </c:pt>
                <c:pt idx="242">
                  <c:v>0</c:v>
                </c:pt>
                <c:pt idx="243">
                  <c:v>0</c:v>
                </c:pt>
                <c:pt idx="244">
                  <c:v>159</c:v>
                </c:pt>
                <c:pt idx="245">
                  <c:v>158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150</c:v>
                </c:pt>
                <c:pt idx="252">
                  <c:v>16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697</c:v>
                </c:pt>
                <c:pt idx="258">
                  <c:v>209</c:v>
                </c:pt>
                <c:pt idx="259">
                  <c:v>0</c:v>
                </c:pt>
                <c:pt idx="260">
                  <c:v>171</c:v>
                </c:pt>
                <c:pt idx="261">
                  <c:v>310</c:v>
                </c:pt>
                <c:pt idx="262">
                  <c:v>0</c:v>
                </c:pt>
                <c:pt idx="263">
                  <c:v>508</c:v>
                </c:pt>
                <c:pt idx="264">
                  <c:v>169</c:v>
                </c:pt>
                <c:pt idx="265">
                  <c:v>0</c:v>
                </c:pt>
                <c:pt idx="266">
                  <c:v>161</c:v>
                </c:pt>
                <c:pt idx="267">
                  <c:v>0</c:v>
                </c:pt>
                <c:pt idx="268">
                  <c:v>156</c:v>
                </c:pt>
                <c:pt idx="269">
                  <c:v>523</c:v>
                </c:pt>
                <c:pt idx="270">
                  <c:v>369</c:v>
                </c:pt>
                <c:pt idx="271">
                  <c:v>198</c:v>
                </c:pt>
                <c:pt idx="272">
                  <c:v>174</c:v>
                </c:pt>
                <c:pt idx="273">
                  <c:v>509</c:v>
                </c:pt>
                <c:pt idx="274">
                  <c:v>0</c:v>
                </c:pt>
                <c:pt idx="275">
                  <c:v>379</c:v>
                </c:pt>
                <c:pt idx="276">
                  <c:v>721</c:v>
                </c:pt>
                <c:pt idx="277">
                  <c:v>752</c:v>
                </c:pt>
                <c:pt idx="278">
                  <c:v>545</c:v>
                </c:pt>
                <c:pt idx="279">
                  <c:v>195</c:v>
                </c:pt>
                <c:pt idx="280">
                  <c:v>371</c:v>
                </c:pt>
                <c:pt idx="281">
                  <c:v>310</c:v>
                </c:pt>
                <c:pt idx="282">
                  <c:v>474</c:v>
                </c:pt>
                <c:pt idx="283">
                  <c:v>414</c:v>
                </c:pt>
                <c:pt idx="284">
                  <c:v>0</c:v>
                </c:pt>
                <c:pt idx="285">
                  <c:v>693</c:v>
                </c:pt>
                <c:pt idx="286">
                  <c:v>549</c:v>
                </c:pt>
                <c:pt idx="287">
                  <c:v>404</c:v>
                </c:pt>
                <c:pt idx="288">
                  <c:v>170</c:v>
                </c:pt>
                <c:pt idx="289">
                  <c:v>214</c:v>
                </c:pt>
                <c:pt idx="290">
                  <c:v>1220</c:v>
                </c:pt>
                <c:pt idx="291">
                  <c:v>1108</c:v>
                </c:pt>
                <c:pt idx="292">
                  <c:v>901</c:v>
                </c:pt>
                <c:pt idx="293">
                  <c:v>1193</c:v>
                </c:pt>
                <c:pt idx="294">
                  <c:v>691</c:v>
                </c:pt>
                <c:pt idx="295">
                  <c:v>507</c:v>
                </c:pt>
                <c:pt idx="296">
                  <c:v>152</c:v>
                </c:pt>
                <c:pt idx="297">
                  <c:v>168</c:v>
                </c:pt>
                <c:pt idx="298">
                  <c:v>402</c:v>
                </c:pt>
                <c:pt idx="299">
                  <c:v>354</c:v>
                </c:pt>
                <c:pt idx="300">
                  <c:v>346</c:v>
                </c:pt>
                <c:pt idx="301">
                  <c:v>0</c:v>
                </c:pt>
                <c:pt idx="302">
                  <c:v>0</c:v>
                </c:pt>
                <c:pt idx="303">
                  <c:v>170</c:v>
                </c:pt>
                <c:pt idx="304">
                  <c:v>329</c:v>
                </c:pt>
                <c:pt idx="305">
                  <c:v>0</c:v>
                </c:pt>
                <c:pt idx="306">
                  <c:v>560</c:v>
                </c:pt>
                <c:pt idx="307">
                  <c:v>580</c:v>
                </c:pt>
                <c:pt idx="308">
                  <c:v>180</c:v>
                </c:pt>
                <c:pt idx="309">
                  <c:v>559</c:v>
                </c:pt>
                <c:pt idx="310">
                  <c:v>319</c:v>
                </c:pt>
                <c:pt idx="311">
                  <c:v>267</c:v>
                </c:pt>
                <c:pt idx="312">
                  <c:v>578</c:v>
                </c:pt>
                <c:pt idx="313">
                  <c:v>643</c:v>
                </c:pt>
                <c:pt idx="314">
                  <c:v>167</c:v>
                </c:pt>
                <c:pt idx="315">
                  <c:v>390</c:v>
                </c:pt>
                <c:pt idx="316">
                  <c:v>179</c:v>
                </c:pt>
                <c:pt idx="317">
                  <c:v>151</c:v>
                </c:pt>
                <c:pt idx="318">
                  <c:v>566</c:v>
                </c:pt>
                <c:pt idx="319">
                  <c:v>966</c:v>
                </c:pt>
                <c:pt idx="320">
                  <c:v>566</c:v>
                </c:pt>
                <c:pt idx="321">
                  <c:v>445</c:v>
                </c:pt>
                <c:pt idx="322">
                  <c:v>174</c:v>
                </c:pt>
                <c:pt idx="323">
                  <c:v>659</c:v>
                </c:pt>
                <c:pt idx="324">
                  <c:v>679</c:v>
                </c:pt>
                <c:pt idx="325">
                  <c:v>496</c:v>
                </c:pt>
                <c:pt idx="326">
                  <c:v>461</c:v>
                </c:pt>
                <c:pt idx="327">
                  <c:v>7556</c:v>
                </c:pt>
                <c:pt idx="328">
                  <c:v>20857</c:v>
                </c:pt>
                <c:pt idx="329">
                  <c:v>25523</c:v>
                </c:pt>
                <c:pt idx="330">
                  <c:v>12256</c:v>
                </c:pt>
                <c:pt idx="331">
                  <c:v>3412</c:v>
                </c:pt>
                <c:pt idx="332">
                  <c:v>1678</c:v>
                </c:pt>
                <c:pt idx="333">
                  <c:v>1206</c:v>
                </c:pt>
                <c:pt idx="334">
                  <c:v>879</c:v>
                </c:pt>
                <c:pt idx="335">
                  <c:v>887</c:v>
                </c:pt>
                <c:pt idx="336">
                  <c:v>788</c:v>
                </c:pt>
                <c:pt idx="337">
                  <c:v>440</c:v>
                </c:pt>
                <c:pt idx="338">
                  <c:v>896</c:v>
                </c:pt>
                <c:pt idx="339">
                  <c:v>2199</c:v>
                </c:pt>
                <c:pt idx="340">
                  <c:v>1963</c:v>
                </c:pt>
                <c:pt idx="341">
                  <c:v>977</c:v>
                </c:pt>
                <c:pt idx="342">
                  <c:v>1038</c:v>
                </c:pt>
                <c:pt idx="343">
                  <c:v>885</c:v>
                </c:pt>
                <c:pt idx="344">
                  <c:v>1459</c:v>
                </c:pt>
                <c:pt idx="345">
                  <c:v>812</c:v>
                </c:pt>
                <c:pt idx="346">
                  <c:v>406</c:v>
                </c:pt>
                <c:pt idx="347">
                  <c:v>325</c:v>
                </c:pt>
                <c:pt idx="348">
                  <c:v>586</c:v>
                </c:pt>
                <c:pt idx="349">
                  <c:v>780</c:v>
                </c:pt>
                <c:pt idx="350">
                  <c:v>975</c:v>
                </c:pt>
                <c:pt idx="351">
                  <c:v>983</c:v>
                </c:pt>
                <c:pt idx="352">
                  <c:v>752</c:v>
                </c:pt>
                <c:pt idx="353">
                  <c:v>1164</c:v>
                </c:pt>
                <c:pt idx="354">
                  <c:v>1467</c:v>
                </c:pt>
                <c:pt idx="355">
                  <c:v>528</c:v>
                </c:pt>
                <c:pt idx="356">
                  <c:v>315</c:v>
                </c:pt>
                <c:pt idx="357">
                  <c:v>1202</c:v>
                </c:pt>
                <c:pt idx="358">
                  <c:v>429</c:v>
                </c:pt>
                <c:pt idx="359">
                  <c:v>1672</c:v>
                </c:pt>
                <c:pt idx="360">
                  <c:v>702</c:v>
                </c:pt>
                <c:pt idx="361">
                  <c:v>1110</c:v>
                </c:pt>
                <c:pt idx="362">
                  <c:v>568</c:v>
                </c:pt>
                <c:pt idx="363">
                  <c:v>890</c:v>
                </c:pt>
                <c:pt idx="364">
                  <c:v>1043</c:v>
                </c:pt>
                <c:pt idx="365">
                  <c:v>1145</c:v>
                </c:pt>
                <c:pt idx="366">
                  <c:v>548</c:v>
                </c:pt>
                <c:pt idx="367">
                  <c:v>952</c:v>
                </c:pt>
                <c:pt idx="368">
                  <c:v>498</c:v>
                </c:pt>
                <c:pt idx="369">
                  <c:v>1010</c:v>
                </c:pt>
                <c:pt idx="370">
                  <c:v>1472</c:v>
                </c:pt>
                <c:pt idx="371">
                  <c:v>501</c:v>
                </c:pt>
                <c:pt idx="372">
                  <c:v>984</c:v>
                </c:pt>
                <c:pt idx="373">
                  <c:v>1050</c:v>
                </c:pt>
                <c:pt idx="374">
                  <c:v>1373</c:v>
                </c:pt>
                <c:pt idx="375">
                  <c:v>2215</c:v>
                </c:pt>
                <c:pt idx="376">
                  <c:v>939</c:v>
                </c:pt>
                <c:pt idx="377">
                  <c:v>881</c:v>
                </c:pt>
                <c:pt idx="378">
                  <c:v>393</c:v>
                </c:pt>
                <c:pt idx="379">
                  <c:v>1181</c:v>
                </c:pt>
                <c:pt idx="380">
                  <c:v>948</c:v>
                </c:pt>
                <c:pt idx="381">
                  <c:v>1209</c:v>
                </c:pt>
                <c:pt idx="382">
                  <c:v>1372</c:v>
                </c:pt>
                <c:pt idx="383">
                  <c:v>1566</c:v>
                </c:pt>
                <c:pt idx="384">
                  <c:v>684</c:v>
                </c:pt>
                <c:pt idx="385">
                  <c:v>1033</c:v>
                </c:pt>
                <c:pt idx="386">
                  <c:v>1190</c:v>
                </c:pt>
                <c:pt idx="387">
                  <c:v>1659</c:v>
                </c:pt>
                <c:pt idx="388">
                  <c:v>2008</c:v>
                </c:pt>
                <c:pt idx="389">
                  <c:v>1687</c:v>
                </c:pt>
                <c:pt idx="390">
                  <c:v>1549</c:v>
                </c:pt>
                <c:pt idx="391">
                  <c:v>1892</c:v>
                </c:pt>
                <c:pt idx="392">
                  <c:v>986</c:v>
                </c:pt>
                <c:pt idx="393">
                  <c:v>1176</c:v>
                </c:pt>
                <c:pt idx="394">
                  <c:v>1212</c:v>
                </c:pt>
                <c:pt idx="395">
                  <c:v>1574</c:v>
                </c:pt>
                <c:pt idx="396">
                  <c:v>1069</c:v>
                </c:pt>
                <c:pt idx="397">
                  <c:v>883</c:v>
                </c:pt>
                <c:pt idx="398">
                  <c:v>1175</c:v>
                </c:pt>
                <c:pt idx="399">
                  <c:v>1648</c:v>
                </c:pt>
                <c:pt idx="400">
                  <c:v>2009</c:v>
                </c:pt>
                <c:pt idx="401">
                  <c:v>4541</c:v>
                </c:pt>
                <c:pt idx="402">
                  <c:v>5276</c:v>
                </c:pt>
                <c:pt idx="403">
                  <c:v>6421</c:v>
                </c:pt>
                <c:pt idx="404">
                  <c:v>5025</c:v>
                </c:pt>
                <c:pt idx="405">
                  <c:v>3766</c:v>
                </c:pt>
                <c:pt idx="406">
                  <c:v>2966</c:v>
                </c:pt>
                <c:pt idx="407">
                  <c:v>1978</c:v>
                </c:pt>
                <c:pt idx="408">
                  <c:v>2420</c:v>
                </c:pt>
                <c:pt idx="409">
                  <c:v>1705</c:v>
                </c:pt>
                <c:pt idx="410">
                  <c:v>1911</c:v>
                </c:pt>
                <c:pt idx="411">
                  <c:v>1232</c:v>
                </c:pt>
                <c:pt idx="412">
                  <c:v>1671</c:v>
                </c:pt>
                <c:pt idx="413">
                  <c:v>1772</c:v>
                </c:pt>
                <c:pt idx="414">
                  <c:v>2172</c:v>
                </c:pt>
                <c:pt idx="415">
                  <c:v>2192</c:v>
                </c:pt>
                <c:pt idx="416">
                  <c:v>1653</c:v>
                </c:pt>
                <c:pt idx="417">
                  <c:v>2038</c:v>
                </c:pt>
                <c:pt idx="418">
                  <c:v>2199</c:v>
                </c:pt>
                <c:pt idx="419">
                  <c:v>2065</c:v>
                </c:pt>
                <c:pt idx="420">
                  <c:v>2006</c:v>
                </c:pt>
                <c:pt idx="421">
                  <c:v>1943</c:v>
                </c:pt>
                <c:pt idx="422">
                  <c:v>1146</c:v>
                </c:pt>
                <c:pt idx="423">
                  <c:v>1977</c:v>
                </c:pt>
                <c:pt idx="424">
                  <c:v>2708</c:v>
                </c:pt>
                <c:pt idx="425">
                  <c:v>2740</c:v>
                </c:pt>
                <c:pt idx="426">
                  <c:v>2000</c:v>
                </c:pt>
                <c:pt idx="427">
                  <c:v>1694</c:v>
                </c:pt>
                <c:pt idx="428">
                  <c:v>2552</c:v>
                </c:pt>
                <c:pt idx="429">
                  <c:v>2636</c:v>
                </c:pt>
                <c:pt idx="430">
                  <c:v>2106</c:v>
                </c:pt>
                <c:pt idx="431">
                  <c:v>2501</c:v>
                </c:pt>
                <c:pt idx="432">
                  <c:v>2078</c:v>
                </c:pt>
                <c:pt idx="433">
                  <c:v>2336</c:v>
                </c:pt>
                <c:pt idx="434">
                  <c:v>1737</c:v>
                </c:pt>
                <c:pt idx="435">
                  <c:v>3368</c:v>
                </c:pt>
                <c:pt idx="436">
                  <c:v>1866</c:v>
                </c:pt>
                <c:pt idx="437">
                  <c:v>2582</c:v>
                </c:pt>
                <c:pt idx="438">
                  <c:v>2757</c:v>
                </c:pt>
                <c:pt idx="439">
                  <c:v>2018</c:v>
                </c:pt>
                <c:pt idx="440">
                  <c:v>3009</c:v>
                </c:pt>
                <c:pt idx="441">
                  <c:v>2880</c:v>
                </c:pt>
                <c:pt idx="442">
                  <c:v>2550</c:v>
                </c:pt>
                <c:pt idx="443">
                  <c:v>3022</c:v>
                </c:pt>
                <c:pt idx="444">
                  <c:v>2456</c:v>
                </c:pt>
                <c:pt idx="445">
                  <c:v>2883</c:v>
                </c:pt>
                <c:pt idx="446">
                  <c:v>2867</c:v>
                </c:pt>
                <c:pt idx="447">
                  <c:v>2669</c:v>
                </c:pt>
                <c:pt idx="448">
                  <c:v>1719</c:v>
                </c:pt>
                <c:pt idx="449">
                  <c:v>2220</c:v>
                </c:pt>
                <c:pt idx="450">
                  <c:v>2301</c:v>
                </c:pt>
                <c:pt idx="451">
                  <c:v>2137</c:v>
                </c:pt>
                <c:pt idx="452">
                  <c:v>2836</c:v>
                </c:pt>
                <c:pt idx="453">
                  <c:v>2668</c:v>
                </c:pt>
                <c:pt idx="454">
                  <c:v>2277</c:v>
                </c:pt>
                <c:pt idx="455">
                  <c:v>2792</c:v>
                </c:pt>
                <c:pt idx="456">
                  <c:v>3333</c:v>
                </c:pt>
                <c:pt idx="457">
                  <c:v>3760</c:v>
                </c:pt>
                <c:pt idx="458">
                  <c:v>3940</c:v>
                </c:pt>
                <c:pt idx="459">
                  <c:v>3466</c:v>
                </c:pt>
                <c:pt idx="460">
                  <c:v>2584</c:v>
                </c:pt>
                <c:pt idx="461">
                  <c:v>2871</c:v>
                </c:pt>
                <c:pt idx="462">
                  <c:v>2590</c:v>
                </c:pt>
                <c:pt idx="463">
                  <c:v>2717</c:v>
                </c:pt>
                <c:pt idx="464">
                  <c:v>3498</c:v>
                </c:pt>
                <c:pt idx="465">
                  <c:v>2027</c:v>
                </c:pt>
                <c:pt idx="466">
                  <c:v>3865</c:v>
                </c:pt>
                <c:pt idx="467">
                  <c:v>4651</c:v>
                </c:pt>
                <c:pt idx="468">
                  <c:v>5270</c:v>
                </c:pt>
                <c:pt idx="469">
                  <c:v>4700</c:v>
                </c:pt>
                <c:pt idx="470">
                  <c:v>3466</c:v>
                </c:pt>
                <c:pt idx="471">
                  <c:v>3118</c:v>
                </c:pt>
                <c:pt idx="472">
                  <c:v>2688</c:v>
                </c:pt>
                <c:pt idx="473">
                  <c:v>3854</c:v>
                </c:pt>
                <c:pt idx="474">
                  <c:v>3929</c:v>
                </c:pt>
                <c:pt idx="475">
                  <c:v>3749</c:v>
                </c:pt>
                <c:pt idx="476">
                  <c:v>3903</c:v>
                </c:pt>
                <c:pt idx="477">
                  <c:v>3838</c:v>
                </c:pt>
                <c:pt idx="478">
                  <c:v>4072</c:v>
                </c:pt>
                <c:pt idx="479">
                  <c:v>2942</c:v>
                </c:pt>
                <c:pt idx="480">
                  <c:v>2743</c:v>
                </c:pt>
                <c:pt idx="481">
                  <c:v>2955</c:v>
                </c:pt>
                <c:pt idx="482">
                  <c:v>4021</c:v>
                </c:pt>
                <c:pt idx="483">
                  <c:v>3129</c:v>
                </c:pt>
                <c:pt idx="484">
                  <c:v>3420</c:v>
                </c:pt>
                <c:pt idx="485">
                  <c:v>4095</c:v>
                </c:pt>
                <c:pt idx="486">
                  <c:v>4381</c:v>
                </c:pt>
                <c:pt idx="487">
                  <c:v>3992</c:v>
                </c:pt>
                <c:pt idx="488">
                  <c:v>4365</c:v>
                </c:pt>
                <c:pt idx="489">
                  <c:v>4260</c:v>
                </c:pt>
                <c:pt idx="490">
                  <c:v>3183</c:v>
                </c:pt>
                <c:pt idx="491">
                  <c:v>4156</c:v>
                </c:pt>
                <c:pt idx="492">
                  <c:v>4112</c:v>
                </c:pt>
                <c:pt idx="493">
                  <c:v>3917</c:v>
                </c:pt>
                <c:pt idx="494">
                  <c:v>3440</c:v>
                </c:pt>
                <c:pt idx="495">
                  <c:v>4357</c:v>
                </c:pt>
                <c:pt idx="496">
                  <c:v>3922</c:v>
                </c:pt>
                <c:pt idx="497">
                  <c:v>3840</c:v>
                </c:pt>
                <c:pt idx="498">
                  <c:v>3488</c:v>
                </c:pt>
                <c:pt idx="499">
                  <c:v>2840</c:v>
                </c:pt>
                <c:pt idx="500">
                  <c:v>3498</c:v>
                </c:pt>
                <c:pt idx="501">
                  <c:v>3312</c:v>
                </c:pt>
                <c:pt idx="502">
                  <c:v>3542</c:v>
                </c:pt>
                <c:pt idx="503">
                  <c:v>3943</c:v>
                </c:pt>
                <c:pt idx="504">
                  <c:v>3466</c:v>
                </c:pt>
                <c:pt idx="505">
                  <c:v>3495</c:v>
                </c:pt>
                <c:pt idx="506">
                  <c:v>4876</c:v>
                </c:pt>
                <c:pt idx="507">
                  <c:v>3754</c:v>
                </c:pt>
                <c:pt idx="508">
                  <c:v>4002</c:v>
                </c:pt>
                <c:pt idx="509">
                  <c:v>3046</c:v>
                </c:pt>
                <c:pt idx="510">
                  <c:v>4077</c:v>
                </c:pt>
                <c:pt idx="511">
                  <c:v>4673</c:v>
                </c:pt>
                <c:pt idx="512">
                  <c:v>4544</c:v>
                </c:pt>
                <c:pt idx="513">
                  <c:v>4643</c:v>
                </c:pt>
                <c:pt idx="514">
                  <c:v>3416</c:v>
                </c:pt>
                <c:pt idx="515">
                  <c:v>3301</c:v>
                </c:pt>
                <c:pt idx="516">
                  <c:v>3814</c:v>
                </c:pt>
                <c:pt idx="517">
                  <c:v>3285</c:v>
                </c:pt>
                <c:pt idx="518">
                  <c:v>4201</c:v>
                </c:pt>
                <c:pt idx="519">
                  <c:v>4450</c:v>
                </c:pt>
                <c:pt idx="520">
                  <c:v>4706</c:v>
                </c:pt>
                <c:pt idx="521">
                  <c:v>4595</c:v>
                </c:pt>
                <c:pt idx="522">
                  <c:v>4896</c:v>
                </c:pt>
                <c:pt idx="523">
                  <c:v>4951</c:v>
                </c:pt>
                <c:pt idx="524">
                  <c:v>2938</c:v>
                </c:pt>
                <c:pt idx="525">
                  <c:v>4326</c:v>
                </c:pt>
                <c:pt idx="526">
                  <c:v>4108</c:v>
                </c:pt>
                <c:pt idx="527">
                  <c:v>4437</c:v>
                </c:pt>
                <c:pt idx="528">
                  <c:v>4255</c:v>
                </c:pt>
                <c:pt idx="529">
                  <c:v>4827</c:v>
                </c:pt>
                <c:pt idx="530">
                  <c:v>3363</c:v>
                </c:pt>
                <c:pt idx="531">
                  <c:v>3867</c:v>
                </c:pt>
                <c:pt idx="532">
                  <c:v>4320</c:v>
                </c:pt>
                <c:pt idx="533">
                  <c:v>5155</c:v>
                </c:pt>
                <c:pt idx="534">
                  <c:v>3997</c:v>
                </c:pt>
                <c:pt idx="535">
                  <c:v>4026</c:v>
                </c:pt>
                <c:pt idx="536">
                  <c:v>3346</c:v>
                </c:pt>
                <c:pt idx="537">
                  <c:v>4333</c:v>
                </c:pt>
                <c:pt idx="538">
                  <c:v>3714</c:v>
                </c:pt>
                <c:pt idx="539">
                  <c:v>4138</c:v>
                </c:pt>
                <c:pt idx="540">
                  <c:v>4215</c:v>
                </c:pt>
                <c:pt idx="541">
                  <c:v>3647</c:v>
                </c:pt>
                <c:pt idx="542">
                  <c:v>4718</c:v>
                </c:pt>
                <c:pt idx="543">
                  <c:v>3869</c:v>
                </c:pt>
                <c:pt idx="544">
                  <c:v>5370</c:v>
                </c:pt>
                <c:pt idx="545">
                  <c:v>3838</c:v>
                </c:pt>
                <c:pt idx="546">
                  <c:v>4121</c:v>
                </c:pt>
                <c:pt idx="547">
                  <c:v>4298</c:v>
                </c:pt>
                <c:pt idx="548">
                  <c:v>4194</c:v>
                </c:pt>
                <c:pt idx="549">
                  <c:v>4454</c:v>
                </c:pt>
                <c:pt idx="550">
                  <c:v>3891</c:v>
                </c:pt>
                <c:pt idx="551">
                  <c:v>4429</c:v>
                </c:pt>
                <c:pt idx="552">
                  <c:v>4630</c:v>
                </c:pt>
                <c:pt idx="553">
                  <c:v>4196</c:v>
                </c:pt>
                <c:pt idx="554">
                  <c:v>4393</c:v>
                </c:pt>
                <c:pt idx="555">
                  <c:v>5543</c:v>
                </c:pt>
                <c:pt idx="556">
                  <c:v>5299</c:v>
                </c:pt>
                <c:pt idx="557">
                  <c:v>5327</c:v>
                </c:pt>
                <c:pt idx="558">
                  <c:v>4485</c:v>
                </c:pt>
                <c:pt idx="559">
                  <c:v>4738</c:v>
                </c:pt>
                <c:pt idx="560">
                  <c:v>3477</c:v>
                </c:pt>
                <c:pt idx="561">
                  <c:v>3961</c:v>
                </c:pt>
                <c:pt idx="562">
                  <c:v>5216</c:v>
                </c:pt>
                <c:pt idx="563">
                  <c:v>4866</c:v>
                </c:pt>
                <c:pt idx="564">
                  <c:v>5542</c:v>
                </c:pt>
                <c:pt idx="565">
                  <c:v>4841</c:v>
                </c:pt>
                <c:pt idx="566">
                  <c:v>3780</c:v>
                </c:pt>
                <c:pt idx="567">
                  <c:v>4315</c:v>
                </c:pt>
                <c:pt idx="568">
                  <c:v>5529</c:v>
                </c:pt>
                <c:pt idx="569">
                  <c:v>4956</c:v>
                </c:pt>
                <c:pt idx="570">
                  <c:v>4527</c:v>
                </c:pt>
                <c:pt idx="571">
                  <c:v>5396</c:v>
                </c:pt>
                <c:pt idx="572">
                  <c:v>4311</c:v>
                </c:pt>
                <c:pt idx="573">
                  <c:v>4811</c:v>
                </c:pt>
                <c:pt idx="574">
                  <c:v>4562</c:v>
                </c:pt>
                <c:pt idx="575">
                  <c:v>6187</c:v>
                </c:pt>
                <c:pt idx="576">
                  <c:v>5239</c:v>
                </c:pt>
                <c:pt idx="577">
                  <c:v>4701</c:v>
                </c:pt>
                <c:pt idx="578">
                  <c:v>4884</c:v>
                </c:pt>
                <c:pt idx="579">
                  <c:v>5936</c:v>
                </c:pt>
                <c:pt idx="580">
                  <c:v>4780</c:v>
                </c:pt>
                <c:pt idx="581">
                  <c:v>4678</c:v>
                </c:pt>
                <c:pt idx="582">
                  <c:v>5335</c:v>
                </c:pt>
                <c:pt idx="583">
                  <c:v>4382</c:v>
                </c:pt>
                <c:pt idx="584">
                  <c:v>4846</c:v>
                </c:pt>
                <c:pt idx="585">
                  <c:v>4735</c:v>
                </c:pt>
                <c:pt idx="586">
                  <c:v>5177</c:v>
                </c:pt>
                <c:pt idx="587">
                  <c:v>4335</c:v>
                </c:pt>
                <c:pt idx="588">
                  <c:v>4633</c:v>
                </c:pt>
                <c:pt idx="589">
                  <c:v>4688</c:v>
                </c:pt>
                <c:pt idx="590">
                  <c:v>5232</c:v>
                </c:pt>
                <c:pt idx="591">
                  <c:v>5145</c:v>
                </c:pt>
                <c:pt idx="592">
                  <c:v>4658</c:v>
                </c:pt>
                <c:pt idx="593">
                  <c:v>5223</c:v>
                </c:pt>
                <c:pt idx="594">
                  <c:v>5162</c:v>
                </c:pt>
                <c:pt idx="595">
                  <c:v>7829</c:v>
                </c:pt>
                <c:pt idx="596">
                  <c:v>28973</c:v>
                </c:pt>
                <c:pt idx="597">
                  <c:v>110438</c:v>
                </c:pt>
                <c:pt idx="598">
                  <c:v>283502</c:v>
                </c:pt>
                <c:pt idx="599">
                  <c:v>392765</c:v>
                </c:pt>
                <c:pt idx="600">
                  <c:v>303088</c:v>
                </c:pt>
                <c:pt idx="601">
                  <c:v>123771</c:v>
                </c:pt>
                <c:pt idx="602">
                  <c:v>34712</c:v>
                </c:pt>
                <c:pt idx="603">
                  <c:v>12523</c:v>
                </c:pt>
                <c:pt idx="604">
                  <c:v>9274</c:v>
                </c:pt>
                <c:pt idx="605">
                  <c:v>6809</c:v>
                </c:pt>
                <c:pt idx="606">
                  <c:v>5368</c:v>
                </c:pt>
                <c:pt idx="607">
                  <c:v>4858</c:v>
                </c:pt>
                <c:pt idx="608">
                  <c:v>5855</c:v>
                </c:pt>
                <c:pt idx="609">
                  <c:v>5644</c:v>
                </c:pt>
                <c:pt idx="610">
                  <c:v>5087</c:v>
                </c:pt>
                <c:pt idx="611">
                  <c:v>4830</c:v>
                </c:pt>
                <c:pt idx="612">
                  <c:v>4466</c:v>
                </c:pt>
                <c:pt idx="613">
                  <c:v>5242</c:v>
                </c:pt>
                <c:pt idx="614">
                  <c:v>4976</c:v>
                </c:pt>
                <c:pt idx="615">
                  <c:v>5367</c:v>
                </c:pt>
                <c:pt idx="616">
                  <c:v>6169</c:v>
                </c:pt>
                <c:pt idx="617">
                  <c:v>4513</c:v>
                </c:pt>
                <c:pt idx="618">
                  <c:v>4879</c:v>
                </c:pt>
                <c:pt idx="619">
                  <c:v>4037</c:v>
                </c:pt>
                <c:pt idx="620">
                  <c:v>4556</c:v>
                </c:pt>
                <c:pt idx="621">
                  <c:v>4857</c:v>
                </c:pt>
                <c:pt idx="622">
                  <c:v>5172</c:v>
                </c:pt>
                <c:pt idx="623">
                  <c:v>3457</c:v>
                </c:pt>
                <c:pt idx="624">
                  <c:v>5077</c:v>
                </c:pt>
                <c:pt idx="625">
                  <c:v>5116</c:v>
                </c:pt>
                <c:pt idx="626">
                  <c:v>5632</c:v>
                </c:pt>
                <c:pt idx="627">
                  <c:v>5070</c:v>
                </c:pt>
                <c:pt idx="628">
                  <c:v>5645</c:v>
                </c:pt>
                <c:pt idx="629">
                  <c:v>4669</c:v>
                </c:pt>
                <c:pt idx="630">
                  <c:v>5484</c:v>
                </c:pt>
                <c:pt idx="631">
                  <c:v>4378</c:v>
                </c:pt>
                <c:pt idx="632">
                  <c:v>5277</c:v>
                </c:pt>
                <c:pt idx="633">
                  <c:v>4881</c:v>
                </c:pt>
                <c:pt idx="634">
                  <c:v>5665</c:v>
                </c:pt>
                <c:pt idx="635">
                  <c:v>4989</c:v>
                </c:pt>
                <c:pt idx="636">
                  <c:v>5211</c:v>
                </c:pt>
                <c:pt idx="637">
                  <c:v>4444</c:v>
                </c:pt>
                <c:pt idx="638">
                  <c:v>6854</c:v>
                </c:pt>
                <c:pt idx="639">
                  <c:v>3994</c:v>
                </c:pt>
                <c:pt idx="640">
                  <c:v>6021</c:v>
                </c:pt>
                <c:pt idx="641">
                  <c:v>4310</c:v>
                </c:pt>
                <c:pt idx="642">
                  <c:v>5229</c:v>
                </c:pt>
                <c:pt idx="643">
                  <c:v>4935</c:v>
                </c:pt>
                <c:pt idx="644">
                  <c:v>4103</c:v>
                </c:pt>
                <c:pt idx="645">
                  <c:v>4569</c:v>
                </c:pt>
                <c:pt idx="646">
                  <c:v>4965</c:v>
                </c:pt>
                <c:pt idx="647">
                  <c:v>3664</c:v>
                </c:pt>
                <c:pt idx="648">
                  <c:v>4431</c:v>
                </c:pt>
                <c:pt idx="649">
                  <c:v>4238</c:v>
                </c:pt>
                <c:pt idx="650">
                  <c:v>5545</c:v>
                </c:pt>
                <c:pt idx="651">
                  <c:v>4037</c:v>
                </c:pt>
                <c:pt idx="652">
                  <c:v>4266</c:v>
                </c:pt>
                <c:pt idx="653">
                  <c:v>4977</c:v>
                </c:pt>
                <c:pt idx="654">
                  <c:v>3366</c:v>
                </c:pt>
                <c:pt idx="655">
                  <c:v>4600</c:v>
                </c:pt>
                <c:pt idx="656">
                  <c:v>4427</c:v>
                </c:pt>
                <c:pt idx="657">
                  <c:v>4648</c:v>
                </c:pt>
                <c:pt idx="658">
                  <c:v>3466</c:v>
                </c:pt>
                <c:pt idx="659">
                  <c:v>4429</c:v>
                </c:pt>
                <c:pt idx="660">
                  <c:v>4446</c:v>
                </c:pt>
                <c:pt idx="661">
                  <c:v>5188</c:v>
                </c:pt>
                <c:pt idx="662">
                  <c:v>6503</c:v>
                </c:pt>
                <c:pt idx="663">
                  <c:v>10514</c:v>
                </c:pt>
                <c:pt idx="664">
                  <c:v>17858</c:v>
                </c:pt>
                <c:pt idx="665">
                  <c:v>19648</c:v>
                </c:pt>
                <c:pt idx="666">
                  <c:v>18016</c:v>
                </c:pt>
                <c:pt idx="667">
                  <c:v>10159</c:v>
                </c:pt>
                <c:pt idx="668">
                  <c:v>6755</c:v>
                </c:pt>
                <c:pt idx="669">
                  <c:v>6101</c:v>
                </c:pt>
                <c:pt idx="670">
                  <c:v>4873</c:v>
                </c:pt>
                <c:pt idx="671">
                  <c:v>5465</c:v>
                </c:pt>
                <c:pt idx="672">
                  <c:v>6355</c:v>
                </c:pt>
                <c:pt idx="673">
                  <c:v>5122</c:v>
                </c:pt>
                <c:pt idx="674">
                  <c:v>5003</c:v>
                </c:pt>
                <c:pt idx="675">
                  <c:v>5729</c:v>
                </c:pt>
                <c:pt idx="676">
                  <c:v>7105</c:v>
                </c:pt>
                <c:pt idx="677">
                  <c:v>5668</c:v>
                </c:pt>
                <c:pt idx="678">
                  <c:v>5736</c:v>
                </c:pt>
                <c:pt idx="679">
                  <c:v>6622</c:v>
                </c:pt>
                <c:pt idx="680">
                  <c:v>5605</c:v>
                </c:pt>
                <c:pt idx="681">
                  <c:v>5352</c:v>
                </c:pt>
                <c:pt idx="682">
                  <c:v>5153</c:v>
                </c:pt>
                <c:pt idx="683">
                  <c:v>4837</c:v>
                </c:pt>
                <c:pt idx="684">
                  <c:v>5996</c:v>
                </c:pt>
                <c:pt idx="685">
                  <c:v>5262</c:v>
                </c:pt>
                <c:pt idx="686">
                  <c:v>5409</c:v>
                </c:pt>
                <c:pt idx="687">
                  <c:v>6270</c:v>
                </c:pt>
                <c:pt idx="688">
                  <c:v>5882</c:v>
                </c:pt>
                <c:pt idx="689">
                  <c:v>6822</c:v>
                </c:pt>
                <c:pt idx="690">
                  <c:v>6980</c:v>
                </c:pt>
                <c:pt idx="691">
                  <c:v>6512</c:v>
                </c:pt>
                <c:pt idx="692">
                  <c:v>6502</c:v>
                </c:pt>
                <c:pt idx="693">
                  <c:v>5252</c:v>
                </c:pt>
                <c:pt idx="694">
                  <c:v>5897</c:v>
                </c:pt>
                <c:pt idx="695">
                  <c:v>5216</c:v>
                </c:pt>
                <c:pt idx="696">
                  <c:v>5813</c:v>
                </c:pt>
                <c:pt idx="697">
                  <c:v>6075</c:v>
                </c:pt>
                <c:pt idx="698">
                  <c:v>5524</c:v>
                </c:pt>
                <c:pt idx="699">
                  <c:v>7315</c:v>
                </c:pt>
                <c:pt idx="700">
                  <c:v>6332</c:v>
                </c:pt>
                <c:pt idx="701">
                  <c:v>5933</c:v>
                </c:pt>
                <c:pt idx="702">
                  <c:v>6805</c:v>
                </c:pt>
                <c:pt idx="703">
                  <c:v>5668</c:v>
                </c:pt>
                <c:pt idx="704">
                  <c:v>6271</c:v>
                </c:pt>
                <c:pt idx="705">
                  <c:v>6343</c:v>
                </c:pt>
                <c:pt idx="706">
                  <c:v>6566</c:v>
                </c:pt>
                <c:pt idx="707">
                  <c:v>7561</c:v>
                </c:pt>
                <c:pt idx="708">
                  <c:v>6537</c:v>
                </c:pt>
                <c:pt idx="709">
                  <c:v>8271</c:v>
                </c:pt>
                <c:pt idx="710">
                  <c:v>6465</c:v>
                </c:pt>
                <c:pt idx="711">
                  <c:v>8526</c:v>
                </c:pt>
                <c:pt idx="712">
                  <c:v>6776</c:v>
                </c:pt>
                <c:pt idx="713">
                  <c:v>7199</c:v>
                </c:pt>
                <c:pt idx="714">
                  <c:v>7208</c:v>
                </c:pt>
                <c:pt idx="715">
                  <c:v>6416</c:v>
                </c:pt>
                <c:pt idx="716">
                  <c:v>5639</c:v>
                </c:pt>
                <c:pt idx="717">
                  <c:v>5658</c:v>
                </c:pt>
                <c:pt idx="718">
                  <c:v>5285</c:v>
                </c:pt>
                <c:pt idx="719">
                  <c:v>6322</c:v>
                </c:pt>
                <c:pt idx="720">
                  <c:v>6575</c:v>
                </c:pt>
                <c:pt idx="721">
                  <c:v>5584</c:v>
                </c:pt>
                <c:pt idx="722">
                  <c:v>5722</c:v>
                </c:pt>
                <c:pt idx="723">
                  <c:v>5889</c:v>
                </c:pt>
                <c:pt idx="724">
                  <c:v>6495</c:v>
                </c:pt>
                <c:pt idx="725">
                  <c:v>6613</c:v>
                </c:pt>
                <c:pt idx="726">
                  <c:v>5784</c:v>
                </c:pt>
                <c:pt idx="727">
                  <c:v>5916</c:v>
                </c:pt>
                <c:pt idx="728">
                  <c:v>6283</c:v>
                </c:pt>
                <c:pt idx="729">
                  <c:v>6106</c:v>
                </c:pt>
                <c:pt idx="730">
                  <c:v>4445</c:v>
                </c:pt>
                <c:pt idx="731">
                  <c:v>6512</c:v>
                </c:pt>
                <c:pt idx="732">
                  <c:v>5162</c:v>
                </c:pt>
                <c:pt idx="733">
                  <c:v>6289</c:v>
                </c:pt>
                <c:pt idx="734">
                  <c:v>5354</c:v>
                </c:pt>
                <c:pt idx="735">
                  <c:v>5035</c:v>
                </c:pt>
                <c:pt idx="736">
                  <c:v>4248</c:v>
                </c:pt>
                <c:pt idx="737">
                  <c:v>4851</c:v>
                </c:pt>
                <c:pt idx="738">
                  <c:v>4825</c:v>
                </c:pt>
                <c:pt idx="739">
                  <c:v>5728</c:v>
                </c:pt>
                <c:pt idx="740">
                  <c:v>5462</c:v>
                </c:pt>
                <c:pt idx="741">
                  <c:v>5558</c:v>
                </c:pt>
                <c:pt idx="742">
                  <c:v>4638</c:v>
                </c:pt>
                <c:pt idx="743">
                  <c:v>6082</c:v>
                </c:pt>
                <c:pt idx="744">
                  <c:v>5312</c:v>
                </c:pt>
                <c:pt idx="745">
                  <c:v>5072</c:v>
                </c:pt>
                <c:pt idx="746">
                  <c:v>4866</c:v>
                </c:pt>
                <c:pt idx="747">
                  <c:v>7118</c:v>
                </c:pt>
                <c:pt idx="748">
                  <c:v>13510</c:v>
                </c:pt>
                <c:pt idx="749">
                  <c:v>31329</c:v>
                </c:pt>
                <c:pt idx="750">
                  <c:v>59116</c:v>
                </c:pt>
                <c:pt idx="751">
                  <c:v>88989</c:v>
                </c:pt>
                <c:pt idx="752">
                  <c:v>96603</c:v>
                </c:pt>
                <c:pt idx="753">
                  <c:v>71561</c:v>
                </c:pt>
                <c:pt idx="754">
                  <c:v>46401</c:v>
                </c:pt>
                <c:pt idx="755">
                  <c:v>28688</c:v>
                </c:pt>
                <c:pt idx="756">
                  <c:v>19112</c:v>
                </c:pt>
                <c:pt idx="757">
                  <c:v>12983</c:v>
                </c:pt>
                <c:pt idx="758">
                  <c:v>12489</c:v>
                </c:pt>
                <c:pt idx="759">
                  <c:v>10824</c:v>
                </c:pt>
                <c:pt idx="760">
                  <c:v>8149</c:v>
                </c:pt>
                <c:pt idx="761">
                  <c:v>7765</c:v>
                </c:pt>
                <c:pt idx="762">
                  <c:v>8194</c:v>
                </c:pt>
                <c:pt idx="763">
                  <c:v>7559</c:v>
                </c:pt>
                <c:pt idx="764">
                  <c:v>6747</c:v>
                </c:pt>
                <c:pt idx="765">
                  <c:v>5966</c:v>
                </c:pt>
                <c:pt idx="766">
                  <c:v>6020</c:v>
                </c:pt>
                <c:pt idx="767">
                  <c:v>5805</c:v>
                </c:pt>
                <c:pt idx="768">
                  <c:v>4989</c:v>
                </c:pt>
                <c:pt idx="769">
                  <c:v>5753</c:v>
                </c:pt>
                <c:pt idx="770">
                  <c:v>4663</c:v>
                </c:pt>
                <c:pt idx="771">
                  <c:v>4823</c:v>
                </c:pt>
                <c:pt idx="772">
                  <c:v>5123</c:v>
                </c:pt>
                <c:pt idx="773">
                  <c:v>4909</c:v>
                </c:pt>
                <c:pt idx="774">
                  <c:v>4755</c:v>
                </c:pt>
                <c:pt idx="775">
                  <c:v>3150</c:v>
                </c:pt>
                <c:pt idx="776">
                  <c:v>5120</c:v>
                </c:pt>
                <c:pt idx="777">
                  <c:v>3446</c:v>
                </c:pt>
                <c:pt idx="778">
                  <c:v>4245</c:v>
                </c:pt>
                <c:pt idx="779">
                  <c:v>4489</c:v>
                </c:pt>
                <c:pt idx="780">
                  <c:v>3628</c:v>
                </c:pt>
                <c:pt idx="781">
                  <c:v>3899</c:v>
                </c:pt>
                <c:pt idx="782">
                  <c:v>3342</c:v>
                </c:pt>
                <c:pt idx="783">
                  <c:v>3181</c:v>
                </c:pt>
                <c:pt idx="784">
                  <c:v>4377</c:v>
                </c:pt>
                <c:pt idx="785">
                  <c:v>4749</c:v>
                </c:pt>
                <c:pt idx="786">
                  <c:v>3763</c:v>
                </c:pt>
                <c:pt idx="787">
                  <c:v>3620</c:v>
                </c:pt>
                <c:pt idx="788">
                  <c:v>3471</c:v>
                </c:pt>
                <c:pt idx="789">
                  <c:v>4087</c:v>
                </c:pt>
                <c:pt idx="790">
                  <c:v>4719</c:v>
                </c:pt>
                <c:pt idx="791">
                  <c:v>4211</c:v>
                </c:pt>
                <c:pt idx="792">
                  <c:v>3906</c:v>
                </c:pt>
                <c:pt idx="793">
                  <c:v>4228</c:v>
                </c:pt>
                <c:pt idx="794">
                  <c:v>4181</c:v>
                </c:pt>
                <c:pt idx="795">
                  <c:v>3810</c:v>
                </c:pt>
                <c:pt idx="796">
                  <c:v>4621</c:v>
                </c:pt>
                <c:pt idx="797">
                  <c:v>3838</c:v>
                </c:pt>
                <c:pt idx="798">
                  <c:v>4134</c:v>
                </c:pt>
                <c:pt idx="799">
                  <c:v>3677</c:v>
                </c:pt>
                <c:pt idx="800">
                  <c:v>2880</c:v>
                </c:pt>
                <c:pt idx="801">
                  <c:v>2361</c:v>
                </c:pt>
                <c:pt idx="802">
                  <c:v>3004</c:v>
                </c:pt>
                <c:pt idx="803">
                  <c:v>3315</c:v>
                </c:pt>
                <c:pt idx="804">
                  <c:v>3257</c:v>
                </c:pt>
                <c:pt idx="805">
                  <c:v>3696</c:v>
                </c:pt>
                <c:pt idx="806">
                  <c:v>2514</c:v>
                </c:pt>
                <c:pt idx="807">
                  <c:v>3083</c:v>
                </c:pt>
                <c:pt idx="808">
                  <c:v>3235</c:v>
                </c:pt>
                <c:pt idx="809">
                  <c:v>3497</c:v>
                </c:pt>
                <c:pt idx="810">
                  <c:v>3142</c:v>
                </c:pt>
                <c:pt idx="811">
                  <c:v>2971</c:v>
                </c:pt>
                <c:pt idx="812">
                  <c:v>2268</c:v>
                </c:pt>
                <c:pt idx="813">
                  <c:v>3132</c:v>
                </c:pt>
                <c:pt idx="814">
                  <c:v>2689</c:v>
                </c:pt>
                <c:pt idx="815">
                  <c:v>3183</c:v>
                </c:pt>
                <c:pt idx="816">
                  <c:v>3443</c:v>
                </c:pt>
                <c:pt idx="817">
                  <c:v>2488</c:v>
                </c:pt>
                <c:pt idx="818">
                  <c:v>2519</c:v>
                </c:pt>
                <c:pt idx="819">
                  <c:v>3809</c:v>
                </c:pt>
                <c:pt idx="820">
                  <c:v>3914</c:v>
                </c:pt>
                <c:pt idx="821">
                  <c:v>4125</c:v>
                </c:pt>
                <c:pt idx="822">
                  <c:v>3232</c:v>
                </c:pt>
                <c:pt idx="823">
                  <c:v>3632</c:v>
                </c:pt>
                <c:pt idx="824">
                  <c:v>3311</c:v>
                </c:pt>
                <c:pt idx="825">
                  <c:v>3197</c:v>
                </c:pt>
                <c:pt idx="826">
                  <c:v>3205</c:v>
                </c:pt>
                <c:pt idx="827">
                  <c:v>2934</c:v>
                </c:pt>
                <c:pt idx="828">
                  <c:v>3387</c:v>
                </c:pt>
                <c:pt idx="829">
                  <c:v>2583</c:v>
                </c:pt>
                <c:pt idx="830">
                  <c:v>3299</c:v>
                </c:pt>
                <c:pt idx="831">
                  <c:v>2985</c:v>
                </c:pt>
                <c:pt idx="832">
                  <c:v>3108</c:v>
                </c:pt>
                <c:pt idx="833">
                  <c:v>2643</c:v>
                </c:pt>
                <c:pt idx="834">
                  <c:v>2684</c:v>
                </c:pt>
                <c:pt idx="835">
                  <c:v>3563</c:v>
                </c:pt>
                <c:pt idx="836">
                  <c:v>2731</c:v>
                </c:pt>
                <c:pt idx="837">
                  <c:v>2811</c:v>
                </c:pt>
                <c:pt idx="838">
                  <c:v>3005</c:v>
                </c:pt>
                <c:pt idx="839">
                  <c:v>2470</c:v>
                </c:pt>
                <c:pt idx="840">
                  <c:v>2717</c:v>
                </c:pt>
                <c:pt idx="841">
                  <c:v>2838</c:v>
                </c:pt>
                <c:pt idx="842">
                  <c:v>3348</c:v>
                </c:pt>
                <c:pt idx="843">
                  <c:v>2954</c:v>
                </c:pt>
                <c:pt idx="844">
                  <c:v>2849</c:v>
                </c:pt>
                <c:pt idx="845">
                  <c:v>3492</c:v>
                </c:pt>
                <c:pt idx="846">
                  <c:v>2979</c:v>
                </c:pt>
                <c:pt idx="847">
                  <c:v>3172</c:v>
                </c:pt>
                <c:pt idx="848">
                  <c:v>3775</c:v>
                </c:pt>
                <c:pt idx="849">
                  <c:v>2569</c:v>
                </c:pt>
                <c:pt idx="850">
                  <c:v>2845</c:v>
                </c:pt>
                <c:pt idx="851">
                  <c:v>3219</c:v>
                </c:pt>
                <c:pt idx="852">
                  <c:v>2935</c:v>
                </c:pt>
                <c:pt idx="853">
                  <c:v>2905</c:v>
                </c:pt>
                <c:pt idx="854">
                  <c:v>2749</c:v>
                </c:pt>
                <c:pt idx="855">
                  <c:v>2739</c:v>
                </c:pt>
                <c:pt idx="856">
                  <c:v>3377</c:v>
                </c:pt>
                <c:pt idx="857">
                  <c:v>2638</c:v>
                </c:pt>
                <c:pt idx="858">
                  <c:v>3124</c:v>
                </c:pt>
                <c:pt idx="859">
                  <c:v>3747</c:v>
                </c:pt>
                <c:pt idx="860">
                  <c:v>3761</c:v>
                </c:pt>
                <c:pt idx="861">
                  <c:v>3185</c:v>
                </c:pt>
                <c:pt idx="862">
                  <c:v>3567</c:v>
                </c:pt>
                <c:pt idx="863">
                  <c:v>2860</c:v>
                </c:pt>
                <c:pt idx="864">
                  <c:v>2824</c:v>
                </c:pt>
                <c:pt idx="865">
                  <c:v>3186</c:v>
                </c:pt>
                <c:pt idx="866">
                  <c:v>3261</c:v>
                </c:pt>
                <c:pt idx="867">
                  <c:v>3036</c:v>
                </c:pt>
                <c:pt idx="868">
                  <c:v>2828</c:v>
                </c:pt>
                <c:pt idx="869">
                  <c:v>2677</c:v>
                </c:pt>
                <c:pt idx="870">
                  <c:v>2356</c:v>
                </c:pt>
                <c:pt idx="871">
                  <c:v>2071</c:v>
                </c:pt>
                <c:pt idx="872">
                  <c:v>3541</c:v>
                </c:pt>
                <c:pt idx="873">
                  <c:v>1804</c:v>
                </c:pt>
                <c:pt idx="874">
                  <c:v>2235</c:v>
                </c:pt>
                <c:pt idx="875">
                  <c:v>2405</c:v>
                </c:pt>
                <c:pt idx="876">
                  <c:v>2436</c:v>
                </c:pt>
                <c:pt idx="877">
                  <c:v>2819</c:v>
                </c:pt>
                <c:pt idx="878">
                  <c:v>2143</c:v>
                </c:pt>
                <c:pt idx="879">
                  <c:v>2597</c:v>
                </c:pt>
                <c:pt idx="880">
                  <c:v>2727</c:v>
                </c:pt>
                <c:pt idx="881">
                  <c:v>2234</c:v>
                </c:pt>
                <c:pt idx="882">
                  <c:v>2984</c:v>
                </c:pt>
                <c:pt idx="883">
                  <c:v>2598</c:v>
                </c:pt>
                <c:pt idx="884">
                  <c:v>3682</c:v>
                </c:pt>
                <c:pt idx="885">
                  <c:v>2682</c:v>
                </c:pt>
                <c:pt idx="886">
                  <c:v>3074</c:v>
                </c:pt>
                <c:pt idx="887">
                  <c:v>2086</c:v>
                </c:pt>
                <c:pt idx="888">
                  <c:v>2698</c:v>
                </c:pt>
                <c:pt idx="889">
                  <c:v>3223</c:v>
                </c:pt>
                <c:pt idx="890">
                  <c:v>2885</c:v>
                </c:pt>
                <c:pt idx="891">
                  <c:v>2627</c:v>
                </c:pt>
                <c:pt idx="892">
                  <c:v>1832</c:v>
                </c:pt>
                <c:pt idx="893">
                  <c:v>3053</c:v>
                </c:pt>
                <c:pt idx="894">
                  <c:v>3136</c:v>
                </c:pt>
                <c:pt idx="895">
                  <c:v>2412</c:v>
                </c:pt>
                <c:pt idx="896">
                  <c:v>3710</c:v>
                </c:pt>
                <c:pt idx="897">
                  <c:v>3007</c:v>
                </c:pt>
                <c:pt idx="898">
                  <c:v>2897</c:v>
                </c:pt>
                <c:pt idx="899">
                  <c:v>2859</c:v>
                </c:pt>
                <c:pt idx="900">
                  <c:v>2404</c:v>
                </c:pt>
                <c:pt idx="901">
                  <c:v>2103</c:v>
                </c:pt>
                <c:pt idx="902">
                  <c:v>2593</c:v>
                </c:pt>
                <c:pt idx="903">
                  <c:v>2427</c:v>
                </c:pt>
                <c:pt idx="904">
                  <c:v>2427</c:v>
                </c:pt>
                <c:pt idx="905">
                  <c:v>3316</c:v>
                </c:pt>
                <c:pt idx="906">
                  <c:v>3322</c:v>
                </c:pt>
                <c:pt idx="907">
                  <c:v>3467</c:v>
                </c:pt>
                <c:pt idx="908">
                  <c:v>4587</c:v>
                </c:pt>
                <c:pt idx="909">
                  <c:v>4781</c:v>
                </c:pt>
                <c:pt idx="910">
                  <c:v>4746</c:v>
                </c:pt>
                <c:pt idx="911">
                  <c:v>3335</c:v>
                </c:pt>
                <c:pt idx="912">
                  <c:v>2959</c:v>
                </c:pt>
                <c:pt idx="913">
                  <c:v>3716</c:v>
                </c:pt>
                <c:pt idx="914">
                  <c:v>3280</c:v>
                </c:pt>
                <c:pt idx="915">
                  <c:v>2890</c:v>
                </c:pt>
                <c:pt idx="916">
                  <c:v>2209</c:v>
                </c:pt>
                <c:pt idx="917">
                  <c:v>2130</c:v>
                </c:pt>
                <c:pt idx="918">
                  <c:v>2402</c:v>
                </c:pt>
                <c:pt idx="919">
                  <c:v>3049</c:v>
                </c:pt>
                <c:pt idx="920">
                  <c:v>2294</c:v>
                </c:pt>
                <c:pt idx="921">
                  <c:v>2993</c:v>
                </c:pt>
                <c:pt idx="922">
                  <c:v>3521</c:v>
                </c:pt>
                <c:pt idx="923">
                  <c:v>2780</c:v>
                </c:pt>
                <c:pt idx="924">
                  <c:v>3153</c:v>
                </c:pt>
                <c:pt idx="925">
                  <c:v>2546</c:v>
                </c:pt>
                <c:pt idx="926">
                  <c:v>2303</c:v>
                </c:pt>
                <c:pt idx="927">
                  <c:v>2620</c:v>
                </c:pt>
                <c:pt idx="928">
                  <c:v>2812</c:v>
                </c:pt>
                <c:pt idx="929">
                  <c:v>2925</c:v>
                </c:pt>
                <c:pt idx="930">
                  <c:v>2553</c:v>
                </c:pt>
                <c:pt idx="931">
                  <c:v>3149</c:v>
                </c:pt>
                <c:pt idx="932">
                  <c:v>3126</c:v>
                </c:pt>
                <c:pt idx="933">
                  <c:v>3077</c:v>
                </c:pt>
                <c:pt idx="934">
                  <c:v>3560</c:v>
                </c:pt>
                <c:pt idx="935">
                  <c:v>3683</c:v>
                </c:pt>
                <c:pt idx="936">
                  <c:v>3105</c:v>
                </c:pt>
                <c:pt idx="937">
                  <c:v>2133</c:v>
                </c:pt>
                <c:pt idx="938">
                  <c:v>2021</c:v>
                </c:pt>
                <c:pt idx="939">
                  <c:v>3256</c:v>
                </c:pt>
                <c:pt idx="940">
                  <c:v>3377</c:v>
                </c:pt>
                <c:pt idx="941">
                  <c:v>2611</c:v>
                </c:pt>
                <c:pt idx="942">
                  <c:v>2811</c:v>
                </c:pt>
                <c:pt idx="943">
                  <c:v>2452</c:v>
                </c:pt>
                <c:pt idx="944">
                  <c:v>3024</c:v>
                </c:pt>
                <c:pt idx="945">
                  <c:v>2572</c:v>
                </c:pt>
                <c:pt idx="946">
                  <c:v>2197</c:v>
                </c:pt>
                <c:pt idx="947">
                  <c:v>2818</c:v>
                </c:pt>
                <c:pt idx="948">
                  <c:v>1915</c:v>
                </c:pt>
                <c:pt idx="949">
                  <c:v>3143</c:v>
                </c:pt>
                <c:pt idx="950">
                  <c:v>3109</c:v>
                </c:pt>
                <c:pt idx="951">
                  <c:v>2218</c:v>
                </c:pt>
                <c:pt idx="952">
                  <c:v>2505</c:v>
                </c:pt>
                <c:pt idx="953">
                  <c:v>2639</c:v>
                </c:pt>
                <c:pt idx="954">
                  <c:v>2782</c:v>
                </c:pt>
                <c:pt idx="955">
                  <c:v>2450</c:v>
                </c:pt>
                <c:pt idx="956">
                  <c:v>2518</c:v>
                </c:pt>
                <c:pt idx="957">
                  <c:v>2768</c:v>
                </c:pt>
                <c:pt idx="958">
                  <c:v>2489</c:v>
                </c:pt>
                <c:pt idx="959">
                  <c:v>2899</c:v>
                </c:pt>
                <c:pt idx="960">
                  <c:v>2009</c:v>
                </c:pt>
                <c:pt idx="961">
                  <c:v>2588</c:v>
                </c:pt>
                <c:pt idx="962">
                  <c:v>3052</c:v>
                </c:pt>
                <c:pt idx="963">
                  <c:v>2635</c:v>
                </c:pt>
                <c:pt idx="964">
                  <c:v>3037</c:v>
                </c:pt>
                <c:pt idx="965">
                  <c:v>2128</c:v>
                </c:pt>
                <c:pt idx="966">
                  <c:v>3257</c:v>
                </c:pt>
                <c:pt idx="967">
                  <c:v>3233</c:v>
                </c:pt>
                <c:pt idx="968">
                  <c:v>2460</c:v>
                </c:pt>
                <c:pt idx="969">
                  <c:v>3480</c:v>
                </c:pt>
                <c:pt idx="970">
                  <c:v>3088</c:v>
                </c:pt>
                <c:pt idx="971">
                  <c:v>2457</c:v>
                </c:pt>
                <c:pt idx="972">
                  <c:v>2650</c:v>
                </c:pt>
                <c:pt idx="973">
                  <c:v>2484</c:v>
                </c:pt>
                <c:pt idx="974">
                  <c:v>2805</c:v>
                </c:pt>
                <c:pt idx="975">
                  <c:v>3809</c:v>
                </c:pt>
                <c:pt idx="976">
                  <c:v>2435</c:v>
                </c:pt>
                <c:pt idx="977">
                  <c:v>2320</c:v>
                </c:pt>
                <c:pt idx="978">
                  <c:v>2797</c:v>
                </c:pt>
                <c:pt idx="979">
                  <c:v>2500</c:v>
                </c:pt>
                <c:pt idx="980">
                  <c:v>2129</c:v>
                </c:pt>
                <c:pt idx="981">
                  <c:v>3342</c:v>
                </c:pt>
                <c:pt idx="982">
                  <c:v>2932</c:v>
                </c:pt>
                <c:pt idx="983">
                  <c:v>2667</c:v>
                </c:pt>
                <c:pt idx="984">
                  <c:v>2189</c:v>
                </c:pt>
                <c:pt idx="985">
                  <c:v>3252</c:v>
                </c:pt>
                <c:pt idx="986">
                  <c:v>2966</c:v>
                </c:pt>
                <c:pt idx="987">
                  <c:v>2406</c:v>
                </c:pt>
                <c:pt idx="988">
                  <c:v>2152</c:v>
                </c:pt>
                <c:pt idx="989">
                  <c:v>2242</c:v>
                </c:pt>
                <c:pt idx="990">
                  <c:v>2473</c:v>
                </c:pt>
                <c:pt idx="991">
                  <c:v>3449</c:v>
                </c:pt>
                <c:pt idx="992">
                  <c:v>2559</c:v>
                </c:pt>
                <c:pt idx="993">
                  <c:v>2440</c:v>
                </c:pt>
                <c:pt idx="994">
                  <c:v>2769</c:v>
                </c:pt>
                <c:pt idx="995">
                  <c:v>2643</c:v>
                </c:pt>
                <c:pt idx="996">
                  <c:v>3448</c:v>
                </c:pt>
                <c:pt idx="997">
                  <c:v>3547</c:v>
                </c:pt>
                <c:pt idx="998">
                  <c:v>3344</c:v>
                </c:pt>
                <c:pt idx="999">
                  <c:v>2939</c:v>
                </c:pt>
                <c:pt idx="1000">
                  <c:v>2745</c:v>
                </c:pt>
                <c:pt idx="1001">
                  <c:v>2941</c:v>
                </c:pt>
                <c:pt idx="1002">
                  <c:v>2492</c:v>
                </c:pt>
                <c:pt idx="1003">
                  <c:v>2691</c:v>
                </c:pt>
                <c:pt idx="1004">
                  <c:v>2737</c:v>
                </c:pt>
                <c:pt idx="1005">
                  <c:v>3028</c:v>
                </c:pt>
                <c:pt idx="1006">
                  <c:v>2465</c:v>
                </c:pt>
                <c:pt idx="1007">
                  <c:v>2167</c:v>
                </c:pt>
                <c:pt idx="1008">
                  <c:v>2615</c:v>
                </c:pt>
                <c:pt idx="1009">
                  <c:v>3307</c:v>
                </c:pt>
                <c:pt idx="1010">
                  <c:v>3285</c:v>
                </c:pt>
                <c:pt idx="1011">
                  <c:v>2398</c:v>
                </c:pt>
                <c:pt idx="1012">
                  <c:v>2027</c:v>
                </c:pt>
                <c:pt idx="1013">
                  <c:v>2102</c:v>
                </c:pt>
                <c:pt idx="1014">
                  <c:v>2040</c:v>
                </c:pt>
                <c:pt idx="1015">
                  <c:v>3802</c:v>
                </c:pt>
                <c:pt idx="1016">
                  <c:v>3193</c:v>
                </c:pt>
                <c:pt idx="1017">
                  <c:v>2571</c:v>
                </c:pt>
                <c:pt idx="1018">
                  <c:v>2893</c:v>
                </c:pt>
                <c:pt idx="1019">
                  <c:v>2654</c:v>
                </c:pt>
                <c:pt idx="1020">
                  <c:v>3407</c:v>
                </c:pt>
                <c:pt idx="1021">
                  <c:v>2130</c:v>
                </c:pt>
                <c:pt idx="1022">
                  <c:v>3374</c:v>
                </c:pt>
                <c:pt idx="1023">
                  <c:v>2546</c:v>
                </c:pt>
                <c:pt idx="1024">
                  <c:v>2786</c:v>
                </c:pt>
                <c:pt idx="1025">
                  <c:v>2101</c:v>
                </c:pt>
                <c:pt idx="1026">
                  <c:v>2373</c:v>
                </c:pt>
                <c:pt idx="1027">
                  <c:v>2958</c:v>
                </c:pt>
                <c:pt idx="1028">
                  <c:v>2786</c:v>
                </c:pt>
                <c:pt idx="1029">
                  <c:v>2854</c:v>
                </c:pt>
                <c:pt idx="1030">
                  <c:v>2840</c:v>
                </c:pt>
                <c:pt idx="1031">
                  <c:v>2087</c:v>
                </c:pt>
                <c:pt idx="1032">
                  <c:v>2479</c:v>
                </c:pt>
                <c:pt idx="1033">
                  <c:v>2340</c:v>
                </c:pt>
                <c:pt idx="1034">
                  <c:v>2880</c:v>
                </c:pt>
                <c:pt idx="1035">
                  <c:v>2619</c:v>
                </c:pt>
                <c:pt idx="1036">
                  <c:v>2697</c:v>
                </c:pt>
                <c:pt idx="1037">
                  <c:v>3132</c:v>
                </c:pt>
                <c:pt idx="1038">
                  <c:v>2654</c:v>
                </c:pt>
                <c:pt idx="1039">
                  <c:v>2354</c:v>
                </c:pt>
                <c:pt idx="1040">
                  <c:v>2951</c:v>
                </c:pt>
                <c:pt idx="1041">
                  <c:v>2460</c:v>
                </c:pt>
                <c:pt idx="1042">
                  <c:v>2636</c:v>
                </c:pt>
                <c:pt idx="1043">
                  <c:v>2214</c:v>
                </c:pt>
                <c:pt idx="1044">
                  <c:v>2517</c:v>
                </c:pt>
                <c:pt idx="1045">
                  <c:v>3154</c:v>
                </c:pt>
                <c:pt idx="1046">
                  <c:v>2799</c:v>
                </c:pt>
                <c:pt idx="1047">
                  <c:v>3398</c:v>
                </c:pt>
                <c:pt idx="1048">
                  <c:v>3419</c:v>
                </c:pt>
                <c:pt idx="1049">
                  <c:v>2506</c:v>
                </c:pt>
                <c:pt idx="1050">
                  <c:v>2319</c:v>
                </c:pt>
                <c:pt idx="1051">
                  <c:v>3318</c:v>
                </c:pt>
                <c:pt idx="1052">
                  <c:v>2828</c:v>
                </c:pt>
                <c:pt idx="1053">
                  <c:v>3396</c:v>
                </c:pt>
                <c:pt idx="1054">
                  <c:v>2098</c:v>
                </c:pt>
                <c:pt idx="1055">
                  <c:v>2714</c:v>
                </c:pt>
                <c:pt idx="1056">
                  <c:v>1808</c:v>
                </c:pt>
                <c:pt idx="1057">
                  <c:v>2116</c:v>
                </c:pt>
                <c:pt idx="1058">
                  <c:v>2452</c:v>
                </c:pt>
                <c:pt idx="1059">
                  <c:v>2743</c:v>
                </c:pt>
                <c:pt idx="1060">
                  <c:v>1981</c:v>
                </c:pt>
                <c:pt idx="1061">
                  <c:v>2416</c:v>
                </c:pt>
                <c:pt idx="1062">
                  <c:v>2945</c:v>
                </c:pt>
                <c:pt idx="1063">
                  <c:v>1979</c:v>
                </c:pt>
                <c:pt idx="1064">
                  <c:v>2914</c:v>
                </c:pt>
                <c:pt idx="1065">
                  <c:v>2978</c:v>
                </c:pt>
                <c:pt idx="1066">
                  <c:v>3076</c:v>
                </c:pt>
                <c:pt idx="1067">
                  <c:v>2571</c:v>
                </c:pt>
                <c:pt idx="1068">
                  <c:v>2544</c:v>
                </c:pt>
                <c:pt idx="1069">
                  <c:v>2590</c:v>
                </c:pt>
                <c:pt idx="1070">
                  <c:v>3284</c:v>
                </c:pt>
                <c:pt idx="1071">
                  <c:v>3109</c:v>
                </c:pt>
                <c:pt idx="1072">
                  <c:v>3449</c:v>
                </c:pt>
                <c:pt idx="1073">
                  <c:v>3349</c:v>
                </c:pt>
                <c:pt idx="1074">
                  <c:v>3067</c:v>
                </c:pt>
                <c:pt idx="1075">
                  <c:v>2855</c:v>
                </c:pt>
                <c:pt idx="1076">
                  <c:v>3130</c:v>
                </c:pt>
                <c:pt idx="1077">
                  <c:v>2596</c:v>
                </c:pt>
                <c:pt idx="1078">
                  <c:v>2474</c:v>
                </c:pt>
                <c:pt idx="1079">
                  <c:v>2883</c:v>
                </c:pt>
                <c:pt idx="1080">
                  <c:v>2969</c:v>
                </c:pt>
                <c:pt idx="1081">
                  <c:v>2529</c:v>
                </c:pt>
                <c:pt idx="1082">
                  <c:v>2566</c:v>
                </c:pt>
                <c:pt idx="1083">
                  <c:v>2544</c:v>
                </c:pt>
                <c:pt idx="1084">
                  <c:v>2467</c:v>
                </c:pt>
                <c:pt idx="1085">
                  <c:v>2670</c:v>
                </c:pt>
                <c:pt idx="1086">
                  <c:v>2571</c:v>
                </c:pt>
                <c:pt idx="1087">
                  <c:v>2954</c:v>
                </c:pt>
                <c:pt idx="1088">
                  <c:v>3233</c:v>
                </c:pt>
                <c:pt idx="1089">
                  <c:v>3417</c:v>
                </c:pt>
                <c:pt idx="1090">
                  <c:v>2829</c:v>
                </c:pt>
                <c:pt idx="1091">
                  <c:v>2982</c:v>
                </c:pt>
                <c:pt idx="1092">
                  <c:v>3322</c:v>
                </c:pt>
                <c:pt idx="1093">
                  <c:v>3274</c:v>
                </c:pt>
                <c:pt idx="1094">
                  <c:v>2660</c:v>
                </c:pt>
                <c:pt idx="1095">
                  <c:v>2707</c:v>
                </c:pt>
                <c:pt idx="1096">
                  <c:v>2838</c:v>
                </c:pt>
                <c:pt idx="1097">
                  <c:v>2939</c:v>
                </c:pt>
                <c:pt idx="1098">
                  <c:v>2515</c:v>
                </c:pt>
                <c:pt idx="1099">
                  <c:v>3288</c:v>
                </c:pt>
                <c:pt idx="1100">
                  <c:v>2135</c:v>
                </c:pt>
                <c:pt idx="1101">
                  <c:v>1968</c:v>
                </c:pt>
                <c:pt idx="1102">
                  <c:v>2865</c:v>
                </c:pt>
                <c:pt idx="1103">
                  <c:v>2334</c:v>
                </c:pt>
                <c:pt idx="1104">
                  <c:v>1946</c:v>
                </c:pt>
                <c:pt idx="1105">
                  <c:v>2495</c:v>
                </c:pt>
                <c:pt idx="1106">
                  <c:v>2825</c:v>
                </c:pt>
                <c:pt idx="1107">
                  <c:v>1663</c:v>
                </c:pt>
                <c:pt idx="1108">
                  <c:v>2868</c:v>
                </c:pt>
                <c:pt idx="1109">
                  <c:v>1904</c:v>
                </c:pt>
                <c:pt idx="1110">
                  <c:v>2574</c:v>
                </c:pt>
                <c:pt idx="1111">
                  <c:v>2622</c:v>
                </c:pt>
                <c:pt idx="1112">
                  <c:v>2359</c:v>
                </c:pt>
                <c:pt idx="1113">
                  <c:v>2448</c:v>
                </c:pt>
                <c:pt idx="1114">
                  <c:v>1988</c:v>
                </c:pt>
                <c:pt idx="1115">
                  <c:v>2376</c:v>
                </c:pt>
                <c:pt idx="1116">
                  <c:v>2852</c:v>
                </c:pt>
                <c:pt idx="1117">
                  <c:v>2484</c:v>
                </c:pt>
                <c:pt idx="1118">
                  <c:v>2538</c:v>
                </c:pt>
                <c:pt idx="1119">
                  <c:v>2514</c:v>
                </c:pt>
                <c:pt idx="1120">
                  <c:v>2545</c:v>
                </c:pt>
                <c:pt idx="1121">
                  <c:v>2881</c:v>
                </c:pt>
                <c:pt idx="1122">
                  <c:v>2690</c:v>
                </c:pt>
                <c:pt idx="1123">
                  <c:v>2934</c:v>
                </c:pt>
                <c:pt idx="1124">
                  <c:v>3010</c:v>
                </c:pt>
                <c:pt idx="1125">
                  <c:v>2497</c:v>
                </c:pt>
                <c:pt idx="1126">
                  <c:v>2273</c:v>
                </c:pt>
                <c:pt idx="1127">
                  <c:v>2609</c:v>
                </c:pt>
                <c:pt idx="1128">
                  <c:v>2299</c:v>
                </c:pt>
                <c:pt idx="1129">
                  <c:v>3205</c:v>
                </c:pt>
                <c:pt idx="1130">
                  <c:v>4076</c:v>
                </c:pt>
                <c:pt idx="1131">
                  <c:v>3490</c:v>
                </c:pt>
                <c:pt idx="1132">
                  <c:v>3305</c:v>
                </c:pt>
                <c:pt idx="1133">
                  <c:v>3026</c:v>
                </c:pt>
                <c:pt idx="1134">
                  <c:v>3180</c:v>
                </c:pt>
                <c:pt idx="1135">
                  <c:v>2561</c:v>
                </c:pt>
                <c:pt idx="1136">
                  <c:v>2338</c:v>
                </c:pt>
                <c:pt idx="1137">
                  <c:v>2491</c:v>
                </c:pt>
                <c:pt idx="1138">
                  <c:v>2455</c:v>
                </c:pt>
                <c:pt idx="1139">
                  <c:v>2075</c:v>
                </c:pt>
                <c:pt idx="1140">
                  <c:v>2507</c:v>
                </c:pt>
                <c:pt idx="1141">
                  <c:v>2755</c:v>
                </c:pt>
                <c:pt idx="1142">
                  <c:v>2649</c:v>
                </c:pt>
                <c:pt idx="1143">
                  <c:v>2805</c:v>
                </c:pt>
                <c:pt idx="1144">
                  <c:v>2266</c:v>
                </c:pt>
                <c:pt idx="1145">
                  <c:v>2167</c:v>
                </c:pt>
                <c:pt idx="1146">
                  <c:v>2156</c:v>
                </c:pt>
                <c:pt idx="1147">
                  <c:v>2915</c:v>
                </c:pt>
                <c:pt idx="1148">
                  <c:v>2288</c:v>
                </c:pt>
                <c:pt idx="1149">
                  <c:v>2359</c:v>
                </c:pt>
                <c:pt idx="1150">
                  <c:v>3063</c:v>
                </c:pt>
                <c:pt idx="1151">
                  <c:v>3331</c:v>
                </c:pt>
                <c:pt idx="1152">
                  <c:v>2325</c:v>
                </c:pt>
                <c:pt idx="1153">
                  <c:v>2442</c:v>
                </c:pt>
                <c:pt idx="1154">
                  <c:v>2710</c:v>
                </c:pt>
                <c:pt idx="1155">
                  <c:v>2754</c:v>
                </c:pt>
                <c:pt idx="1156">
                  <c:v>1974</c:v>
                </c:pt>
                <c:pt idx="1157">
                  <c:v>2280</c:v>
                </c:pt>
                <c:pt idx="1158">
                  <c:v>2766</c:v>
                </c:pt>
                <c:pt idx="1159">
                  <c:v>1963</c:v>
                </c:pt>
                <c:pt idx="1160">
                  <c:v>2762</c:v>
                </c:pt>
                <c:pt idx="1161">
                  <c:v>2476</c:v>
                </c:pt>
                <c:pt idx="1162">
                  <c:v>2766</c:v>
                </c:pt>
                <c:pt idx="1163">
                  <c:v>2080</c:v>
                </c:pt>
                <c:pt idx="1164">
                  <c:v>2296</c:v>
                </c:pt>
                <c:pt idx="1165">
                  <c:v>2657</c:v>
                </c:pt>
                <c:pt idx="1166">
                  <c:v>2431</c:v>
                </c:pt>
                <c:pt idx="1167">
                  <c:v>2193</c:v>
                </c:pt>
                <c:pt idx="1168">
                  <c:v>2494</c:v>
                </c:pt>
                <c:pt idx="1169">
                  <c:v>2721</c:v>
                </c:pt>
                <c:pt idx="1170">
                  <c:v>2084</c:v>
                </c:pt>
                <c:pt idx="1171">
                  <c:v>1968</c:v>
                </c:pt>
                <c:pt idx="1172">
                  <c:v>2679</c:v>
                </c:pt>
                <c:pt idx="1173">
                  <c:v>1983</c:v>
                </c:pt>
                <c:pt idx="1174">
                  <c:v>2691</c:v>
                </c:pt>
                <c:pt idx="1175">
                  <c:v>2355</c:v>
                </c:pt>
                <c:pt idx="1176">
                  <c:v>2427</c:v>
                </c:pt>
                <c:pt idx="1177">
                  <c:v>1910</c:v>
                </c:pt>
                <c:pt idx="1178">
                  <c:v>2764</c:v>
                </c:pt>
                <c:pt idx="1179">
                  <c:v>2246</c:v>
                </c:pt>
                <c:pt idx="1180">
                  <c:v>1784</c:v>
                </c:pt>
                <c:pt idx="1181">
                  <c:v>2403</c:v>
                </c:pt>
                <c:pt idx="1182">
                  <c:v>1950</c:v>
                </c:pt>
                <c:pt idx="1183">
                  <c:v>2171</c:v>
                </c:pt>
                <c:pt idx="1184">
                  <c:v>3379</c:v>
                </c:pt>
                <c:pt idx="1185">
                  <c:v>2238</c:v>
                </c:pt>
                <c:pt idx="1186">
                  <c:v>2886</c:v>
                </c:pt>
                <c:pt idx="1187">
                  <c:v>2714</c:v>
                </c:pt>
                <c:pt idx="1188">
                  <c:v>2106</c:v>
                </c:pt>
                <c:pt idx="1189">
                  <c:v>2728</c:v>
                </c:pt>
                <c:pt idx="1190">
                  <c:v>3605</c:v>
                </c:pt>
                <c:pt idx="1191">
                  <c:v>2757</c:v>
                </c:pt>
                <c:pt idx="1192">
                  <c:v>2412</c:v>
                </c:pt>
                <c:pt idx="1193">
                  <c:v>2752</c:v>
                </c:pt>
                <c:pt idx="1194">
                  <c:v>3101</c:v>
                </c:pt>
                <c:pt idx="1195">
                  <c:v>3237</c:v>
                </c:pt>
                <c:pt idx="1196">
                  <c:v>2613</c:v>
                </c:pt>
                <c:pt idx="1197">
                  <c:v>2774</c:v>
                </c:pt>
                <c:pt idx="1198">
                  <c:v>3116</c:v>
                </c:pt>
                <c:pt idx="1199">
                  <c:v>3489</c:v>
                </c:pt>
                <c:pt idx="1200">
                  <c:v>2905</c:v>
                </c:pt>
                <c:pt idx="1201">
                  <c:v>3763</c:v>
                </c:pt>
                <c:pt idx="1202">
                  <c:v>2801</c:v>
                </c:pt>
                <c:pt idx="1203">
                  <c:v>2988</c:v>
                </c:pt>
                <c:pt idx="1204">
                  <c:v>2196</c:v>
                </c:pt>
                <c:pt idx="1205">
                  <c:v>2722</c:v>
                </c:pt>
                <c:pt idx="1206">
                  <c:v>2557</c:v>
                </c:pt>
                <c:pt idx="1207">
                  <c:v>2531</c:v>
                </c:pt>
                <c:pt idx="1208">
                  <c:v>2733</c:v>
                </c:pt>
                <c:pt idx="1209">
                  <c:v>2199</c:v>
                </c:pt>
                <c:pt idx="1210">
                  <c:v>2546</c:v>
                </c:pt>
                <c:pt idx="1211">
                  <c:v>2461</c:v>
                </c:pt>
                <c:pt idx="1212">
                  <c:v>2106</c:v>
                </c:pt>
                <c:pt idx="1213">
                  <c:v>3067</c:v>
                </c:pt>
                <c:pt idx="1214">
                  <c:v>2172</c:v>
                </c:pt>
                <c:pt idx="1215">
                  <c:v>1942</c:v>
                </c:pt>
                <c:pt idx="1216">
                  <c:v>2846</c:v>
                </c:pt>
                <c:pt idx="1217">
                  <c:v>2495</c:v>
                </c:pt>
                <c:pt idx="1218">
                  <c:v>2315</c:v>
                </c:pt>
                <c:pt idx="1219">
                  <c:v>2578</c:v>
                </c:pt>
                <c:pt idx="1220">
                  <c:v>3278</c:v>
                </c:pt>
                <c:pt idx="1221">
                  <c:v>2760</c:v>
                </c:pt>
                <c:pt idx="1222">
                  <c:v>3210</c:v>
                </c:pt>
                <c:pt idx="1223">
                  <c:v>2247</c:v>
                </c:pt>
                <c:pt idx="1224">
                  <c:v>2327</c:v>
                </c:pt>
                <c:pt idx="1225">
                  <c:v>2629</c:v>
                </c:pt>
                <c:pt idx="1226">
                  <c:v>2125</c:v>
                </c:pt>
                <c:pt idx="1227">
                  <c:v>2763</c:v>
                </c:pt>
                <c:pt idx="1228">
                  <c:v>2780</c:v>
                </c:pt>
                <c:pt idx="1229">
                  <c:v>2342</c:v>
                </c:pt>
                <c:pt idx="1230">
                  <c:v>3103</c:v>
                </c:pt>
                <c:pt idx="1231">
                  <c:v>2422</c:v>
                </c:pt>
                <c:pt idx="1232">
                  <c:v>2666</c:v>
                </c:pt>
                <c:pt idx="1233">
                  <c:v>2235</c:v>
                </c:pt>
                <c:pt idx="1234">
                  <c:v>2898</c:v>
                </c:pt>
                <c:pt idx="1235">
                  <c:v>2791</c:v>
                </c:pt>
                <c:pt idx="1236">
                  <c:v>2738</c:v>
                </c:pt>
                <c:pt idx="1237">
                  <c:v>2282</c:v>
                </c:pt>
                <c:pt idx="1238">
                  <c:v>2266</c:v>
                </c:pt>
                <c:pt idx="1239">
                  <c:v>2151</c:v>
                </c:pt>
                <c:pt idx="1240">
                  <c:v>2258</c:v>
                </c:pt>
                <c:pt idx="1241">
                  <c:v>2479</c:v>
                </c:pt>
                <c:pt idx="1242">
                  <c:v>2916</c:v>
                </c:pt>
                <c:pt idx="1243">
                  <c:v>2460</c:v>
                </c:pt>
                <c:pt idx="1244">
                  <c:v>2385</c:v>
                </c:pt>
                <c:pt idx="1245">
                  <c:v>3143</c:v>
                </c:pt>
                <c:pt idx="1246">
                  <c:v>2271</c:v>
                </c:pt>
                <c:pt idx="1247">
                  <c:v>2190</c:v>
                </c:pt>
                <c:pt idx="1248">
                  <c:v>2671</c:v>
                </c:pt>
                <c:pt idx="1249">
                  <c:v>2491</c:v>
                </c:pt>
                <c:pt idx="1250">
                  <c:v>2579</c:v>
                </c:pt>
                <c:pt idx="1251">
                  <c:v>2767</c:v>
                </c:pt>
                <c:pt idx="1252">
                  <c:v>2507</c:v>
                </c:pt>
                <c:pt idx="1253">
                  <c:v>2510</c:v>
                </c:pt>
                <c:pt idx="1254">
                  <c:v>2671</c:v>
                </c:pt>
                <c:pt idx="1255">
                  <c:v>2689</c:v>
                </c:pt>
                <c:pt idx="1256">
                  <c:v>2788</c:v>
                </c:pt>
                <c:pt idx="1257">
                  <c:v>2339</c:v>
                </c:pt>
                <c:pt idx="1258">
                  <c:v>2916</c:v>
                </c:pt>
                <c:pt idx="1259">
                  <c:v>2604</c:v>
                </c:pt>
                <c:pt idx="1260">
                  <c:v>2862</c:v>
                </c:pt>
                <c:pt idx="1261">
                  <c:v>2128</c:v>
                </c:pt>
                <c:pt idx="1262">
                  <c:v>2906</c:v>
                </c:pt>
                <c:pt idx="1263">
                  <c:v>2303</c:v>
                </c:pt>
                <c:pt idx="1264">
                  <c:v>1955</c:v>
                </c:pt>
                <c:pt idx="1265">
                  <c:v>3202</c:v>
                </c:pt>
                <c:pt idx="1266">
                  <c:v>2971</c:v>
                </c:pt>
                <c:pt idx="1267">
                  <c:v>2853</c:v>
                </c:pt>
                <c:pt idx="1268">
                  <c:v>2990</c:v>
                </c:pt>
                <c:pt idx="1269">
                  <c:v>2146</c:v>
                </c:pt>
                <c:pt idx="1270">
                  <c:v>2569</c:v>
                </c:pt>
                <c:pt idx="1271">
                  <c:v>3038</c:v>
                </c:pt>
                <c:pt idx="1272">
                  <c:v>2413</c:v>
                </c:pt>
                <c:pt idx="1273">
                  <c:v>2397</c:v>
                </c:pt>
                <c:pt idx="1274">
                  <c:v>2679</c:v>
                </c:pt>
                <c:pt idx="1275">
                  <c:v>2865</c:v>
                </c:pt>
                <c:pt idx="1276">
                  <c:v>2666</c:v>
                </c:pt>
                <c:pt idx="1277">
                  <c:v>2417</c:v>
                </c:pt>
                <c:pt idx="1278">
                  <c:v>2035</c:v>
                </c:pt>
                <c:pt idx="1279">
                  <c:v>2961</c:v>
                </c:pt>
                <c:pt idx="1280">
                  <c:v>2381</c:v>
                </c:pt>
                <c:pt idx="1281">
                  <c:v>2882</c:v>
                </c:pt>
                <c:pt idx="1282">
                  <c:v>2786</c:v>
                </c:pt>
                <c:pt idx="1283">
                  <c:v>2318</c:v>
                </c:pt>
                <c:pt idx="1284">
                  <c:v>2501</c:v>
                </c:pt>
                <c:pt idx="1285">
                  <c:v>2632</c:v>
                </c:pt>
                <c:pt idx="1286">
                  <c:v>2753</c:v>
                </c:pt>
                <c:pt idx="1287">
                  <c:v>2700</c:v>
                </c:pt>
                <c:pt idx="1288">
                  <c:v>2650</c:v>
                </c:pt>
                <c:pt idx="1289">
                  <c:v>2898</c:v>
                </c:pt>
                <c:pt idx="1290">
                  <c:v>3090</c:v>
                </c:pt>
                <c:pt idx="1291">
                  <c:v>2465</c:v>
                </c:pt>
                <c:pt idx="1292">
                  <c:v>2267</c:v>
                </c:pt>
                <c:pt idx="1293">
                  <c:v>2523</c:v>
                </c:pt>
                <c:pt idx="1294">
                  <c:v>2547</c:v>
                </c:pt>
                <c:pt idx="1295">
                  <c:v>2460</c:v>
                </c:pt>
                <c:pt idx="1296">
                  <c:v>2418</c:v>
                </c:pt>
                <c:pt idx="1297">
                  <c:v>2202</c:v>
                </c:pt>
                <c:pt idx="1298">
                  <c:v>1975</c:v>
                </c:pt>
                <c:pt idx="1299">
                  <c:v>2748</c:v>
                </c:pt>
                <c:pt idx="1300">
                  <c:v>2550</c:v>
                </c:pt>
                <c:pt idx="1301">
                  <c:v>3246</c:v>
                </c:pt>
                <c:pt idx="1302">
                  <c:v>3258</c:v>
                </c:pt>
                <c:pt idx="1303">
                  <c:v>2391</c:v>
                </c:pt>
                <c:pt idx="1304">
                  <c:v>2595</c:v>
                </c:pt>
                <c:pt idx="1305">
                  <c:v>2332</c:v>
                </c:pt>
                <c:pt idx="1306">
                  <c:v>2594</c:v>
                </c:pt>
                <c:pt idx="1307">
                  <c:v>1933</c:v>
                </c:pt>
                <c:pt idx="1308">
                  <c:v>2876</c:v>
                </c:pt>
                <c:pt idx="1309">
                  <c:v>3048</c:v>
                </c:pt>
                <c:pt idx="1310">
                  <c:v>3020</c:v>
                </c:pt>
                <c:pt idx="1311">
                  <c:v>2489</c:v>
                </c:pt>
                <c:pt idx="1312">
                  <c:v>3219</c:v>
                </c:pt>
                <c:pt idx="1313">
                  <c:v>3932</c:v>
                </c:pt>
                <c:pt idx="1314">
                  <c:v>2421</c:v>
                </c:pt>
                <c:pt idx="1315">
                  <c:v>2027</c:v>
                </c:pt>
                <c:pt idx="1316">
                  <c:v>2424</c:v>
                </c:pt>
                <c:pt idx="1317">
                  <c:v>2514</c:v>
                </c:pt>
                <c:pt idx="1318">
                  <c:v>2437</c:v>
                </c:pt>
                <c:pt idx="1319">
                  <c:v>2430</c:v>
                </c:pt>
                <c:pt idx="1320">
                  <c:v>2365</c:v>
                </c:pt>
                <c:pt idx="1321">
                  <c:v>2604</c:v>
                </c:pt>
                <c:pt idx="1322">
                  <c:v>2171</c:v>
                </c:pt>
                <c:pt idx="1323">
                  <c:v>2690</c:v>
                </c:pt>
                <c:pt idx="1324">
                  <c:v>2705</c:v>
                </c:pt>
                <c:pt idx="1325">
                  <c:v>2876</c:v>
                </c:pt>
                <c:pt idx="1326">
                  <c:v>1589</c:v>
                </c:pt>
                <c:pt idx="1327">
                  <c:v>2557</c:v>
                </c:pt>
                <c:pt idx="1328">
                  <c:v>2888</c:v>
                </c:pt>
                <c:pt idx="1329">
                  <c:v>2445</c:v>
                </c:pt>
                <c:pt idx="1330">
                  <c:v>2193</c:v>
                </c:pt>
                <c:pt idx="1331">
                  <c:v>2863</c:v>
                </c:pt>
                <c:pt idx="1332">
                  <c:v>1890</c:v>
                </c:pt>
                <c:pt idx="1333">
                  <c:v>2114</c:v>
                </c:pt>
                <c:pt idx="1334">
                  <c:v>1989</c:v>
                </c:pt>
                <c:pt idx="1335">
                  <c:v>2750</c:v>
                </c:pt>
                <c:pt idx="1336">
                  <c:v>2607</c:v>
                </c:pt>
                <c:pt idx="1337">
                  <c:v>2666</c:v>
                </c:pt>
                <c:pt idx="1338">
                  <c:v>3382</c:v>
                </c:pt>
                <c:pt idx="1339">
                  <c:v>2795</c:v>
                </c:pt>
                <c:pt idx="1340">
                  <c:v>3496</c:v>
                </c:pt>
                <c:pt idx="1341">
                  <c:v>2375</c:v>
                </c:pt>
                <c:pt idx="1342">
                  <c:v>2647</c:v>
                </c:pt>
                <c:pt idx="1343">
                  <c:v>3024</c:v>
                </c:pt>
                <c:pt idx="1344">
                  <c:v>2210</c:v>
                </c:pt>
                <c:pt idx="1345">
                  <c:v>2965</c:v>
                </c:pt>
                <c:pt idx="1346">
                  <c:v>1581</c:v>
                </c:pt>
                <c:pt idx="1347">
                  <c:v>3156</c:v>
                </c:pt>
                <c:pt idx="1348">
                  <c:v>2628</c:v>
                </c:pt>
                <c:pt idx="1349">
                  <c:v>3007</c:v>
                </c:pt>
                <c:pt idx="1350">
                  <c:v>2723</c:v>
                </c:pt>
                <c:pt idx="1351">
                  <c:v>3578</c:v>
                </c:pt>
                <c:pt idx="1352">
                  <c:v>2558</c:v>
                </c:pt>
                <c:pt idx="1353">
                  <c:v>2246</c:v>
                </c:pt>
                <c:pt idx="1354">
                  <c:v>2075</c:v>
                </c:pt>
                <c:pt idx="1355">
                  <c:v>2647</c:v>
                </c:pt>
                <c:pt idx="1356">
                  <c:v>2851</c:v>
                </c:pt>
                <c:pt idx="1357">
                  <c:v>2026</c:v>
                </c:pt>
                <c:pt idx="1358">
                  <c:v>2852</c:v>
                </c:pt>
                <c:pt idx="1359">
                  <c:v>2729</c:v>
                </c:pt>
                <c:pt idx="1360">
                  <c:v>2327</c:v>
                </c:pt>
                <c:pt idx="1361">
                  <c:v>2674</c:v>
                </c:pt>
                <c:pt idx="1362">
                  <c:v>2845</c:v>
                </c:pt>
                <c:pt idx="1363">
                  <c:v>2255</c:v>
                </c:pt>
                <c:pt idx="1364">
                  <c:v>2581</c:v>
                </c:pt>
                <c:pt idx="1365">
                  <c:v>2081</c:v>
                </c:pt>
                <c:pt idx="1366">
                  <c:v>2906</c:v>
                </c:pt>
                <c:pt idx="1367">
                  <c:v>3112</c:v>
                </c:pt>
                <c:pt idx="1368">
                  <c:v>3186</c:v>
                </c:pt>
                <c:pt idx="1369">
                  <c:v>2678</c:v>
                </c:pt>
                <c:pt idx="1370">
                  <c:v>2777</c:v>
                </c:pt>
                <c:pt idx="1371">
                  <c:v>2897</c:v>
                </c:pt>
                <c:pt idx="1372">
                  <c:v>1968</c:v>
                </c:pt>
                <c:pt idx="1373">
                  <c:v>2791</c:v>
                </c:pt>
                <c:pt idx="1374">
                  <c:v>2129</c:v>
                </c:pt>
                <c:pt idx="1375">
                  <c:v>2677</c:v>
                </c:pt>
                <c:pt idx="1376">
                  <c:v>3300</c:v>
                </c:pt>
                <c:pt idx="1377">
                  <c:v>2253</c:v>
                </c:pt>
                <c:pt idx="1378">
                  <c:v>2543</c:v>
                </c:pt>
                <c:pt idx="1379">
                  <c:v>3059</c:v>
                </c:pt>
                <c:pt idx="1380">
                  <c:v>2338</c:v>
                </c:pt>
                <c:pt idx="1381">
                  <c:v>2488</c:v>
                </c:pt>
                <c:pt idx="1382">
                  <c:v>2252</c:v>
                </c:pt>
                <c:pt idx="1383">
                  <c:v>2508</c:v>
                </c:pt>
                <c:pt idx="1384">
                  <c:v>2716</c:v>
                </c:pt>
                <c:pt idx="1385">
                  <c:v>252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193-47D6-A854-F36DB5DE1E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797056"/>
        <c:axId val="157797616"/>
      </c:scatterChart>
      <c:valAx>
        <c:axId val="157797056"/>
        <c:scaling>
          <c:orientation val="minMax"/>
          <c:max val="9"/>
          <c:min val="3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797616"/>
        <c:crosses val="autoZero"/>
        <c:crossBetween val="midCat"/>
      </c:valAx>
      <c:valAx>
        <c:axId val="1577976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77970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2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DFD78A-A74F-45A4-9F4D-ABF8999FBD71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29677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7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A57FA8-6D82-49F8-A213-EB9AB7181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848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2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93181A-C7C4-4CC1-BE08-1BC9A14CEA1C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6" y="4473577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77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7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C58876-8151-43E7-AE86-C0527689D7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050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2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015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596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604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492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204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77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420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05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631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861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8C471-33B2-4C9E-833A-993C036BF1B2}" type="datetimeFigureOut">
              <a:rPr lang="en-US" smtClean="0"/>
              <a:t>3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525E8E-6371-4B01-AB2E-57989ACA3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709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7729663"/>
              </p:ext>
            </p:extLst>
          </p:nvPr>
        </p:nvGraphicFramePr>
        <p:xfrm>
          <a:off x="707619" y="3865370"/>
          <a:ext cx="7550035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861179" y="5331363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308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501934" y="5303369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293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740332" y="4597121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217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482637" y="4401280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207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435447" y="3984914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16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84920" y="3871654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124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912056" y="3949661"/>
            <a:ext cx="3225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9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195317" y="4086425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108</a:t>
            </a:r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5950269"/>
              </p:ext>
            </p:extLst>
          </p:nvPr>
        </p:nvGraphicFramePr>
        <p:xfrm>
          <a:off x="588089" y="1405065"/>
          <a:ext cx="7550035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8970" y="5226"/>
            <a:ext cx="870827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6 Figure: </a:t>
            </a:r>
            <a:r>
              <a:rPr lang="en-US" sz="1100" dirty="0"/>
              <a:t>mass spectral and NMR characterization of 4-hydroxy isotrichodermin (3-</a:t>
            </a:r>
            <a:r>
              <a:rPr lang="en-US" sz="1100" i="1" dirty="0"/>
              <a:t>O</a:t>
            </a:r>
            <a:r>
              <a:rPr lang="en-US" sz="1100" dirty="0"/>
              <a:t>-acetyl-4-hydroxy EPT) produced in YEPD cultures of </a:t>
            </a:r>
            <a:r>
              <a:rPr lang="en-US" sz="1100" i="1" dirty="0"/>
              <a:t>F. verticillioides </a:t>
            </a:r>
            <a:r>
              <a:rPr lang="en-US" sz="1100" dirty="0"/>
              <a:t>expressing the </a:t>
            </a:r>
            <a:r>
              <a:rPr lang="en-US" sz="1100" i="1" dirty="0"/>
              <a:t>B. bassiana TRI22 </a:t>
            </a:r>
            <a:r>
              <a:rPr lang="en-US" sz="1100" dirty="0"/>
              <a:t>homolog and to which exogenous isotrichodermin was added. </a:t>
            </a:r>
            <a:r>
              <a:rPr lang="en-US" sz="1100" b="1" dirty="0" smtClean="0"/>
              <a:t>Fig A</a:t>
            </a:r>
            <a:r>
              <a:rPr lang="en-US" sz="1100" dirty="0" smtClean="0"/>
              <a:t>: </a:t>
            </a:r>
            <a:r>
              <a:rPr lang="en-US" sz="1100" dirty="0"/>
              <a:t>Total ion chromatogram of an ethyl acetate extract of the culture (above), and mass spectrum of 4-hydroxy isotrichodermin (below). </a:t>
            </a:r>
            <a:r>
              <a:rPr lang="en-US" sz="1100" b="1" dirty="0" smtClean="0"/>
              <a:t>Fig B: </a:t>
            </a:r>
            <a:r>
              <a:rPr lang="en-US" sz="1100" baseline="30000" dirty="0"/>
              <a:t>13</a:t>
            </a:r>
            <a:r>
              <a:rPr lang="en-US" sz="1100" dirty="0"/>
              <a:t>C (left) and </a:t>
            </a:r>
            <a:r>
              <a:rPr lang="en-US" sz="1100" baseline="30000" dirty="0"/>
              <a:t>1</a:t>
            </a:r>
            <a:r>
              <a:rPr lang="en-US" sz="1100" dirty="0"/>
              <a:t>H (right) NMR spectra of 4-hydroxy isotrichodermin. </a:t>
            </a:r>
            <a:endParaRPr lang="en-US" sz="11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924485" y="1808133"/>
            <a:ext cx="13067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 err="1"/>
              <a:t>isotrichodermin</a:t>
            </a:r>
            <a:endParaRPr lang="en-US" sz="1350" dirty="0"/>
          </a:p>
        </p:txBody>
      </p:sp>
      <p:sp>
        <p:nvSpPr>
          <p:cNvPr id="16" name="TextBox 15"/>
          <p:cNvSpPr txBox="1"/>
          <p:nvPr/>
        </p:nvSpPr>
        <p:spPr>
          <a:xfrm>
            <a:off x="5888365" y="2295265"/>
            <a:ext cx="209679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 smtClean="0"/>
              <a:t>4-hydroxy-isotrichodermin</a:t>
            </a:r>
            <a:endParaRPr lang="en-US" sz="1350" dirty="0"/>
          </a:p>
        </p:txBody>
      </p:sp>
      <p:cxnSp>
        <p:nvCxnSpPr>
          <p:cNvPr id="18" name="Straight Connector 17"/>
          <p:cNvCxnSpPr/>
          <p:nvPr/>
        </p:nvCxnSpPr>
        <p:spPr>
          <a:xfrm flipH="1">
            <a:off x="6172200" y="2535921"/>
            <a:ext cx="329734" cy="342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740332" y="2085132"/>
            <a:ext cx="344085" cy="3486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259635" y="3823332"/>
            <a:ext cx="2096792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 smtClean="0"/>
              <a:t>4-hydroxy-isotrichodermin</a:t>
            </a:r>
            <a:endParaRPr lang="en-US" sz="1350" dirty="0"/>
          </a:p>
          <a:p>
            <a:r>
              <a:rPr lang="en-US" sz="1350" dirty="0" smtClean="0"/>
              <a:t>mass </a:t>
            </a:r>
            <a:r>
              <a:rPr lang="en-US" sz="1350" dirty="0"/>
              <a:t>spectrum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158029" y="3357771"/>
            <a:ext cx="992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Time (min)</a:t>
            </a:r>
            <a:endParaRPr 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235483" y="5940876"/>
            <a:ext cx="479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m/z</a:t>
            </a:r>
            <a:endParaRPr lang="en-US" sz="1400" b="1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21804" y="4576175"/>
            <a:ext cx="970137" cy="2666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33" b="1" dirty="0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21804" y="2086665"/>
            <a:ext cx="970137" cy="2666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33" b="1" dirty="0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9685" y="1002160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 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14088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718"/>
          <a:stretch/>
        </p:blipFill>
        <p:spPr>
          <a:xfrm>
            <a:off x="601534" y="1497126"/>
            <a:ext cx="3659714" cy="347186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22128" y="1643791"/>
            <a:ext cx="3714750" cy="350043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45841" y="1163701"/>
            <a:ext cx="78579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aseline="30000" dirty="0"/>
              <a:t>13</a:t>
            </a:r>
            <a:r>
              <a:rPr lang="en-US" sz="1350" dirty="0"/>
              <a:t>C NMR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530013" y="1163701"/>
            <a:ext cx="74251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aseline="30000" dirty="0"/>
              <a:t>1</a:t>
            </a:r>
            <a:r>
              <a:rPr lang="en-US" sz="1350" dirty="0"/>
              <a:t>H NMR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45841" y="886702"/>
            <a:ext cx="209679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 smtClean="0"/>
              <a:t>4-hydroxy-isotrichodermin</a:t>
            </a:r>
            <a:endParaRPr lang="en-US" sz="1350" dirty="0"/>
          </a:p>
        </p:txBody>
      </p:sp>
      <p:sp>
        <p:nvSpPr>
          <p:cNvPr id="8" name="TextBox 7"/>
          <p:cNvSpPr txBox="1"/>
          <p:nvPr/>
        </p:nvSpPr>
        <p:spPr>
          <a:xfrm>
            <a:off x="4530012" y="930434"/>
            <a:ext cx="209679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 smtClean="0"/>
              <a:t>4-hydroxy-isotrichodermin</a:t>
            </a:r>
            <a:endParaRPr lang="en-US" sz="1350" dirty="0"/>
          </a:p>
        </p:txBody>
      </p:sp>
      <p:sp>
        <p:nvSpPr>
          <p:cNvPr id="10" name="TextBox 9"/>
          <p:cNvSpPr txBox="1"/>
          <p:nvPr/>
        </p:nvSpPr>
        <p:spPr>
          <a:xfrm>
            <a:off x="77792" y="316033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 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7223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62</TotalTime>
  <Words>112</Words>
  <Application>Microsoft Office PowerPoint</Application>
  <PresentationFormat>On-screen Show (4:3)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hp</dc:creator>
  <cp:lastModifiedBy>rhp</cp:lastModifiedBy>
  <cp:revision>585</cp:revision>
  <cp:lastPrinted>2017-12-19T20:09:49Z</cp:lastPrinted>
  <dcterms:created xsi:type="dcterms:W3CDTF">2015-02-21T01:35:43Z</dcterms:created>
  <dcterms:modified xsi:type="dcterms:W3CDTF">2018-03-05T18:29:55Z</dcterms:modified>
</cp:coreProperties>
</file>